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4398963" cy="723265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337995-38FA-4C02-AAF5-4D2FA45585B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220320" y="288720"/>
            <a:ext cx="3957480" cy="1206360"/>
          </a:xfrm>
          <a:prstGeom prst="rect">
            <a:avLst/>
          </a:prstGeom>
          <a:noFill/>
          <a:ln w="0">
            <a:noFill/>
          </a:ln>
        </p:spPr>
        <p:txBody>
          <a:bodyPr lIns="66600" rIns="66600" tIns="33120" bIns="33120" anchor="ctr">
            <a:noAutofit/>
          </a:bodyPr>
          <a:p>
            <a:pPr indent="0" algn="ctr">
              <a:buNone/>
              <a:tabLst>
                <a:tab algn="l" pos="0"/>
                <a:tab algn="l" pos="331920"/>
                <a:tab algn="l" pos="663480"/>
                <a:tab algn="l" pos="995400"/>
                <a:tab algn="l" pos="1327320"/>
                <a:tab algn="l" pos="1658880"/>
                <a:tab algn="l" pos="1990800"/>
                <a:tab algn="l" pos="2322360"/>
                <a:tab algn="l" pos="2654280"/>
                <a:tab algn="l" pos="2986200"/>
                <a:tab algn="l" pos="3317760"/>
                <a:tab algn="l" pos="3649680"/>
                <a:tab algn="l" pos="3981600"/>
                <a:tab algn="l" pos="4313160"/>
                <a:tab algn="l" pos="4645080"/>
                <a:tab algn="l" pos="4976640"/>
                <a:tab algn="l" pos="5308560"/>
                <a:tab algn="l" pos="5640480"/>
                <a:tab algn="l" pos="5972040"/>
                <a:tab algn="l" pos="6303960"/>
                <a:tab algn="l" pos="663588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220320" y="1687680"/>
            <a:ext cx="3957480" cy="2276640"/>
          </a:xfrm>
          <a:prstGeom prst="rect">
            <a:avLst/>
          </a:prstGeom>
          <a:noFill/>
          <a:ln w="0">
            <a:noFill/>
          </a:ln>
        </p:spPr>
        <p:txBody>
          <a:bodyPr lIns="66600" rIns="66600" tIns="33120" bIns="33120" anchor="t">
            <a:normAutofit/>
          </a:bodyPr>
          <a:p>
            <a:pPr indent="0">
              <a:spcBef>
                <a:spcPts val="575"/>
              </a:spcBef>
              <a:buNone/>
              <a:tabLst>
                <a:tab algn="l" pos="331920"/>
                <a:tab algn="l" pos="663480"/>
                <a:tab algn="l" pos="995400"/>
                <a:tab algn="l" pos="1327320"/>
                <a:tab algn="l" pos="1658880"/>
                <a:tab algn="l" pos="1990800"/>
                <a:tab algn="l" pos="2322360"/>
                <a:tab algn="l" pos="2654280"/>
                <a:tab algn="l" pos="2986200"/>
                <a:tab algn="l" pos="3317760"/>
                <a:tab algn="l" pos="3649680"/>
                <a:tab algn="l" pos="3981600"/>
                <a:tab algn="l" pos="4313160"/>
                <a:tab algn="l" pos="4645080"/>
                <a:tab algn="l" pos="4976640"/>
                <a:tab algn="l" pos="5308560"/>
                <a:tab algn="l" pos="5640480"/>
                <a:tab algn="l" pos="5972040"/>
                <a:tab algn="l" pos="6303960"/>
                <a:tab algn="l" pos="663588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220320" y="4181040"/>
            <a:ext cx="3957480" cy="2276640"/>
          </a:xfrm>
          <a:prstGeom prst="rect">
            <a:avLst/>
          </a:prstGeom>
          <a:noFill/>
          <a:ln w="0">
            <a:noFill/>
          </a:ln>
        </p:spPr>
        <p:txBody>
          <a:bodyPr lIns="66600" rIns="66600" tIns="33120" bIns="33120" anchor="t">
            <a:normAutofit/>
          </a:bodyPr>
          <a:p>
            <a:pPr indent="0">
              <a:spcBef>
                <a:spcPts val="575"/>
              </a:spcBef>
              <a:buNone/>
              <a:tabLst>
                <a:tab algn="l" pos="331920"/>
                <a:tab algn="l" pos="663480"/>
                <a:tab algn="l" pos="995400"/>
                <a:tab algn="l" pos="1327320"/>
                <a:tab algn="l" pos="1658880"/>
                <a:tab algn="l" pos="1990800"/>
                <a:tab algn="l" pos="2322360"/>
                <a:tab algn="l" pos="2654280"/>
                <a:tab algn="l" pos="2986200"/>
                <a:tab algn="l" pos="3317760"/>
                <a:tab algn="l" pos="3649680"/>
                <a:tab algn="l" pos="3981600"/>
                <a:tab algn="l" pos="4313160"/>
                <a:tab algn="l" pos="4645080"/>
                <a:tab algn="l" pos="4976640"/>
                <a:tab algn="l" pos="5308560"/>
                <a:tab algn="l" pos="5640480"/>
                <a:tab algn="l" pos="5972040"/>
                <a:tab algn="l" pos="6303960"/>
                <a:tab algn="l" pos="663588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3A4C6D-6C11-41CB-9BDC-FC055712DDD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220320" y="288720"/>
            <a:ext cx="3957480" cy="1206360"/>
          </a:xfrm>
          <a:prstGeom prst="rect">
            <a:avLst/>
          </a:prstGeom>
          <a:noFill/>
          <a:ln w="0">
            <a:noFill/>
          </a:ln>
        </p:spPr>
        <p:txBody>
          <a:bodyPr lIns="66600" rIns="66600" tIns="33120" bIns="33120" anchor="ctr">
            <a:noAutofit/>
          </a:bodyPr>
          <a:p>
            <a:pPr indent="0" algn="ctr">
              <a:buNone/>
              <a:tabLst>
                <a:tab algn="l" pos="0"/>
                <a:tab algn="l" pos="331920"/>
                <a:tab algn="l" pos="663480"/>
                <a:tab algn="l" pos="995400"/>
                <a:tab algn="l" pos="1327320"/>
                <a:tab algn="l" pos="1658880"/>
                <a:tab algn="l" pos="1990800"/>
                <a:tab algn="l" pos="2322360"/>
                <a:tab algn="l" pos="2654280"/>
                <a:tab algn="l" pos="2986200"/>
                <a:tab algn="l" pos="3317760"/>
                <a:tab algn="l" pos="3649680"/>
                <a:tab algn="l" pos="3981600"/>
                <a:tab algn="l" pos="4313160"/>
                <a:tab algn="l" pos="4645080"/>
                <a:tab algn="l" pos="4976640"/>
                <a:tab algn="l" pos="5308560"/>
                <a:tab algn="l" pos="5640480"/>
                <a:tab algn="l" pos="5972040"/>
                <a:tab algn="l" pos="6303960"/>
                <a:tab algn="l" pos="663588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220320" y="1687680"/>
            <a:ext cx="1931040" cy="2276640"/>
          </a:xfrm>
          <a:prstGeom prst="rect">
            <a:avLst/>
          </a:prstGeom>
          <a:noFill/>
          <a:ln w="0">
            <a:noFill/>
          </a:ln>
        </p:spPr>
        <p:txBody>
          <a:bodyPr lIns="66600" rIns="66600" tIns="33120" bIns="33120" anchor="t">
            <a:normAutofit/>
          </a:bodyPr>
          <a:p>
            <a:pPr indent="0">
              <a:spcBef>
                <a:spcPts val="575"/>
              </a:spcBef>
              <a:buNone/>
              <a:tabLst>
                <a:tab algn="l" pos="331920"/>
                <a:tab algn="l" pos="663480"/>
                <a:tab algn="l" pos="995400"/>
                <a:tab algn="l" pos="1327320"/>
                <a:tab algn="l" pos="1658880"/>
                <a:tab algn="l" pos="1990800"/>
                <a:tab algn="l" pos="2322360"/>
                <a:tab algn="l" pos="2654280"/>
                <a:tab algn="l" pos="2986200"/>
                <a:tab algn="l" pos="3317760"/>
                <a:tab algn="l" pos="3649680"/>
                <a:tab algn="l" pos="3981600"/>
                <a:tab algn="l" pos="4313160"/>
                <a:tab algn="l" pos="4645080"/>
                <a:tab algn="l" pos="4976640"/>
                <a:tab algn="l" pos="5308560"/>
                <a:tab algn="l" pos="5640480"/>
                <a:tab algn="l" pos="5972040"/>
                <a:tab algn="l" pos="6303960"/>
                <a:tab algn="l" pos="663588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2248200" y="1687680"/>
            <a:ext cx="1931040" cy="2276640"/>
          </a:xfrm>
          <a:prstGeom prst="rect">
            <a:avLst/>
          </a:prstGeom>
          <a:noFill/>
          <a:ln w="0">
            <a:noFill/>
          </a:ln>
        </p:spPr>
        <p:txBody>
          <a:bodyPr lIns="66600" rIns="66600" tIns="33120" bIns="33120" anchor="t">
            <a:normAutofit/>
          </a:bodyPr>
          <a:p>
            <a:pPr indent="0">
              <a:spcBef>
                <a:spcPts val="575"/>
              </a:spcBef>
              <a:buNone/>
              <a:tabLst>
                <a:tab algn="l" pos="331920"/>
                <a:tab algn="l" pos="663480"/>
                <a:tab algn="l" pos="995400"/>
                <a:tab algn="l" pos="1327320"/>
                <a:tab algn="l" pos="1658880"/>
                <a:tab algn="l" pos="1990800"/>
                <a:tab algn="l" pos="2322360"/>
                <a:tab algn="l" pos="2654280"/>
                <a:tab algn="l" pos="2986200"/>
                <a:tab algn="l" pos="3317760"/>
                <a:tab algn="l" pos="3649680"/>
                <a:tab algn="l" pos="3981600"/>
                <a:tab algn="l" pos="4313160"/>
                <a:tab algn="l" pos="4645080"/>
                <a:tab algn="l" pos="4976640"/>
                <a:tab algn="l" pos="5308560"/>
                <a:tab algn="l" pos="5640480"/>
                <a:tab algn="l" pos="5972040"/>
                <a:tab algn="l" pos="6303960"/>
                <a:tab algn="l" pos="663588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220320" y="4181040"/>
            <a:ext cx="1931040" cy="2276640"/>
          </a:xfrm>
          <a:prstGeom prst="rect">
            <a:avLst/>
          </a:prstGeom>
          <a:noFill/>
          <a:ln w="0">
            <a:noFill/>
          </a:ln>
        </p:spPr>
        <p:txBody>
          <a:bodyPr lIns="66600" rIns="66600" tIns="33120" bIns="33120" anchor="t">
            <a:normAutofit/>
          </a:bodyPr>
          <a:p>
            <a:pPr indent="0">
              <a:spcBef>
                <a:spcPts val="575"/>
              </a:spcBef>
              <a:buNone/>
              <a:tabLst>
                <a:tab algn="l" pos="331920"/>
                <a:tab algn="l" pos="663480"/>
                <a:tab algn="l" pos="995400"/>
                <a:tab algn="l" pos="1327320"/>
                <a:tab algn="l" pos="1658880"/>
                <a:tab algn="l" pos="1990800"/>
                <a:tab algn="l" pos="2322360"/>
                <a:tab algn="l" pos="2654280"/>
                <a:tab algn="l" pos="2986200"/>
                <a:tab algn="l" pos="3317760"/>
                <a:tab algn="l" pos="3649680"/>
                <a:tab algn="l" pos="3981600"/>
                <a:tab algn="l" pos="4313160"/>
                <a:tab algn="l" pos="4645080"/>
                <a:tab algn="l" pos="4976640"/>
                <a:tab algn="l" pos="5308560"/>
                <a:tab algn="l" pos="5640480"/>
                <a:tab algn="l" pos="5972040"/>
                <a:tab algn="l" pos="6303960"/>
                <a:tab algn="l" pos="663588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2248200" y="4181040"/>
            <a:ext cx="1931040" cy="2276640"/>
          </a:xfrm>
          <a:prstGeom prst="rect">
            <a:avLst/>
          </a:prstGeom>
          <a:noFill/>
          <a:ln w="0">
            <a:noFill/>
          </a:ln>
        </p:spPr>
        <p:txBody>
          <a:bodyPr lIns="66600" rIns="66600" tIns="33120" bIns="33120" anchor="t">
            <a:normAutofit/>
          </a:bodyPr>
          <a:p>
            <a:pPr indent="0">
              <a:spcBef>
                <a:spcPts val="575"/>
              </a:spcBef>
              <a:buNone/>
              <a:tabLst>
                <a:tab algn="l" pos="331920"/>
                <a:tab algn="l" pos="663480"/>
                <a:tab algn="l" pos="995400"/>
                <a:tab algn="l" pos="1327320"/>
                <a:tab algn="l" pos="1658880"/>
                <a:tab algn="l" pos="1990800"/>
                <a:tab algn="l" pos="2322360"/>
                <a:tab algn="l" pos="2654280"/>
                <a:tab algn="l" pos="2986200"/>
                <a:tab algn="l" pos="3317760"/>
                <a:tab algn="l" pos="3649680"/>
                <a:tab algn="l" pos="3981600"/>
                <a:tab algn="l" pos="4313160"/>
                <a:tab algn="l" pos="4645080"/>
                <a:tab algn="l" pos="4976640"/>
                <a:tab algn="l" pos="5308560"/>
                <a:tab algn="l" pos="5640480"/>
                <a:tab algn="l" pos="5972040"/>
                <a:tab algn="l" pos="6303960"/>
                <a:tab algn="l" pos="663588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9AFC29-73CC-46CD-B3B2-10418BE2638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220320" y="288720"/>
            <a:ext cx="3957480" cy="1206360"/>
          </a:xfrm>
          <a:prstGeom prst="rect">
            <a:avLst/>
          </a:prstGeom>
          <a:noFill/>
          <a:ln w="0">
            <a:noFill/>
          </a:ln>
        </p:spPr>
        <p:txBody>
          <a:bodyPr lIns="66600" rIns="66600" tIns="33120" bIns="33120" anchor="ctr">
            <a:noAutofit/>
          </a:bodyPr>
          <a:p>
            <a:pPr indent="0" algn="ctr">
              <a:buNone/>
              <a:tabLst>
                <a:tab algn="l" pos="0"/>
                <a:tab algn="l" pos="331920"/>
                <a:tab algn="l" pos="663480"/>
                <a:tab algn="l" pos="995400"/>
                <a:tab algn="l" pos="1327320"/>
                <a:tab algn="l" pos="1658880"/>
                <a:tab algn="l" pos="1990800"/>
                <a:tab algn="l" pos="2322360"/>
                <a:tab algn="l" pos="2654280"/>
                <a:tab algn="l" pos="2986200"/>
                <a:tab algn="l" pos="3317760"/>
                <a:tab algn="l" pos="3649680"/>
                <a:tab algn="l" pos="3981600"/>
                <a:tab algn="l" pos="4313160"/>
                <a:tab algn="l" pos="4645080"/>
                <a:tab algn="l" pos="4976640"/>
                <a:tab algn="l" pos="5308560"/>
                <a:tab algn="l" pos="5640480"/>
                <a:tab algn="l" pos="5972040"/>
                <a:tab algn="l" pos="6303960"/>
                <a:tab algn="l" pos="663588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220320" y="1687680"/>
            <a:ext cx="1274040" cy="2276640"/>
          </a:xfrm>
          <a:prstGeom prst="rect">
            <a:avLst/>
          </a:prstGeom>
          <a:noFill/>
          <a:ln w="0">
            <a:noFill/>
          </a:ln>
        </p:spPr>
        <p:txBody>
          <a:bodyPr lIns="66600" rIns="66600" tIns="33120" bIns="33120" anchor="t">
            <a:normAutofit/>
          </a:bodyPr>
          <a:p>
            <a:pPr indent="0">
              <a:spcBef>
                <a:spcPts val="575"/>
              </a:spcBef>
              <a:buNone/>
              <a:tabLst>
                <a:tab algn="l" pos="331920"/>
                <a:tab algn="l" pos="663480"/>
                <a:tab algn="l" pos="995400"/>
                <a:tab algn="l" pos="1327320"/>
                <a:tab algn="l" pos="1658880"/>
                <a:tab algn="l" pos="1990800"/>
                <a:tab algn="l" pos="2322360"/>
                <a:tab algn="l" pos="2654280"/>
                <a:tab algn="l" pos="2986200"/>
                <a:tab algn="l" pos="3317760"/>
                <a:tab algn="l" pos="3649680"/>
                <a:tab algn="l" pos="3981600"/>
                <a:tab algn="l" pos="4313160"/>
                <a:tab algn="l" pos="4645080"/>
                <a:tab algn="l" pos="4976640"/>
                <a:tab algn="l" pos="5308560"/>
                <a:tab algn="l" pos="5640480"/>
                <a:tab algn="l" pos="5972040"/>
                <a:tab algn="l" pos="6303960"/>
                <a:tab algn="l" pos="663588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1558440" y="1687680"/>
            <a:ext cx="1274040" cy="2276640"/>
          </a:xfrm>
          <a:prstGeom prst="rect">
            <a:avLst/>
          </a:prstGeom>
          <a:noFill/>
          <a:ln w="0">
            <a:noFill/>
          </a:ln>
        </p:spPr>
        <p:txBody>
          <a:bodyPr lIns="66600" rIns="66600" tIns="33120" bIns="33120" anchor="t">
            <a:normAutofit/>
          </a:bodyPr>
          <a:p>
            <a:pPr indent="0">
              <a:spcBef>
                <a:spcPts val="575"/>
              </a:spcBef>
              <a:buNone/>
              <a:tabLst>
                <a:tab algn="l" pos="331920"/>
                <a:tab algn="l" pos="663480"/>
                <a:tab algn="l" pos="995400"/>
                <a:tab algn="l" pos="1327320"/>
                <a:tab algn="l" pos="1658880"/>
                <a:tab algn="l" pos="1990800"/>
                <a:tab algn="l" pos="2322360"/>
                <a:tab algn="l" pos="2654280"/>
                <a:tab algn="l" pos="2986200"/>
                <a:tab algn="l" pos="3317760"/>
                <a:tab algn="l" pos="3649680"/>
                <a:tab algn="l" pos="3981600"/>
                <a:tab algn="l" pos="4313160"/>
                <a:tab algn="l" pos="4645080"/>
                <a:tab algn="l" pos="4976640"/>
                <a:tab algn="l" pos="5308560"/>
                <a:tab algn="l" pos="5640480"/>
                <a:tab algn="l" pos="5972040"/>
                <a:tab algn="l" pos="6303960"/>
                <a:tab algn="l" pos="663588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2896560" y="1687680"/>
            <a:ext cx="1274040" cy="2276640"/>
          </a:xfrm>
          <a:prstGeom prst="rect">
            <a:avLst/>
          </a:prstGeom>
          <a:noFill/>
          <a:ln w="0">
            <a:noFill/>
          </a:ln>
        </p:spPr>
        <p:txBody>
          <a:bodyPr lIns="66600" rIns="66600" tIns="33120" bIns="33120" anchor="t">
            <a:normAutofit/>
          </a:bodyPr>
          <a:p>
            <a:pPr indent="0">
              <a:spcBef>
                <a:spcPts val="575"/>
              </a:spcBef>
              <a:buNone/>
              <a:tabLst>
                <a:tab algn="l" pos="331920"/>
                <a:tab algn="l" pos="663480"/>
                <a:tab algn="l" pos="995400"/>
                <a:tab algn="l" pos="1327320"/>
                <a:tab algn="l" pos="1658880"/>
                <a:tab algn="l" pos="1990800"/>
                <a:tab algn="l" pos="2322360"/>
                <a:tab algn="l" pos="2654280"/>
                <a:tab algn="l" pos="2986200"/>
                <a:tab algn="l" pos="3317760"/>
                <a:tab algn="l" pos="3649680"/>
                <a:tab algn="l" pos="3981600"/>
                <a:tab algn="l" pos="4313160"/>
                <a:tab algn="l" pos="4645080"/>
                <a:tab algn="l" pos="4976640"/>
                <a:tab algn="l" pos="5308560"/>
                <a:tab algn="l" pos="5640480"/>
                <a:tab algn="l" pos="5972040"/>
                <a:tab algn="l" pos="6303960"/>
                <a:tab algn="l" pos="663588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220320" y="4181040"/>
            <a:ext cx="1274040" cy="2276640"/>
          </a:xfrm>
          <a:prstGeom prst="rect">
            <a:avLst/>
          </a:prstGeom>
          <a:noFill/>
          <a:ln w="0">
            <a:noFill/>
          </a:ln>
        </p:spPr>
        <p:txBody>
          <a:bodyPr lIns="66600" rIns="66600" tIns="33120" bIns="33120" anchor="t">
            <a:normAutofit/>
          </a:bodyPr>
          <a:p>
            <a:pPr indent="0">
              <a:spcBef>
                <a:spcPts val="575"/>
              </a:spcBef>
              <a:buNone/>
              <a:tabLst>
                <a:tab algn="l" pos="331920"/>
                <a:tab algn="l" pos="663480"/>
                <a:tab algn="l" pos="995400"/>
                <a:tab algn="l" pos="1327320"/>
                <a:tab algn="l" pos="1658880"/>
                <a:tab algn="l" pos="1990800"/>
                <a:tab algn="l" pos="2322360"/>
                <a:tab algn="l" pos="2654280"/>
                <a:tab algn="l" pos="2986200"/>
                <a:tab algn="l" pos="3317760"/>
                <a:tab algn="l" pos="3649680"/>
                <a:tab algn="l" pos="3981600"/>
                <a:tab algn="l" pos="4313160"/>
                <a:tab algn="l" pos="4645080"/>
                <a:tab algn="l" pos="4976640"/>
                <a:tab algn="l" pos="5308560"/>
                <a:tab algn="l" pos="5640480"/>
                <a:tab algn="l" pos="5972040"/>
                <a:tab algn="l" pos="6303960"/>
                <a:tab algn="l" pos="663588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1558440" y="4181040"/>
            <a:ext cx="1274040" cy="2276640"/>
          </a:xfrm>
          <a:prstGeom prst="rect">
            <a:avLst/>
          </a:prstGeom>
          <a:noFill/>
          <a:ln w="0">
            <a:noFill/>
          </a:ln>
        </p:spPr>
        <p:txBody>
          <a:bodyPr lIns="66600" rIns="66600" tIns="33120" bIns="33120" anchor="t">
            <a:normAutofit/>
          </a:bodyPr>
          <a:p>
            <a:pPr indent="0">
              <a:spcBef>
                <a:spcPts val="575"/>
              </a:spcBef>
              <a:buNone/>
              <a:tabLst>
                <a:tab algn="l" pos="331920"/>
                <a:tab algn="l" pos="663480"/>
                <a:tab algn="l" pos="995400"/>
                <a:tab algn="l" pos="1327320"/>
                <a:tab algn="l" pos="1658880"/>
                <a:tab algn="l" pos="1990800"/>
                <a:tab algn="l" pos="2322360"/>
                <a:tab algn="l" pos="2654280"/>
                <a:tab algn="l" pos="2986200"/>
                <a:tab algn="l" pos="3317760"/>
                <a:tab algn="l" pos="3649680"/>
                <a:tab algn="l" pos="3981600"/>
                <a:tab algn="l" pos="4313160"/>
                <a:tab algn="l" pos="4645080"/>
                <a:tab algn="l" pos="4976640"/>
                <a:tab algn="l" pos="5308560"/>
                <a:tab algn="l" pos="5640480"/>
                <a:tab algn="l" pos="5972040"/>
                <a:tab algn="l" pos="6303960"/>
                <a:tab algn="l" pos="663588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2896560" y="4181040"/>
            <a:ext cx="1274040" cy="2276640"/>
          </a:xfrm>
          <a:prstGeom prst="rect">
            <a:avLst/>
          </a:prstGeom>
          <a:noFill/>
          <a:ln w="0">
            <a:noFill/>
          </a:ln>
        </p:spPr>
        <p:txBody>
          <a:bodyPr lIns="66600" rIns="66600" tIns="33120" bIns="33120" anchor="t">
            <a:normAutofit/>
          </a:bodyPr>
          <a:p>
            <a:pPr indent="0">
              <a:spcBef>
                <a:spcPts val="575"/>
              </a:spcBef>
              <a:buNone/>
              <a:tabLst>
                <a:tab algn="l" pos="331920"/>
                <a:tab algn="l" pos="663480"/>
                <a:tab algn="l" pos="995400"/>
                <a:tab algn="l" pos="1327320"/>
                <a:tab algn="l" pos="1658880"/>
                <a:tab algn="l" pos="1990800"/>
                <a:tab algn="l" pos="2322360"/>
                <a:tab algn="l" pos="2654280"/>
                <a:tab algn="l" pos="2986200"/>
                <a:tab algn="l" pos="3317760"/>
                <a:tab algn="l" pos="3649680"/>
                <a:tab algn="l" pos="3981600"/>
                <a:tab algn="l" pos="4313160"/>
                <a:tab algn="l" pos="4645080"/>
                <a:tab algn="l" pos="4976640"/>
                <a:tab algn="l" pos="5308560"/>
                <a:tab algn="l" pos="5640480"/>
                <a:tab algn="l" pos="5972040"/>
                <a:tab algn="l" pos="6303960"/>
                <a:tab algn="l" pos="663588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55FFB0-F594-484A-B04A-4F1E169CE20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220320" y="288720"/>
            <a:ext cx="3957480" cy="1206360"/>
          </a:xfrm>
          <a:prstGeom prst="rect">
            <a:avLst/>
          </a:prstGeom>
          <a:noFill/>
          <a:ln w="0">
            <a:noFill/>
          </a:ln>
        </p:spPr>
        <p:txBody>
          <a:bodyPr lIns="66600" rIns="66600" tIns="33120" bIns="33120" anchor="ctr">
            <a:noAutofit/>
          </a:bodyPr>
          <a:p>
            <a:pPr indent="0" algn="ctr">
              <a:buNone/>
              <a:tabLst>
                <a:tab algn="l" pos="0"/>
                <a:tab algn="l" pos="331920"/>
                <a:tab algn="l" pos="663480"/>
                <a:tab algn="l" pos="995400"/>
                <a:tab algn="l" pos="1327320"/>
                <a:tab algn="l" pos="1658880"/>
                <a:tab algn="l" pos="1990800"/>
                <a:tab algn="l" pos="2322360"/>
                <a:tab algn="l" pos="2654280"/>
                <a:tab algn="l" pos="2986200"/>
                <a:tab algn="l" pos="3317760"/>
                <a:tab algn="l" pos="3649680"/>
                <a:tab algn="l" pos="3981600"/>
                <a:tab algn="l" pos="4313160"/>
                <a:tab algn="l" pos="4645080"/>
                <a:tab algn="l" pos="4976640"/>
                <a:tab algn="l" pos="5308560"/>
                <a:tab algn="l" pos="5640480"/>
                <a:tab algn="l" pos="5972040"/>
                <a:tab algn="l" pos="6303960"/>
                <a:tab algn="l" pos="663588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220320" y="1687680"/>
            <a:ext cx="3957480" cy="4773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575"/>
              </a:spcBef>
              <a:buNone/>
              <a:tabLst>
                <a:tab algn="l" pos="0"/>
                <a:tab algn="l" pos="331920"/>
                <a:tab algn="l" pos="663480"/>
                <a:tab algn="l" pos="995400"/>
                <a:tab algn="l" pos="1327320"/>
                <a:tab algn="l" pos="1658880"/>
                <a:tab algn="l" pos="1990800"/>
                <a:tab algn="l" pos="2322360"/>
                <a:tab algn="l" pos="2654280"/>
                <a:tab algn="l" pos="2986200"/>
                <a:tab algn="l" pos="3317760"/>
                <a:tab algn="l" pos="3649680"/>
                <a:tab algn="l" pos="3981600"/>
                <a:tab algn="l" pos="4313160"/>
                <a:tab algn="l" pos="4645080"/>
                <a:tab algn="l" pos="4976640"/>
                <a:tab algn="l" pos="5308560"/>
                <a:tab algn="l" pos="5640480"/>
                <a:tab algn="l" pos="5972040"/>
                <a:tab algn="l" pos="6303960"/>
                <a:tab algn="l" pos="663588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7F4925-4E49-4F92-8C65-3ABDE3A93C4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220320" y="288720"/>
            <a:ext cx="3957480" cy="1206360"/>
          </a:xfrm>
          <a:prstGeom prst="rect">
            <a:avLst/>
          </a:prstGeom>
          <a:noFill/>
          <a:ln w="0">
            <a:noFill/>
          </a:ln>
        </p:spPr>
        <p:txBody>
          <a:bodyPr lIns="66600" rIns="66600" tIns="33120" bIns="33120" anchor="ctr">
            <a:noAutofit/>
          </a:bodyPr>
          <a:p>
            <a:pPr indent="0" algn="ctr">
              <a:buNone/>
              <a:tabLst>
                <a:tab algn="l" pos="0"/>
                <a:tab algn="l" pos="331920"/>
                <a:tab algn="l" pos="663480"/>
                <a:tab algn="l" pos="995400"/>
                <a:tab algn="l" pos="1327320"/>
                <a:tab algn="l" pos="1658880"/>
                <a:tab algn="l" pos="1990800"/>
                <a:tab algn="l" pos="2322360"/>
                <a:tab algn="l" pos="2654280"/>
                <a:tab algn="l" pos="2986200"/>
                <a:tab algn="l" pos="3317760"/>
                <a:tab algn="l" pos="3649680"/>
                <a:tab algn="l" pos="3981600"/>
                <a:tab algn="l" pos="4313160"/>
                <a:tab algn="l" pos="4645080"/>
                <a:tab algn="l" pos="4976640"/>
                <a:tab algn="l" pos="5308560"/>
                <a:tab algn="l" pos="5640480"/>
                <a:tab algn="l" pos="5972040"/>
                <a:tab algn="l" pos="6303960"/>
                <a:tab algn="l" pos="663588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220320" y="1687680"/>
            <a:ext cx="3957480" cy="4773600"/>
          </a:xfrm>
          <a:prstGeom prst="rect">
            <a:avLst/>
          </a:prstGeom>
          <a:noFill/>
          <a:ln w="0">
            <a:noFill/>
          </a:ln>
        </p:spPr>
        <p:txBody>
          <a:bodyPr lIns="66600" rIns="66600" tIns="33120" bIns="33120" anchor="t">
            <a:normAutofit/>
          </a:bodyPr>
          <a:p>
            <a:pPr indent="0">
              <a:spcBef>
                <a:spcPts val="575"/>
              </a:spcBef>
              <a:buNone/>
              <a:tabLst>
                <a:tab algn="l" pos="331920"/>
                <a:tab algn="l" pos="663480"/>
                <a:tab algn="l" pos="995400"/>
                <a:tab algn="l" pos="1327320"/>
                <a:tab algn="l" pos="1658880"/>
                <a:tab algn="l" pos="1990800"/>
                <a:tab algn="l" pos="2322360"/>
                <a:tab algn="l" pos="2654280"/>
                <a:tab algn="l" pos="2986200"/>
                <a:tab algn="l" pos="3317760"/>
                <a:tab algn="l" pos="3649680"/>
                <a:tab algn="l" pos="3981600"/>
                <a:tab algn="l" pos="4313160"/>
                <a:tab algn="l" pos="4645080"/>
                <a:tab algn="l" pos="4976640"/>
                <a:tab algn="l" pos="5308560"/>
                <a:tab algn="l" pos="5640480"/>
                <a:tab algn="l" pos="5972040"/>
                <a:tab algn="l" pos="6303960"/>
                <a:tab algn="l" pos="663588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CEF30D-9C0C-4C59-9D31-139EFDEC951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220320" y="288720"/>
            <a:ext cx="3957480" cy="1206360"/>
          </a:xfrm>
          <a:prstGeom prst="rect">
            <a:avLst/>
          </a:prstGeom>
          <a:noFill/>
          <a:ln w="0">
            <a:noFill/>
          </a:ln>
        </p:spPr>
        <p:txBody>
          <a:bodyPr lIns="66600" rIns="66600" tIns="33120" bIns="33120" anchor="ctr">
            <a:noAutofit/>
          </a:bodyPr>
          <a:p>
            <a:pPr indent="0" algn="ctr">
              <a:buNone/>
              <a:tabLst>
                <a:tab algn="l" pos="0"/>
                <a:tab algn="l" pos="331920"/>
                <a:tab algn="l" pos="663480"/>
                <a:tab algn="l" pos="995400"/>
                <a:tab algn="l" pos="1327320"/>
                <a:tab algn="l" pos="1658880"/>
                <a:tab algn="l" pos="1990800"/>
                <a:tab algn="l" pos="2322360"/>
                <a:tab algn="l" pos="2654280"/>
                <a:tab algn="l" pos="2986200"/>
                <a:tab algn="l" pos="3317760"/>
                <a:tab algn="l" pos="3649680"/>
                <a:tab algn="l" pos="3981600"/>
                <a:tab algn="l" pos="4313160"/>
                <a:tab algn="l" pos="4645080"/>
                <a:tab algn="l" pos="4976640"/>
                <a:tab algn="l" pos="5308560"/>
                <a:tab algn="l" pos="5640480"/>
                <a:tab algn="l" pos="5972040"/>
                <a:tab algn="l" pos="6303960"/>
                <a:tab algn="l" pos="663588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220320" y="1687680"/>
            <a:ext cx="1931040" cy="4773600"/>
          </a:xfrm>
          <a:prstGeom prst="rect">
            <a:avLst/>
          </a:prstGeom>
          <a:noFill/>
          <a:ln w="0">
            <a:noFill/>
          </a:ln>
        </p:spPr>
        <p:txBody>
          <a:bodyPr lIns="66600" rIns="66600" tIns="33120" bIns="33120" anchor="t">
            <a:normAutofit/>
          </a:bodyPr>
          <a:p>
            <a:pPr indent="0">
              <a:spcBef>
                <a:spcPts val="575"/>
              </a:spcBef>
              <a:buNone/>
              <a:tabLst>
                <a:tab algn="l" pos="331920"/>
                <a:tab algn="l" pos="663480"/>
                <a:tab algn="l" pos="995400"/>
                <a:tab algn="l" pos="1327320"/>
                <a:tab algn="l" pos="1658880"/>
                <a:tab algn="l" pos="1990800"/>
                <a:tab algn="l" pos="2322360"/>
                <a:tab algn="l" pos="2654280"/>
                <a:tab algn="l" pos="2986200"/>
                <a:tab algn="l" pos="3317760"/>
                <a:tab algn="l" pos="3649680"/>
                <a:tab algn="l" pos="3981600"/>
                <a:tab algn="l" pos="4313160"/>
                <a:tab algn="l" pos="4645080"/>
                <a:tab algn="l" pos="4976640"/>
                <a:tab algn="l" pos="5308560"/>
                <a:tab algn="l" pos="5640480"/>
                <a:tab algn="l" pos="5972040"/>
                <a:tab algn="l" pos="6303960"/>
                <a:tab algn="l" pos="663588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2248200" y="1687680"/>
            <a:ext cx="1931040" cy="4773600"/>
          </a:xfrm>
          <a:prstGeom prst="rect">
            <a:avLst/>
          </a:prstGeom>
          <a:noFill/>
          <a:ln w="0">
            <a:noFill/>
          </a:ln>
        </p:spPr>
        <p:txBody>
          <a:bodyPr lIns="66600" rIns="66600" tIns="33120" bIns="33120" anchor="t">
            <a:normAutofit/>
          </a:bodyPr>
          <a:p>
            <a:pPr indent="0">
              <a:spcBef>
                <a:spcPts val="575"/>
              </a:spcBef>
              <a:buNone/>
              <a:tabLst>
                <a:tab algn="l" pos="331920"/>
                <a:tab algn="l" pos="663480"/>
                <a:tab algn="l" pos="995400"/>
                <a:tab algn="l" pos="1327320"/>
                <a:tab algn="l" pos="1658880"/>
                <a:tab algn="l" pos="1990800"/>
                <a:tab algn="l" pos="2322360"/>
                <a:tab algn="l" pos="2654280"/>
                <a:tab algn="l" pos="2986200"/>
                <a:tab algn="l" pos="3317760"/>
                <a:tab algn="l" pos="3649680"/>
                <a:tab algn="l" pos="3981600"/>
                <a:tab algn="l" pos="4313160"/>
                <a:tab algn="l" pos="4645080"/>
                <a:tab algn="l" pos="4976640"/>
                <a:tab algn="l" pos="5308560"/>
                <a:tab algn="l" pos="5640480"/>
                <a:tab algn="l" pos="5972040"/>
                <a:tab algn="l" pos="6303960"/>
                <a:tab algn="l" pos="663588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3DED1B-8AA0-4024-A6F7-3760D071E84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220320" y="288720"/>
            <a:ext cx="3957480" cy="1206360"/>
          </a:xfrm>
          <a:prstGeom prst="rect">
            <a:avLst/>
          </a:prstGeom>
          <a:noFill/>
          <a:ln w="0">
            <a:noFill/>
          </a:ln>
        </p:spPr>
        <p:txBody>
          <a:bodyPr lIns="66600" rIns="66600" tIns="33120" bIns="33120" anchor="ctr">
            <a:noAutofit/>
          </a:bodyPr>
          <a:p>
            <a:pPr indent="0" algn="ctr">
              <a:buNone/>
              <a:tabLst>
                <a:tab algn="l" pos="0"/>
                <a:tab algn="l" pos="331920"/>
                <a:tab algn="l" pos="663480"/>
                <a:tab algn="l" pos="995400"/>
                <a:tab algn="l" pos="1327320"/>
                <a:tab algn="l" pos="1658880"/>
                <a:tab algn="l" pos="1990800"/>
                <a:tab algn="l" pos="2322360"/>
                <a:tab algn="l" pos="2654280"/>
                <a:tab algn="l" pos="2986200"/>
                <a:tab algn="l" pos="3317760"/>
                <a:tab algn="l" pos="3649680"/>
                <a:tab algn="l" pos="3981600"/>
                <a:tab algn="l" pos="4313160"/>
                <a:tab algn="l" pos="4645080"/>
                <a:tab algn="l" pos="4976640"/>
                <a:tab algn="l" pos="5308560"/>
                <a:tab algn="l" pos="5640480"/>
                <a:tab algn="l" pos="5972040"/>
                <a:tab algn="l" pos="6303960"/>
                <a:tab algn="l" pos="663588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2A0540-2BC6-41FD-AD26-376C40697AC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220320" y="288720"/>
            <a:ext cx="3957480" cy="5593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575"/>
              </a:spcBef>
              <a:tabLst>
                <a:tab algn="l" pos="0"/>
                <a:tab algn="l" pos="331920"/>
                <a:tab algn="l" pos="663480"/>
                <a:tab algn="l" pos="995400"/>
                <a:tab algn="l" pos="1327320"/>
                <a:tab algn="l" pos="1658880"/>
                <a:tab algn="l" pos="1990800"/>
                <a:tab algn="l" pos="2322360"/>
                <a:tab algn="l" pos="2654280"/>
                <a:tab algn="l" pos="2986200"/>
                <a:tab algn="l" pos="3317760"/>
                <a:tab algn="l" pos="3649680"/>
                <a:tab algn="l" pos="3981600"/>
                <a:tab algn="l" pos="4313160"/>
                <a:tab algn="l" pos="4645080"/>
                <a:tab algn="l" pos="4976640"/>
                <a:tab algn="l" pos="5308560"/>
                <a:tab algn="l" pos="5640480"/>
                <a:tab algn="l" pos="5972040"/>
                <a:tab algn="l" pos="6303960"/>
                <a:tab algn="l" pos="663588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299EAE-B49F-4E2B-ADF6-00B54E14194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220320" y="288720"/>
            <a:ext cx="3957480" cy="1206360"/>
          </a:xfrm>
          <a:prstGeom prst="rect">
            <a:avLst/>
          </a:prstGeom>
          <a:noFill/>
          <a:ln w="0">
            <a:noFill/>
          </a:ln>
        </p:spPr>
        <p:txBody>
          <a:bodyPr lIns="66600" rIns="66600" tIns="33120" bIns="33120" anchor="ctr">
            <a:noAutofit/>
          </a:bodyPr>
          <a:p>
            <a:pPr indent="0" algn="ctr">
              <a:buNone/>
              <a:tabLst>
                <a:tab algn="l" pos="0"/>
                <a:tab algn="l" pos="331920"/>
                <a:tab algn="l" pos="663480"/>
                <a:tab algn="l" pos="995400"/>
                <a:tab algn="l" pos="1327320"/>
                <a:tab algn="l" pos="1658880"/>
                <a:tab algn="l" pos="1990800"/>
                <a:tab algn="l" pos="2322360"/>
                <a:tab algn="l" pos="2654280"/>
                <a:tab algn="l" pos="2986200"/>
                <a:tab algn="l" pos="3317760"/>
                <a:tab algn="l" pos="3649680"/>
                <a:tab algn="l" pos="3981600"/>
                <a:tab algn="l" pos="4313160"/>
                <a:tab algn="l" pos="4645080"/>
                <a:tab algn="l" pos="4976640"/>
                <a:tab algn="l" pos="5308560"/>
                <a:tab algn="l" pos="5640480"/>
                <a:tab algn="l" pos="5972040"/>
                <a:tab algn="l" pos="6303960"/>
                <a:tab algn="l" pos="663588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220320" y="1687680"/>
            <a:ext cx="1931040" cy="2276640"/>
          </a:xfrm>
          <a:prstGeom prst="rect">
            <a:avLst/>
          </a:prstGeom>
          <a:noFill/>
          <a:ln w="0">
            <a:noFill/>
          </a:ln>
        </p:spPr>
        <p:txBody>
          <a:bodyPr lIns="66600" rIns="66600" tIns="33120" bIns="33120" anchor="t">
            <a:normAutofit/>
          </a:bodyPr>
          <a:p>
            <a:pPr indent="0">
              <a:spcBef>
                <a:spcPts val="575"/>
              </a:spcBef>
              <a:buNone/>
              <a:tabLst>
                <a:tab algn="l" pos="331920"/>
                <a:tab algn="l" pos="663480"/>
                <a:tab algn="l" pos="995400"/>
                <a:tab algn="l" pos="1327320"/>
                <a:tab algn="l" pos="1658880"/>
                <a:tab algn="l" pos="1990800"/>
                <a:tab algn="l" pos="2322360"/>
                <a:tab algn="l" pos="2654280"/>
                <a:tab algn="l" pos="2986200"/>
                <a:tab algn="l" pos="3317760"/>
                <a:tab algn="l" pos="3649680"/>
                <a:tab algn="l" pos="3981600"/>
                <a:tab algn="l" pos="4313160"/>
                <a:tab algn="l" pos="4645080"/>
                <a:tab algn="l" pos="4976640"/>
                <a:tab algn="l" pos="5308560"/>
                <a:tab algn="l" pos="5640480"/>
                <a:tab algn="l" pos="5972040"/>
                <a:tab algn="l" pos="6303960"/>
                <a:tab algn="l" pos="663588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2248200" y="1687680"/>
            <a:ext cx="1931040" cy="4773600"/>
          </a:xfrm>
          <a:prstGeom prst="rect">
            <a:avLst/>
          </a:prstGeom>
          <a:noFill/>
          <a:ln w="0">
            <a:noFill/>
          </a:ln>
        </p:spPr>
        <p:txBody>
          <a:bodyPr lIns="66600" rIns="66600" tIns="33120" bIns="33120" anchor="t">
            <a:normAutofit/>
          </a:bodyPr>
          <a:p>
            <a:pPr indent="0">
              <a:spcBef>
                <a:spcPts val="575"/>
              </a:spcBef>
              <a:buNone/>
              <a:tabLst>
                <a:tab algn="l" pos="331920"/>
                <a:tab algn="l" pos="663480"/>
                <a:tab algn="l" pos="995400"/>
                <a:tab algn="l" pos="1327320"/>
                <a:tab algn="l" pos="1658880"/>
                <a:tab algn="l" pos="1990800"/>
                <a:tab algn="l" pos="2322360"/>
                <a:tab algn="l" pos="2654280"/>
                <a:tab algn="l" pos="2986200"/>
                <a:tab algn="l" pos="3317760"/>
                <a:tab algn="l" pos="3649680"/>
                <a:tab algn="l" pos="3981600"/>
                <a:tab algn="l" pos="4313160"/>
                <a:tab algn="l" pos="4645080"/>
                <a:tab algn="l" pos="4976640"/>
                <a:tab algn="l" pos="5308560"/>
                <a:tab algn="l" pos="5640480"/>
                <a:tab algn="l" pos="5972040"/>
                <a:tab algn="l" pos="6303960"/>
                <a:tab algn="l" pos="663588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220320" y="4181040"/>
            <a:ext cx="1931040" cy="2276640"/>
          </a:xfrm>
          <a:prstGeom prst="rect">
            <a:avLst/>
          </a:prstGeom>
          <a:noFill/>
          <a:ln w="0">
            <a:noFill/>
          </a:ln>
        </p:spPr>
        <p:txBody>
          <a:bodyPr lIns="66600" rIns="66600" tIns="33120" bIns="33120" anchor="t">
            <a:normAutofit/>
          </a:bodyPr>
          <a:p>
            <a:pPr indent="0">
              <a:spcBef>
                <a:spcPts val="575"/>
              </a:spcBef>
              <a:buNone/>
              <a:tabLst>
                <a:tab algn="l" pos="331920"/>
                <a:tab algn="l" pos="663480"/>
                <a:tab algn="l" pos="995400"/>
                <a:tab algn="l" pos="1327320"/>
                <a:tab algn="l" pos="1658880"/>
                <a:tab algn="l" pos="1990800"/>
                <a:tab algn="l" pos="2322360"/>
                <a:tab algn="l" pos="2654280"/>
                <a:tab algn="l" pos="2986200"/>
                <a:tab algn="l" pos="3317760"/>
                <a:tab algn="l" pos="3649680"/>
                <a:tab algn="l" pos="3981600"/>
                <a:tab algn="l" pos="4313160"/>
                <a:tab algn="l" pos="4645080"/>
                <a:tab algn="l" pos="4976640"/>
                <a:tab algn="l" pos="5308560"/>
                <a:tab algn="l" pos="5640480"/>
                <a:tab algn="l" pos="5972040"/>
                <a:tab algn="l" pos="6303960"/>
                <a:tab algn="l" pos="663588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DEBA6F-434E-4556-BC6C-7CBEF296B53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220320" y="288720"/>
            <a:ext cx="3957480" cy="1206360"/>
          </a:xfrm>
          <a:prstGeom prst="rect">
            <a:avLst/>
          </a:prstGeom>
          <a:noFill/>
          <a:ln w="0">
            <a:noFill/>
          </a:ln>
        </p:spPr>
        <p:txBody>
          <a:bodyPr lIns="66600" rIns="66600" tIns="33120" bIns="33120" anchor="ctr">
            <a:noAutofit/>
          </a:bodyPr>
          <a:p>
            <a:pPr indent="0" algn="ctr">
              <a:buNone/>
              <a:tabLst>
                <a:tab algn="l" pos="0"/>
                <a:tab algn="l" pos="331920"/>
                <a:tab algn="l" pos="663480"/>
                <a:tab algn="l" pos="995400"/>
                <a:tab algn="l" pos="1327320"/>
                <a:tab algn="l" pos="1658880"/>
                <a:tab algn="l" pos="1990800"/>
                <a:tab algn="l" pos="2322360"/>
                <a:tab algn="l" pos="2654280"/>
                <a:tab algn="l" pos="2986200"/>
                <a:tab algn="l" pos="3317760"/>
                <a:tab algn="l" pos="3649680"/>
                <a:tab algn="l" pos="3981600"/>
                <a:tab algn="l" pos="4313160"/>
                <a:tab algn="l" pos="4645080"/>
                <a:tab algn="l" pos="4976640"/>
                <a:tab algn="l" pos="5308560"/>
                <a:tab algn="l" pos="5640480"/>
                <a:tab algn="l" pos="5972040"/>
                <a:tab algn="l" pos="6303960"/>
                <a:tab algn="l" pos="663588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220320" y="1687680"/>
            <a:ext cx="1931040" cy="4773600"/>
          </a:xfrm>
          <a:prstGeom prst="rect">
            <a:avLst/>
          </a:prstGeom>
          <a:noFill/>
          <a:ln w="0">
            <a:noFill/>
          </a:ln>
        </p:spPr>
        <p:txBody>
          <a:bodyPr lIns="66600" rIns="66600" tIns="33120" bIns="33120" anchor="t">
            <a:normAutofit/>
          </a:bodyPr>
          <a:p>
            <a:pPr indent="0">
              <a:spcBef>
                <a:spcPts val="575"/>
              </a:spcBef>
              <a:buNone/>
              <a:tabLst>
                <a:tab algn="l" pos="331920"/>
                <a:tab algn="l" pos="663480"/>
                <a:tab algn="l" pos="995400"/>
                <a:tab algn="l" pos="1327320"/>
                <a:tab algn="l" pos="1658880"/>
                <a:tab algn="l" pos="1990800"/>
                <a:tab algn="l" pos="2322360"/>
                <a:tab algn="l" pos="2654280"/>
                <a:tab algn="l" pos="2986200"/>
                <a:tab algn="l" pos="3317760"/>
                <a:tab algn="l" pos="3649680"/>
                <a:tab algn="l" pos="3981600"/>
                <a:tab algn="l" pos="4313160"/>
                <a:tab algn="l" pos="4645080"/>
                <a:tab algn="l" pos="4976640"/>
                <a:tab algn="l" pos="5308560"/>
                <a:tab algn="l" pos="5640480"/>
                <a:tab algn="l" pos="5972040"/>
                <a:tab algn="l" pos="6303960"/>
                <a:tab algn="l" pos="663588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2248200" y="1687680"/>
            <a:ext cx="1931040" cy="2276640"/>
          </a:xfrm>
          <a:prstGeom prst="rect">
            <a:avLst/>
          </a:prstGeom>
          <a:noFill/>
          <a:ln w="0">
            <a:noFill/>
          </a:ln>
        </p:spPr>
        <p:txBody>
          <a:bodyPr lIns="66600" rIns="66600" tIns="33120" bIns="33120" anchor="t">
            <a:normAutofit/>
          </a:bodyPr>
          <a:p>
            <a:pPr indent="0">
              <a:spcBef>
                <a:spcPts val="575"/>
              </a:spcBef>
              <a:buNone/>
              <a:tabLst>
                <a:tab algn="l" pos="331920"/>
                <a:tab algn="l" pos="663480"/>
                <a:tab algn="l" pos="995400"/>
                <a:tab algn="l" pos="1327320"/>
                <a:tab algn="l" pos="1658880"/>
                <a:tab algn="l" pos="1990800"/>
                <a:tab algn="l" pos="2322360"/>
                <a:tab algn="l" pos="2654280"/>
                <a:tab algn="l" pos="2986200"/>
                <a:tab algn="l" pos="3317760"/>
                <a:tab algn="l" pos="3649680"/>
                <a:tab algn="l" pos="3981600"/>
                <a:tab algn="l" pos="4313160"/>
                <a:tab algn="l" pos="4645080"/>
                <a:tab algn="l" pos="4976640"/>
                <a:tab algn="l" pos="5308560"/>
                <a:tab algn="l" pos="5640480"/>
                <a:tab algn="l" pos="5972040"/>
                <a:tab algn="l" pos="6303960"/>
                <a:tab algn="l" pos="663588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2248200" y="4181040"/>
            <a:ext cx="1931040" cy="2276640"/>
          </a:xfrm>
          <a:prstGeom prst="rect">
            <a:avLst/>
          </a:prstGeom>
          <a:noFill/>
          <a:ln w="0">
            <a:noFill/>
          </a:ln>
        </p:spPr>
        <p:txBody>
          <a:bodyPr lIns="66600" rIns="66600" tIns="33120" bIns="33120" anchor="t">
            <a:normAutofit/>
          </a:bodyPr>
          <a:p>
            <a:pPr indent="0">
              <a:spcBef>
                <a:spcPts val="575"/>
              </a:spcBef>
              <a:buNone/>
              <a:tabLst>
                <a:tab algn="l" pos="331920"/>
                <a:tab algn="l" pos="663480"/>
                <a:tab algn="l" pos="995400"/>
                <a:tab algn="l" pos="1327320"/>
                <a:tab algn="l" pos="1658880"/>
                <a:tab algn="l" pos="1990800"/>
                <a:tab algn="l" pos="2322360"/>
                <a:tab algn="l" pos="2654280"/>
                <a:tab algn="l" pos="2986200"/>
                <a:tab algn="l" pos="3317760"/>
                <a:tab algn="l" pos="3649680"/>
                <a:tab algn="l" pos="3981600"/>
                <a:tab algn="l" pos="4313160"/>
                <a:tab algn="l" pos="4645080"/>
                <a:tab algn="l" pos="4976640"/>
                <a:tab algn="l" pos="5308560"/>
                <a:tab algn="l" pos="5640480"/>
                <a:tab algn="l" pos="5972040"/>
                <a:tab algn="l" pos="6303960"/>
                <a:tab algn="l" pos="663588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CFDE86-525C-4F7F-8E48-A7EE2014BAC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220320" y="288720"/>
            <a:ext cx="3957480" cy="1206360"/>
          </a:xfrm>
          <a:prstGeom prst="rect">
            <a:avLst/>
          </a:prstGeom>
          <a:noFill/>
          <a:ln w="0">
            <a:noFill/>
          </a:ln>
        </p:spPr>
        <p:txBody>
          <a:bodyPr lIns="66600" rIns="66600" tIns="33120" bIns="33120" anchor="ctr">
            <a:noAutofit/>
          </a:bodyPr>
          <a:p>
            <a:pPr indent="0" algn="ctr">
              <a:buNone/>
              <a:tabLst>
                <a:tab algn="l" pos="0"/>
                <a:tab algn="l" pos="331920"/>
                <a:tab algn="l" pos="663480"/>
                <a:tab algn="l" pos="995400"/>
                <a:tab algn="l" pos="1327320"/>
                <a:tab algn="l" pos="1658880"/>
                <a:tab algn="l" pos="1990800"/>
                <a:tab algn="l" pos="2322360"/>
                <a:tab algn="l" pos="2654280"/>
                <a:tab algn="l" pos="2986200"/>
                <a:tab algn="l" pos="3317760"/>
                <a:tab algn="l" pos="3649680"/>
                <a:tab algn="l" pos="3981600"/>
                <a:tab algn="l" pos="4313160"/>
                <a:tab algn="l" pos="4645080"/>
                <a:tab algn="l" pos="4976640"/>
                <a:tab algn="l" pos="5308560"/>
                <a:tab algn="l" pos="5640480"/>
                <a:tab algn="l" pos="5972040"/>
                <a:tab algn="l" pos="6303960"/>
                <a:tab algn="l" pos="663588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220320" y="1687680"/>
            <a:ext cx="1931040" cy="2276640"/>
          </a:xfrm>
          <a:prstGeom prst="rect">
            <a:avLst/>
          </a:prstGeom>
          <a:noFill/>
          <a:ln w="0">
            <a:noFill/>
          </a:ln>
        </p:spPr>
        <p:txBody>
          <a:bodyPr lIns="66600" rIns="66600" tIns="33120" bIns="33120" anchor="t">
            <a:normAutofit/>
          </a:bodyPr>
          <a:p>
            <a:pPr indent="0">
              <a:spcBef>
                <a:spcPts val="575"/>
              </a:spcBef>
              <a:buNone/>
              <a:tabLst>
                <a:tab algn="l" pos="331920"/>
                <a:tab algn="l" pos="663480"/>
                <a:tab algn="l" pos="995400"/>
                <a:tab algn="l" pos="1327320"/>
                <a:tab algn="l" pos="1658880"/>
                <a:tab algn="l" pos="1990800"/>
                <a:tab algn="l" pos="2322360"/>
                <a:tab algn="l" pos="2654280"/>
                <a:tab algn="l" pos="2986200"/>
                <a:tab algn="l" pos="3317760"/>
                <a:tab algn="l" pos="3649680"/>
                <a:tab algn="l" pos="3981600"/>
                <a:tab algn="l" pos="4313160"/>
                <a:tab algn="l" pos="4645080"/>
                <a:tab algn="l" pos="4976640"/>
                <a:tab algn="l" pos="5308560"/>
                <a:tab algn="l" pos="5640480"/>
                <a:tab algn="l" pos="5972040"/>
                <a:tab algn="l" pos="6303960"/>
                <a:tab algn="l" pos="663588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2248200" y="1687680"/>
            <a:ext cx="1931040" cy="2276640"/>
          </a:xfrm>
          <a:prstGeom prst="rect">
            <a:avLst/>
          </a:prstGeom>
          <a:noFill/>
          <a:ln w="0">
            <a:noFill/>
          </a:ln>
        </p:spPr>
        <p:txBody>
          <a:bodyPr lIns="66600" rIns="66600" tIns="33120" bIns="33120" anchor="t">
            <a:normAutofit/>
          </a:bodyPr>
          <a:p>
            <a:pPr indent="0">
              <a:spcBef>
                <a:spcPts val="575"/>
              </a:spcBef>
              <a:buNone/>
              <a:tabLst>
                <a:tab algn="l" pos="331920"/>
                <a:tab algn="l" pos="663480"/>
                <a:tab algn="l" pos="995400"/>
                <a:tab algn="l" pos="1327320"/>
                <a:tab algn="l" pos="1658880"/>
                <a:tab algn="l" pos="1990800"/>
                <a:tab algn="l" pos="2322360"/>
                <a:tab algn="l" pos="2654280"/>
                <a:tab algn="l" pos="2986200"/>
                <a:tab algn="l" pos="3317760"/>
                <a:tab algn="l" pos="3649680"/>
                <a:tab algn="l" pos="3981600"/>
                <a:tab algn="l" pos="4313160"/>
                <a:tab algn="l" pos="4645080"/>
                <a:tab algn="l" pos="4976640"/>
                <a:tab algn="l" pos="5308560"/>
                <a:tab algn="l" pos="5640480"/>
                <a:tab algn="l" pos="5972040"/>
                <a:tab algn="l" pos="6303960"/>
                <a:tab algn="l" pos="663588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220320" y="4181040"/>
            <a:ext cx="3957480" cy="2276640"/>
          </a:xfrm>
          <a:prstGeom prst="rect">
            <a:avLst/>
          </a:prstGeom>
          <a:noFill/>
          <a:ln w="0">
            <a:noFill/>
          </a:ln>
        </p:spPr>
        <p:txBody>
          <a:bodyPr lIns="66600" rIns="66600" tIns="33120" bIns="33120" anchor="t">
            <a:normAutofit/>
          </a:bodyPr>
          <a:p>
            <a:pPr indent="0">
              <a:spcBef>
                <a:spcPts val="575"/>
              </a:spcBef>
              <a:buNone/>
              <a:tabLst>
                <a:tab algn="l" pos="331920"/>
                <a:tab algn="l" pos="663480"/>
                <a:tab algn="l" pos="995400"/>
                <a:tab algn="l" pos="1327320"/>
                <a:tab algn="l" pos="1658880"/>
                <a:tab algn="l" pos="1990800"/>
                <a:tab algn="l" pos="2322360"/>
                <a:tab algn="l" pos="2654280"/>
                <a:tab algn="l" pos="2986200"/>
                <a:tab algn="l" pos="3317760"/>
                <a:tab algn="l" pos="3649680"/>
                <a:tab algn="l" pos="3981600"/>
                <a:tab algn="l" pos="4313160"/>
                <a:tab algn="l" pos="4645080"/>
                <a:tab algn="l" pos="4976640"/>
                <a:tab algn="l" pos="5308560"/>
                <a:tab algn="l" pos="5640480"/>
                <a:tab algn="l" pos="5972040"/>
                <a:tab algn="l" pos="6303960"/>
                <a:tab algn="l" pos="663588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F39F52-FFE6-47B9-8A0F-B73A5AF9559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220320" y="288720"/>
            <a:ext cx="3957480" cy="1206360"/>
          </a:xfrm>
          <a:prstGeom prst="rect">
            <a:avLst/>
          </a:prstGeom>
          <a:noFill/>
          <a:ln w="0">
            <a:noFill/>
          </a:ln>
        </p:spPr>
        <p:txBody>
          <a:bodyPr lIns="66600" rIns="66600" tIns="33120" bIns="33120" anchor="ctr">
            <a:noAutofit/>
          </a:bodyPr>
          <a:p>
            <a:pPr indent="0" algn="ctr">
              <a:buNone/>
              <a:tabLst>
                <a:tab algn="l" pos="0"/>
                <a:tab algn="l" pos="331920"/>
                <a:tab algn="l" pos="663480"/>
                <a:tab algn="l" pos="995400"/>
                <a:tab algn="l" pos="1327320"/>
                <a:tab algn="l" pos="1658880"/>
                <a:tab algn="l" pos="1990800"/>
                <a:tab algn="l" pos="2322360"/>
                <a:tab algn="l" pos="2654280"/>
                <a:tab algn="l" pos="2986200"/>
                <a:tab algn="l" pos="3317760"/>
                <a:tab algn="l" pos="3649680"/>
                <a:tab algn="l" pos="3981600"/>
                <a:tab algn="l" pos="4313160"/>
                <a:tab algn="l" pos="4645080"/>
                <a:tab algn="l" pos="4976640"/>
                <a:tab algn="l" pos="5308560"/>
                <a:tab algn="l" pos="5640480"/>
                <a:tab algn="l" pos="5972040"/>
                <a:tab algn="l" pos="6303960"/>
                <a:tab algn="l" pos="663588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220320" y="1687680"/>
            <a:ext cx="3957480" cy="4773600"/>
          </a:xfrm>
          <a:prstGeom prst="rect">
            <a:avLst/>
          </a:prstGeom>
          <a:noFill/>
          <a:ln w="0">
            <a:noFill/>
          </a:ln>
        </p:spPr>
        <p:txBody>
          <a:bodyPr lIns="66600" rIns="66600" tIns="33120" bIns="33120" anchor="t">
            <a:normAutofit/>
          </a:bodyPr>
          <a:p>
            <a:pPr marL="247680" indent="-247680">
              <a:spcBef>
                <a:spcPts val="575"/>
              </a:spcBef>
              <a:buClr>
                <a:srgbClr val="000000"/>
              </a:buClr>
              <a:buFont typeface="Arial"/>
              <a:buChar char="•"/>
              <a:tabLst>
                <a:tab algn="l" pos="331920"/>
                <a:tab algn="l" pos="663480"/>
                <a:tab algn="l" pos="995400"/>
                <a:tab algn="l" pos="1327320"/>
                <a:tab algn="l" pos="1658880"/>
                <a:tab algn="l" pos="1990800"/>
                <a:tab algn="l" pos="2322360"/>
                <a:tab algn="l" pos="2654280"/>
                <a:tab algn="l" pos="2986200"/>
                <a:tab algn="l" pos="3317760"/>
                <a:tab algn="l" pos="3649680"/>
                <a:tab algn="l" pos="3981600"/>
                <a:tab algn="l" pos="4313160"/>
                <a:tab algn="l" pos="4645080"/>
                <a:tab algn="l" pos="4976640"/>
                <a:tab algn="l" pos="5308560"/>
                <a:tab algn="l" pos="5640480"/>
                <a:tab algn="l" pos="5972040"/>
                <a:tab algn="l" pos="6303960"/>
                <a:tab algn="l" pos="6635880"/>
              </a:tabLst>
            </a:pPr>
            <a:r>
              <a:rPr b="0" lang="en-US" sz="23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  <a:p>
            <a:pPr lvl="1" marL="539640" indent="-206280">
              <a:spcBef>
                <a:spcPts val="575"/>
              </a:spcBef>
              <a:buClr>
                <a:srgbClr val="000000"/>
              </a:buClr>
              <a:buFont typeface="Arial"/>
              <a:buChar char="–"/>
              <a:tabLst>
                <a:tab algn="l" pos="331920"/>
                <a:tab algn="l" pos="663480"/>
                <a:tab algn="l" pos="995400"/>
                <a:tab algn="l" pos="1327320"/>
                <a:tab algn="l" pos="1658880"/>
                <a:tab algn="l" pos="1990800"/>
                <a:tab algn="l" pos="2322360"/>
                <a:tab algn="l" pos="2654280"/>
                <a:tab algn="l" pos="2986200"/>
                <a:tab algn="l" pos="3317760"/>
                <a:tab algn="l" pos="3649680"/>
                <a:tab algn="l" pos="3981600"/>
                <a:tab algn="l" pos="4313160"/>
                <a:tab algn="l" pos="4645080"/>
                <a:tab algn="l" pos="4976640"/>
                <a:tab algn="l" pos="5308560"/>
                <a:tab algn="l" pos="5640480"/>
                <a:tab algn="l" pos="5972040"/>
                <a:tab algn="l" pos="6303960"/>
                <a:tab algn="l" pos="6635880"/>
              </a:tabLst>
            </a:pPr>
            <a:r>
              <a:rPr b="0" lang="en-US" sz="23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  <a:p>
            <a:pPr lvl="2" marL="830160" indent="-164880">
              <a:spcBef>
                <a:spcPts val="575"/>
              </a:spcBef>
              <a:buClr>
                <a:srgbClr val="000000"/>
              </a:buClr>
              <a:buFont typeface="Arial"/>
              <a:buChar char="•"/>
              <a:tabLst>
                <a:tab algn="l" pos="331920"/>
                <a:tab algn="l" pos="663480"/>
                <a:tab algn="l" pos="995400"/>
                <a:tab algn="l" pos="1327320"/>
                <a:tab algn="l" pos="1658880"/>
                <a:tab algn="l" pos="1990800"/>
                <a:tab algn="l" pos="2322360"/>
                <a:tab algn="l" pos="2654280"/>
                <a:tab algn="l" pos="2986200"/>
                <a:tab algn="l" pos="3317760"/>
                <a:tab algn="l" pos="3649680"/>
                <a:tab algn="l" pos="3981600"/>
                <a:tab algn="l" pos="4313160"/>
                <a:tab algn="l" pos="4645080"/>
                <a:tab algn="l" pos="4976640"/>
                <a:tab algn="l" pos="5308560"/>
                <a:tab algn="l" pos="5640480"/>
                <a:tab algn="l" pos="5972040"/>
                <a:tab algn="l" pos="6303960"/>
                <a:tab algn="l" pos="6635880"/>
              </a:tabLst>
            </a:pPr>
            <a:r>
              <a:rPr b="0" lang="en-US" sz="23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  <a:p>
            <a:pPr lvl="3" marL="1162080" indent="-165240">
              <a:spcBef>
                <a:spcPts val="575"/>
              </a:spcBef>
              <a:buClr>
                <a:srgbClr val="000000"/>
              </a:buClr>
              <a:buFont typeface="Arial"/>
              <a:buChar char="–"/>
              <a:tabLst>
                <a:tab algn="l" pos="331920"/>
                <a:tab algn="l" pos="663480"/>
                <a:tab algn="l" pos="995400"/>
                <a:tab algn="l" pos="1327320"/>
                <a:tab algn="l" pos="1658880"/>
                <a:tab algn="l" pos="1990800"/>
                <a:tab algn="l" pos="2322360"/>
                <a:tab algn="l" pos="2654280"/>
                <a:tab algn="l" pos="2986200"/>
                <a:tab algn="l" pos="3317760"/>
                <a:tab algn="l" pos="3649680"/>
                <a:tab algn="l" pos="3981600"/>
                <a:tab algn="l" pos="4313160"/>
                <a:tab algn="l" pos="4645080"/>
                <a:tab algn="l" pos="4976640"/>
                <a:tab algn="l" pos="5308560"/>
                <a:tab algn="l" pos="5640480"/>
                <a:tab algn="l" pos="5972040"/>
                <a:tab algn="l" pos="6303960"/>
                <a:tab algn="l" pos="6635880"/>
              </a:tabLst>
            </a:pPr>
            <a:r>
              <a:rPr b="0" lang="en-US" sz="23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  <a:p>
            <a:pPr lvl="4" marL="1494000" indent="-165240">
              <a:spcBef>
                <a:spcPts val="575"/>
              </a:spcBef>
              <a:buClr>
                <a:srgbClr val="000000"/>
              </a:buClr>
              <a:buFont typeface="Arial"/>
              <a:buChar char="»"/>
              <a:tabLst>
                <a:tab algn="l" pos="331920"/>
                <a:tab algn="l" pos="663480"/>
                <a:tab algn="l" pos="995400"/>
                <a:tab algn="l" pos="1327320"/>
                <a:tab algn="l" pos="1658880"/>
                <a:tab algn="l" pos="1990800"/>
                <a:tab algn="l" pos="2322360"/>
                <a:tab algn="l" pos="2654280"/>
                <a:tab algn="l" pos="2986200"/>
                <a:tab algn="l" pos="3317760"/>
                <a:tab algn="l" pos="3649680"/>
                <a:tab algn="l" pos="3981600"/>
                <a:tab algn="l" pos="4313160"/>
                <a:tab algn="l" pos="4645080"/>
                <a:tab algn="l" pos="4976640"/>
                <a:tab algn="l" pos="5308560"/>
                <a:tab algn="l" pos="5640480"/>
                <a:tab algn="l" pos="5972040"/>
                <a:tab algn="l" pos="6303960"/>
                <a:tab algn="l" pos="6635880"/>
              </a:tabLst>
            </a:pPr>
            <a:r>
              <a:rPr b="0" lang="en-US" sz="23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  <a:p>
            <a:pPr lvl="5" marL="1494000" indent="-165240">
              <a:spcBef>
                <a:spcPts val="575"/>
              </a:spcBef>
              <a:buClr>
                <a:srgbClr val="000000"/>
              </a:buClr>
              <a:buFont typeface="Arial"/>
              <a:buChar char="»"/>
              <a:tabLst>
                <a:tab algn="l" pos="331920"/>
                <a:tab algn="l" pos="663480"/>
                <a:tab algn="l" pos="995400"/>
                <a:tab algn="l" pos="1327320"/>
                <a:tab algn="l" pos="1658880"/>
                <a:tab algn="l" pos="1990800"/>
                <a:tab algn="l" pos="2322360"/>
                <a:tab algn="l" pos="2654280"/>
                <a:tab algn="l" pos="2986200"/>
                <a:tab algn="l" pos="3317760"/>
                <a:tab algn="l" pos="3649680"/>
                <a:tab algn="l" pos="3981600"/>
                <a:tab algn="l" pos="4313160"/>
                <a:tab algn="l" pos="4645080"/>
                <a:tab algn="l" pos="4976640"/>
                <a:tab algn="l" pos="5308560"/>
                <a:tab algn="l" pos="5640480"/>
                <a:tab algn="l" pos="5972040"/>
                <a:tab algn="l" pos="6303960"/>
                <a:tab algn="l" pos="6635880"/>
              </a:tabLst>
            </a:pPr>
            <a:r>
              <a:rPr b="0" lang="en-US" sz="23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  <a:p>
            <a:pPr lvl="6" marL="1494000" indent="-165240">
              <a:spcBef>
                <a:spcPts val="575"/>
              </a:spcBef>
              <a:buClr>
                <a:srgbClr val="000000"/>
              </a:buClr>
              <a:buFont typeface="Arial"/>
              <a:buChar char="»"/>
              <a:tabLst>
                <a:tab algn="l" pos="331920"/>
                <a:tab algn="l" pos="663480"/>
                <a:tab algn="l" pos="995400"/>
                <a:tab algn="l" pos="1327320"/>
                <a:tab algn="l" pos="1658880"/>
                <a:tab algn="l" pos="1990800"/>
                <a:tab algn="l" pos="2322360"/>
                <a:tab algn="l" pos="2654280"/>
                <a:tab algn="l" pos="2986200"/>
                <a:tab algn="l" pos="3317760"/>
                <a:tab algn="l" pos="3649680"/>
                <a:tab algn="l" pos="3981600"/>
                <a:tab algn="l" pos="4313160"/>
                <a:tab algn="l" pos="4645080"/>
                <a:tab algn="l" pos="4976640"/>
                <a:tab algn="l" pos="5308560"/>
                <a:tab algn="l" pos="5640480"/>
                <a:tab algn="l" pos="5972040"/>
                <a:tab algn="l" pos="6303960"/>
                <a:tab algn="l" pos="6635880"/>
              </a:tabLst>
            </a:pPr>
            <a:r>
              <a:rPr b="0" lang="en-US" sz="23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220320" y="6703560"/>
            <a:ext cx="1025640" cy="384120"/>
          </a:xfrm>
          <a:prstGeom prst="rect">
            <a:avLst/>
          </a:prstGeom>
          <a:noFill/>
          <a:ln w="0">
            <a:noFill/>
          </a:ln>
        </p:spPr>
        <p:txBody>
          <a:bodyPr lIns="66600" rIns="66600" tIns="33120" bIns="33120" anchor="ctr">
            <a:noAutofit/>
          </a:bodyPr>
          <a:lstStyle>
            <a:lvl1pPr indent="0">
              <a:buNone/>
              <a:tabLst>
                <a:tab algn="l" pos="0"/>
                <a:tab algn="l" pos="331920"/>
                <a:tab algn="l" pos="663480"/>
                <a:tab algn="l" pos="995400"/>
                <a:tab algn="l" pos="1327320"/>
                <a:tab algn="l" pos="1658880"/>
                <a:tab algn="l" pos="1990800"/>
                <a:tab algn="l" pos="2322360"/>
                <a:tab algn="l" pos="2654280"/>
                <a:tab algn="l" pos="2986200"/>
                <a:tab algn="l" pos="3317760"/>
                <a:tab algn="l" pos="3649680"/>
                <a:tab algn="l" pos="3981600"/>
                <a:tab algn="l" pos="4313160"/>
                <a:tab algn="l" pos="4645080"/>
                <a:tab algn="l" pos="4976640"/>
                <a:tab algn="l" pos="5308560"/>
                <a:tab algn="l" pos="5640480"/>
                <a:tab algn="l" pos="5972040"/>
                <a:tab algn="l" pos="6303960"/>
                <a:tab algn="l" pos="6635880"/>
              </a:tabLst>
              <a:defRPr b="0" lang="fr-FR" sz="9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331920"/>
                <a:tab algn="l" pos="663480"/>
                <a:tab algn="l" pos="995400"/>
                <a:tab algn="l" pos="1327320"/>
                <a:tab algn="l" pos="1658880"/>
                <a:tab algn="l" pos="1990800"/>
                <a:tab algn="l" pos="2322360"/>
                <a:tab algn="l" pos="2654280"/>
                <a:tab algn="l" pos="2986200"/>
                <a:tab algn="l" pos="3317760"/>
                <a:tab algn="l" pos="3649680"/>
                <a:tab algn="l" pos="3981600"/>
                <a:tab algn="l" pos="4313160"/>
                <a:tab algn="l" pos="4645080"/>
                <a:tab algn="l" pos="4976640"/>
                <a:tab algn="l" pos="5308560"/>
                <a:tab algn="l" pos="5640480"/>
                <a:tab algn="l" pos="5972040"/>
                <a:tab algn="l" pos="6303960"/>
                <a:tab algn="l" pos="6635880"/>
              </a:tabLst>
            </a:pPr>
            <a:fld id="{DA96B278-71FA-4C2D-BE57-0F0D38E58793}" type="datetime">
              <a:rPr b="0" lang="fr-FR" sz="900" spc="-1" strike="noStrike">
                <a:solidFill>
                  <a:srgbClr val="898989"/>
                </a:solidFill>
                <a:latin typeface="Calibri"/>
              </a:rPr>
              <a:t>29/08/26</a:t>
            </a:fld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1503000" y="6703560"/>
            <a:ext cx="1392120" cy="384120"/>
          </a:xfrm>
          <a:prstGeom prst="rect">
            <a:avLst/>
          </a:prstGeom>
          <a:noFill/>
          <a:ln w="0">
            <a:noFill/>
          </a:ln>
        </p:spPr>
        <p:txBody>
          <a:bodyPr lIns="66600" rIns="66600" tIns="33120" bIns="33120" anchor="ctr">
            <a:noAutofit/>
          </a:bodyPr>
          <a:p>
            <a:pPr indent="0">
              <a:buNone/>
              <a:tabLst>
                <a:tab algn="l" pos="0"/>
                <a:tab algn="l" pos="331920"/>
                <a:tab algn="l" pos="663480"/>
                <a:tab algn="l" pos="995400"/>
                <a:tab algn="l" pos="1327320"/>
                <a:tab algn="l" pos="1658880"/>
                <a:tab algn="l" pos="1990800"/>
                <a:tab algn="l" pos="2322360"/>
                <a:tab algn="l" pos="2654280"/>
                <a:tab algn="l" pos="2986200"/>
                <a:tab algn="l" pos="3317760"/>
                <a:tab algn="l" pos="3649680"/>
                <a:tab algn="l" pos="3981600"/>
                <a:tab algn="l" pos="4313160"/>
                <a:tab algn="l" pos="4645080"/>
                <a:tab algn="l" pos="4976640"/>
                <a:tab algn="l" pos="5308560"/>
                <a:tab algn="l" pos="5640480"/>
                <a:tab algn="l" pos="5972040"/>
                <a:tab algn="l" pos="6303960"/>
                <a:tab algn="l" pos="6635880"/>
              </a:tabLst>
            </a:pP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3152880" y="6703560"/>
            <a:ext cx="1025280" cy="384120"/>
          </a:xfrm>
          <a:prstGeom prst="rect">
            <a:avLst/>
          </a:prstGeom>
          <a:noFill/>
          <a:ln w="0">
            <a:noFill/>
          </a:ln>
        </p:spPr>
        <p:txBody>
          <a:bodyPr lIns="66600" rIns="66600" tIns="33120" bIns="33120" anchor="ctr">
            <a:noAutofit/>
          </a:bodyPr>
          <a:lstStyle>
            <a:lvl1pPr indent="0" algn="r">
              <a:buNone/>
              <a:tabLst>
                <a:tab algn="l" pos="0"/>
                <a:tab algn="l" pos="331920"/>
                <a:tab algn="l" pos="663480"/>
                <a:tab algn="l" pos="995400"/>
                <a:tab algn="l" pos="1327320"/>
                <a:tab algn="l" pos="1658880"/>
                <a:tab algn="l" pos="1990800"/>
                <a:tab algn="l" pos="2322360"/>
                <a:tab algn="l" pos="2654280"/>
                <a:tab algn="l" pos="2986200"/>
                <a:tab algn="l" pos="3317760"/>
                <a:tab algn="l" pos="3649680"/>
                <a:tab algn="l" pos="3981600"/>
                <a:tab algn="l" pos="4313160"/>
                <a:tab algn="l" pos="4645080"/>
                <a:tab algn="l" pos="4976640"/>
                <a:tab algn="l" pos="5308560"/>
                <a:tab algn="l" pos="5640480"/>
                <a:tab algn="l" pos="5972040"/>
                <a:tab algn="l" pos="6303960"/>
                <a:tab algn="l" pos="6635880"/>
              </a:tabLst>
              <a:defRPr b="0" lang="fr-FR" sz="9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331920"/>
                <a:tab algn="l" pos="663480"/>
                <a:tab algn="l" pos="995400"/>
                <a:tab algn="l" pos="1327320"/>
                <a:tab algn="l" pos="1658880"/>
                <a:tab algn="l" pos="1990800"/>
                <a:tab algn="l" pos="2322360"/>
                <a:tab algn="l" pos="2654280"/>
                <a:tab algn="l" pos="2986200"/>
                <a:tab algn="l" pos="3317760"/>
                <a:tab algn="l" pos="3649680"/>
                <a:tab algn="l" pos="3981600"/>
                <a:tab algn="l" pos="4313160"/>
                <a:tab algn="l" pos="4645080"/>
                <a:tab algn="l" pos="4976640"/>
                <a:tab algn="l" pos="5308560"/>
                <a:tab algn="l" pos="5640480"/>
                <a:tab algn="l" pos="5972040"/>
                <a:tab algn="l" pos="6303960"/>
                <a:tab algn="l" pos="6635880"/>
              </a:tabLst>
            </a:pPr>
            <a:fld id="{99F03F5F-BA45-4416-95E7-1EAC1911ECF5}" type="slidenum">
              <a:rPr b="0" lang="fr-FR" sz="9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er 95"/>
          <p:cNvGrpSpPr/>
          <p:nvPr/>
        </p:nvGrpSpPr>
        <p:grpSpPr>
          <a:xfrm>
            <a:off x="82800" y="5573880"/>
            <a:ext cx="4375440" cy="1608480"/>
            <a:chOff x="82800" y="5573880"/>
            <a:chExt cx="4375440" cy="1608480"/>
          </a:xfrm>
        </p:grpSpPr>
        <p:grpSp>
          <p:nvGrpSpPr>
            <p:cNvPr id="42" name="Grouper 220"/>
            <p:cNvGrpSpPr/>
            <p:nvPr/>
          </p:nvGrpSpPr>
          <p:grpSpPr>
            <a:xfrm>
              <a:off x="95400" y="5573880"/>
              <a:ext cx="4362840" cy="1608480"/>
              <a:chOff x="95400" y="5573880"/>
              <a:chExt cx="4362840" cy="1608480"/>
            </a:xfrm>
          </p:grpSpPr>
          <p:grpSp>
            <p:nvGrpSpPr>
              <p:cNvPr id="43" name="Grouper 117"/>
              <p:cNvGrpSpPr/>
              <p:nvPr/>
            </p:nvGrpSpPr>
            <p:grpSpPr>
              <a:xfrm>
                <a:off x="95400" y="5792040"/>
                <a:ext cx="4362840" cy="1390320"/>
                <a:chOff x="95400" y="5792040"/>
                <a:chExt cx="4362840" cy="1390320"/>
              </a:xfrm>
            </p:grpSpPr>
            <p:pic>
              <p:nvPicPr>
                <p:cNvPr id="44" name="Image 134" descr=""/>
                <p:cNvPicPr/>
                <p:nvPr/>
              </p:nvPicPr>
              <p:blipFill>
                <a:blip r:embed="rId1"/>
                <a:stretch/>
              </p:blipFill>
              <p:spPr>
                <a:xfrm>
                  <a:off x="564840" y="6396120"/>
                  <a:ext cx="2956320" cy="764640"/>
                </a:xfrm>
                <a:prstGeom prst="rect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</p:pic>
            <p:sp>
              <p:nvSpPr>
                <p:cNvPr id="45" name="Connecteur droit 135"/>
                <p:cNvSpPr/>
                <p:nvPr/>
              </p:nvSpPr>
              <p:spPr>
                <a:xfrm>
                  <a:off x="470520" y="7066080"/>
                  <a:ext cx="94320" cy="144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3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6" name="ZoneTexte 136"/>
                <p:cNvSpPr/>
                <p:nvPr/>
              </p:nvSpPr>
              <p:spPr>
                <a:xfrm>
                  <a:off x="95400" y="6951240"/>
                  <a:ext cx="404640" cy="231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331920"/>
                      <a:tab algn="l" pos="663480"/>
                      <a:tab algn="l" pos="995400"/>
                      <a:tab algn="l" pos="1327320"/>
                      <a:tab algn="l" pos="1658880"/>
                      <a:tab algn="l" pos="1990800"/>
                      <a:tab algn="l" pos="2322360"/>
                      <a:tab algn="l" pos="2654280"/>
                      <a:tab algn="l" pos="2986200"/>
                      <a:tab algn="l" pos="3317760"/>
                      <a:tab algn="l" pos="3649680"/>
                      <a:tab algn="l" pos="3981600"/>
                      <a:tab algn="l" pos="4313160"/>
                      <a:tab algn="l" pos="4645080"/>
                      <a:tab algn="l" pos="4976640"/>
                      <a:tab algn="l" pos="5308560"/>
                      <a:tab algn="l" pos="5640480"/>
                      <a:tab algn="l" pos="5972040"/>
                      <a:tab algn="l" pos="6303960"/>
                      <a:tab algn="l" pos="6635880"/>
                    </a:tabLst>
                  </a:pPr>
                  <a:r>
                    <a:rPr b="1" lang="en-US" sz="9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15.0</a:t>
                  </a:r>
                  <a:endParaRPr b="0" lang="en-US" sz="9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7" name="Connecteur droit 137"/>
                <p:cNvSpPr/>
                <p:nvPr/>
              </p:nvSpPr>
              <p:spPr>
                <a:xfrm>
                  <a:off x="470520" y="6497640"/>
                  <a:ext cx="94320" cy="144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3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8" name="ZoneTexte 138"/>
                <p:cNvSpPr/>
                <p:nvPr/>
              </p:nvSpPr>
              <p:spPr>
                <a:xfrm>
                  <a:off x="95400" y="6379920"/>
                  <a:ext cx="404640" cy="231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331920"/>
                      <a:tab algn="l" pos="663480"/>
                      <a:tab algn="l" pos="995400"/>
                      <a:tab algn="l" pos="1327320"/>
                      <a:tab algn="l" pos="1658880"/>
                      <a:tab algn="l" pos="1990800"/>
                      <a:tab algn="l" pos="2322360"/>
                      <a:tab algn="l" pos="2654280"/>
                      <a:tab algn="l" pos="2986200"/>
                      <a:tab algn="l" pos="3317760"/>
                      <a:tab algn="l" pos="3649680"/>
                      <a:tab algn="l" pos="3981600"/>
                      <a:tab algn="l" pos="4313160"/>
                      <a:tab algn="l" pos="4645080"/>
                      <a:tab algn="l" pos="4976640"/>
                      <a:tab algn="l" pos="5308560"/>
                      <a:tab algn="l" pos="5640480"/>
                      <a:tab algn="l" pos="5972040"/>
                      <a:tab algn="l" pos="6303960"/>
                      <a:tab algn="l" pos="6635880"/>
                    </a:tabLst>
                  </a:pPr>
                  <a:r>
                    <a:rPr b="1" lang="en-US" sz="9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25.0</a:t>
                  </a:r>
                  <a:endParaRPr b="0" lang="en-US" sz="9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9" name="ZoneTexte 139"/>
                <p:cNvSpPr/>
                <p:nvPr/>
              </p:nvSpPr>
              <p:spPr>
                <a:xfrm>
                  <a:off x="522000" y="5792400"/>
                  <a:ext cx="656280" cy="4287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331920"/>
                      <a:tab algn="l" pos="663480"/>
                      <a:tab algn="l" pos="995400"/>
                      <a:tab algn="l" pos="1327320"/>
                      <a:tab algn="l" pos="1658880"/>
                      <a:tab algn="l" pos="1990800"/>
                      <a:tab algn="l" pos="2322360"/>
                      <a:tab algn="l" pos="2654280"/>
                      <a:tab algn="l" pos="2986200"/>
                      <a:tab algn="l" pos="3317760"/>
                      <a:tab algn="l" pos="3649680"/>
                      <a:tab algn="l" pos="3981600"/>
                      <a:tab algn="l" pos="4313160"/>
                      <a:tab algn="l" pos="4645080"/>
                      <a:tab algn="l" pos="4976640"/>
                      <a:tab algn="l" pos="5308560"/>
                      <a:tab algn="l" pos="5640480"/>
                      <a:tab algn="l" pos="5972040"/>
                      <a:tab algn="l" pos="6303960"/>
                      <a:tab algn="l" pos="6635880"/>
                    </a:tabLst>
                  </a:pPr>
                  <a:r>
                    <a:rPr b="1" lang="fr-FR" sz="11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Extract</a:t>
                  </a:r>
                  <a:endParaRPr b="0" lang="en-US" sz="1100" spc="-1" strike="noStrike">
                    <a:solidFill>
                      <a:srgbClr val="000000"/>
                    </a:solidFill>
                    <a:latin typeface="Calibri"/>
                  </a:endParaRPr>
                </a:p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331920"/>
                      <a:tab algn="l" pos="663480"/>
                      <a:tab algn="l" pos="995400"/>
                      <a:tab algn="l" pos="1327320"/>
                      <a:tab algn="l" pos="1658880"/>
                      <a:tab algn="l" pos="1990800"/>
                      <a:tab algn="l" pos="2322360"/>
                      <a:tab algn="l" pos="2654280"/>
                      <a:tab algn="l" pos="2986200"/>
                      <a:tab algn="l" pos="3317760"/>
                      <a:tab algn="l" pos="3649680"/>
                      <a:tab algn="l" pos="3981600"/>
                      <a:tab algn="l" pos="4313160"/>
                      <a:tab algn="l" pos="4645080"/>
                      <a:tab algn="l" pos="4976640"/>
                      <a:tab algn="l" pos="5308560"/>
                      <a:tab algn="l" pos="5640480"/>
                      <a:tab algn="l" pos="5972040"/>
                      <a:tab algn="l" pos="6303960"/>
                      <a:tab algn="l" pos="6635880"/>
                    </a:tabLst>
                  </a:pPr>
                  <a:r>
                    <a:rPr b="1" lang="fr-FR" sz="11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ClpP</a:t>
                  </a:r>
                  <a:endParaRPr b="0" lang="en-US" sz="11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0" name="ZoneTexte 140"/>
                <p:cNvSpPr/>
                <p:nvPr/>
              </p:nvSpPr>
              <p:spPr>
                <a:xfrm>
                  <a:off x="1056960" y="5976360"/>
                  <a:ext cx="49932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331920"/>
                      <a:tab algn="l" pos="663480"/>
                      <a:tab algn="l" pos="995400"/>
                      <a:tab algn="l" pos="1327320"/>
                      <a:tab algn="l" pos="1658880"/>
                      <a:tab algn="l" pos="1990800"/>
                      <a:tab algn="l" pos="2322360"/>
                      <a:tab algn="l" pos="2654280"/>
                      <a:tab algn="l" pos="2986200"/>
                      <a:tab algn="l" pos="3317760"/>
                      <a:tab algn="l" pos="3649680"/>
                      <a:tab algn="l" pos="3981600"/>
                      <a:tab algn="l" pos="4313160"/>
                      <a:tab algn="l" pos="4645080"/>
                      <a:tab algn="l" pos="4976640"/>
                      <a:tab algn="l" pos="5308560"/>
                      <a:tab algn="l" pos="5640480"/>
                      <a:tab algn="l" pos="5972040"/>
                      <a:tab algn="l" pos="6303960"/>
                      <a:tab algn="l" pos="6635880"/>
                    </a:tabLst>
                  </a:pPr>
                  <a:r>
                    <a:rPr b="1" lang="fr-FR" sz="11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ClpP</a:t>
                  </a:r>
                  <a:endParaRPr b="0" lang="en-US" sz="11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1" name="ZoneTexte 141"/>
                <p:cNvSpPr/>
                <p:nvPr/>
              </p:nvSpPr>
              <p:spPr>
                <a:xfrm>
                  <a:off x="1494000" y="5976360"/>
                  <a:ext cx="57708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331920"/>
                      <a:tab algn="l" pos="663480"/>
                      <a:tab algn="l" pos="995400"/>
                      <a:tab algn="l" pos="1327320"/>
                      <a:tab algn="l" pos="1658880"/>
                      <a:tab algn="l" pos="1990800"/>
                      <a:tab algn="l" pos="2322360"/>
                      <a:tab algn="l" pos="2654280"/>
                      <a:tab algn="l" pos="2986200"/>
                      <a:tab algn="l" pos="3317760"/>
                      <a:tab algn="l" pos="3649680"/>
                      <a:tab algn="l" pos="3981600"/>
                      <a:tab algn="l" pos="4313160"/>
                      <a:tab algn="l" pos="4645080"/>
                      <a:tab algn="l" pos="4976640"/>
                      <a:tab algn="l" pos="5308560"/>
                      <a:tab algn="l" pos="5640480"/>
                      <a:tab algn="l" pos="5972040"/>
                      <a:tab algn="l" pos="6303960"/>
                      <a:tab algn="l" pos="6635880"/>
                    </a:tabLst>
                  </a:pPr>
                  <a:r>
                    <a:rPr b="1" lang="en-US" sz="11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ClpP1</a:t>
                  </a:r>
                  <a:endParaRPr b="0" lang="en-US" sz="11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2" name="ZoneTexte 142"/>
                <p:cNvSpPr/>
                <p:nvPr/>
              </p:nvSpPr>
              <p:spPr>
                <a:xfrm>
                  <a:off x="1989000" y="5976360"/>
                  <a:ext cx="57708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331920"/>
                      <a:tab algn="l" pos="663480"/>
                      <a:tab algn="l" pos="995400"/>
                      <a:tab algn="l" pos="1327320"/>
                      <a:tab algn="l" pos="1658880"/>
                      <a:tab algn="l" pos="1990800"/>
                      <a:tab algn="l" pos="2322360"/>
                      <a:tab algn="l" pos="2654280"/>
                      <a:tab algn="l" pos="2986200"/>
                      <a:tab algn="l" pos="3317760"/>
                      <a:tab algn="l" pos="3649680"/>
                      <a:tab algn="l" pos="3981600"/>
                      <a:tab algn="l" pos="4313160"/>
                      <a:tab algn="l" pos="4645080"/>
                      <a:tab algn="l" pos="4976640"/>
                      <a:tab algn="l" pos="5308560"/>
                      <a:tab algn="l" pos="5640480"/>
                      <a:tab algn="l" pos="5972040"/>
                      <a:tab algn="l" pos="6303960"/>
                      <a:tab algn="l" pos="6635880"/>
                    </a:tabLst>
                  </a:pPr>
                  <a:r>
                    <a:rPr b="1" lang="en-US" sz="11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ClpP2</a:t>
                  </a:r>
                  <a:endParaRPr b="0" lang="en-US" sz="11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3" name="ZoneTexte 143"/>
                <p:cNvSpPr/>
                <p:nvPr/>
              </p:nvSpPr>
              <p:spPr>
                <a:xfrm>
                  <a:off x="2471400" y="5792040"/>
                  <a:ext cx="577080" cy="4287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331920"/>
                      <a:tab algn="l" pos="663480"/>
                      <a:tab algn="l" pos="995400"/>
                      <a:tab algn="l" pos="1327320"/>
                      <a:tab algn="l" pos="1658880"/>
                      <a:tab algn="l" pos="1990800"/>
                      <a:tab algn="l" pos="2322360"/>
                      <a:tab algn="l" pos="2654280"/>
                      <a:tab algn="l" pos="2986200"/>
                      <a:tab algn="l" pos="3317760"/>
                      <a:tab algn="l" pos="3649680"/>
                      <a:tab algn="l" pos="3981600"/>
                      <a:tab algn="l" pos="4313160"/>
                      <a:tab algn="l" pos="4645080"/>
                      <a:tab algn="l" pos="4976640"/>
                      <a:tab algn="l" pos="5308560"/>
                      <a:tab algn="l" pos="5640480"/>
                      <a:tab algn="l" pos="5972040"/>
                      <a:tab algn="l" pos="6303960"/>
                      <a:tab algn="l" pos="6635880"/>
                    </a:tabLst>
                  </a:pPr>
                  <a:r>
                    <a:rPr b="1" lang="fr-FR" sz="11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ClpP</a:t>
                  </a:r>
                  <a:endParaRPr b="0" lang="en-US" sz="1100" spc="-1" strike="noStrike">
                    <a:solidFill>
                      <a:srgbClr val="000000"/>
                    </a:solidFill>
                    <a:latin typeface="Calibri"/>
                  </a:endParaRPr>
                </a:p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331920"/>
                      <a:tab algn="l" pos="663480"/>
                      <a:tab algn="l" pos="995400"/>
                      <a:tab algn="l" pos="1327320"/>
                      <a:tab algn="l" pos="1658880"/>
                      <a:tab algn="l" pos="1990800"/>
                      <a:tab algn="l" pos="2322360"/>
                      <a:tab algn="l" pos="2654280"/>
                      <a:tab algn="l" pos="2986200"/>
                      <a:tab algn="l" pos="3317760"/>
                      <a:tab algn="l" pos="3649680"/>
                      <a:tab algn="l" pos="3981600"/>
                      <a:tab algn="l" pos="4313160"/>
                      <a:tab algn="l" pos="4645080"/>
                      <a:tab algn="l" pos="4976640"/>
                      <a:tab algn="l" pos="5308560"/>
                      <a:tab algn="l" pos="5640480"/>
                      <a:tab algn="l" pos="5972040"/>
                      <a:tab algn="l" pos="6303960"/>
                      <a:tab algn="l" pos="6635880"/>
                    </a:tabLst>
                  </a:pPr>
                  <a:r>
                    <a:rPr b="1" lang="fr-FR" sz="11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ClpP1</a:t>
                  </a:r>
                  <a:endParaRPr b="0" lang="en-US" sz="11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4" name="ZoneTexte 144"/>
                <p:cNvSpPr/>
                <p:nvPr/>
              </p:nvSpPr>
              <p:spPr>
                <a:xfrm>
                  <a:off x="2953800" y="5792040"/>
                  <a:ext cx="577080" cy="4287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331920"/>
                      <a:tab algn="l" pos="663480"/>
                      <a:tab algn="l" pos="995400"/>
                      <a:tab algn="l" pos="1327320"/>
                      <a:tab algn="l" pos="1658880"/>
                      <a:tab algn="l" pos="1990800"/>
                      <a:tab algn="l" pos="2322360"/>
                      <a:tab algn="l" pos="2654280"/>
                      <a:tab algn="l" pos="2986200"/>
                      <a:tab algn="l" pos="3317760"/>
                      <a:tab algn="l" pos="3649680"/>
                      <a:tab algn="l" pos="3981600"/>
                      <a:tab algn="l" pos="4313160"/>
                      <a:tab algn="l" pos="4645080"/>
                      <a:tab algn="l" pos="4976640"/>
                      <a:tab algn="l" pos="5308560"/>
                      <a:tab algn="l" pos="5640480"/>
                      <a:tab algn="l" pos="5972040"/>
                      <a:tab algn="l" pos="6303960"/>
                      <a:tab algn="l" pos="6635880"/>
                    </a:tabLst>
                  </a:pPr>
                  <a:r>
                    <a:rPr b="1" lang="fr-FR" sz="11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ClpP</a:t>
                  </a:r>
                  <a:endParaRPr b="0" lang="en-US" sz="1100" spc="-1" strike="noStrike">
                    <a:solidFill>
                      <a:srgbClr val="000000"/>
                    </a:solidFill>
                    <a:latin typeface="Calibri"/>
                  </a:endParaRPr>
                </a:p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331920"/>
                      <a:tab algn="l" pos="663480"/>
                      <a:tab algn="l" pos="995400"/>
                      <a:tab algn="l" pos="1327320"/>
                      <a:tab algn="l" pos="1658880"/>
                      <a:tab algn="l" pos="1990800"/>
                      <a:tab algn="l" pos="2322360"/>
                      <a:tab algn="l" pos="2654280"/>
                      <a:tab algn="l" pos="2986200"/>
                      <a:tab algn="l" pos="3317760"/>
                      <a:tab algn="l" pos="3649680"/>
                      <a:tab algn="l" pos="3981600"/>
                      <a:tab algn="l" pos="4313160"/>
                      <a:tab algn="l" pos="4645080"/>
                      <a:tab algn="l" pos="4976640"/>
                      <a:tab algn="l" pos="5308560"/>
                      <a:tab algn="l" pos="5640480"/>
                      <a:tab algn="l" pos="5972040"/>
                      <a:tab algn="l" pos="6303960"/>
                      <a:tab algn="l" pos="6635880"/>
                    </a:tabLst>
                  </a:pPr>
                  <a:r>
                    <a:rPr b="1" lang="fr-FR" sz="11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ClpP2</a:t>
                  </a:r>
                  <a:endParaRPr b="0" lang="en-US" sz="11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5" name="Triangle isocèle 145"/>
                <p:cNvSpPr/>
                <p:nvPr/>
              </p:nvSpPr>
              <p:spPr>
                <a:xfrm rot="16200000">
                  <a:off x="3588480" y="6480360"/>
                  <a:ext cx="45360" cy="93960"/>
                </a:xfrm>
                <a:prstGeom prst="triangle">
                  <a:avLst>
                    <a:gd name="adj" fmla="val 50000"/>
                  </a:avLst>
                </a:prstGeom>
                <a:solidFill>
                  <a:srgbClr val="0000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5480" bIns="-15480" anchor="ctr">
                  <a:noAutofit/>
                </a:bodyPr>
                <a:p>
                  <a:pPr algn="ctr">
                    <a:tabLst>
                      <a:tab algn="l" pos="0"/>
                      <a:tab algn="l" pos="331920"/>
                      <a:tab algn="l" pos="663480"/>
                      <a:tab algn="l" pos="995400"/>
                      <a:tab algn="l" pos="1327320"/>
                      <a:tab algn="l" pos="1658880"/>
                      <a:tab algn="l" pos="1990800"/>
                      <a:tab algn="l" pos="2322360"/>
                      <a:tab algn="l" pos="2654280"/>
                      <a:tab algn="l" pos="2986200"/>
                      <a:tab algn="l" pos="3317760"/>
                      <a:tab algn="l" pos="3649680"/>
                      <a:tab algn="l" pos="3981600"/>
                      <a:tab algn="l" pos="4313160"/>
                      <a:tab algn="l" pos="4645080"/>
                      <a:tab algn="l" pos="4976640"/>
                      <a:tab algn="l" pos="5308560"/>
                      <a:tab algn="l" pos="5640480"/>
                      <a:tab algn="l" pos="5972040"/>
                      <a:tab algn="l" pos="6303960"/>
                      <a:tab algn="l" pos="6635880"/>
                    </a:tabLst>
                  </a:pPr>
                  <a:endParaRPr b="0" lang="en-US" sz="13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6" name="Triangle isocèle 146"/>
                <p:cNvSpPr/>
                <p:nvPr/>
              </p:nvSpPr>
              <p:spPr>
                <a:xfrm rot="16200000">
                  <a:off x="3588480" y="6569280"/>
                  <a:ext cx="45360" cy="93960"/>
                </a:xfrm>
                <a:prstGeom prst="triangle">
                  <a:avLst>
                    <a:gd name="adj" fmla="val 50000"/>
                  </a:avLst>
                </a:prstGeom>
                <a:solidFill>
                  <a:srgbClr val="0000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5480" bIns="-15480" anchor="ctr">
                  <a:noAutofit/>
                </a:bodyPr>
                <a:p>
                  <a:pPr algn="ctr">
                    <a:tabLst>
                      <a:tab algn="l" pos="0"/>
                      <a:tab algn="l" pos="331920"/>
                      <a:tab algn="l" pos="663480"/>
                      <a:tab algn="l" pos="995400"/>
                      <a:tab algn="l" pos="1327320"/>
                      <a:tab algn="l" pos="1658880"/>
                      <a:tab algn="l" pos="1990800"/>
                      <a:tab algn="l" pos="2322360"/>
                      <a:tab algn="l" pos="2654280"/>
                      <a:tab algn="l" pos="2986200"/>
                      <a:tab algn="l" pos="3317760"/>
                      <a:tab algn="l" pos="3649680"/>
                      <a:tab algn="l" pos="3981600"/>
                      <a:tab algn="l" pos="4313160"/>
                      <a:tab algn="l" pos="4645080"/>
                      <a:tab algn="l" pos="4976640"/>
                      <a:tab algn="l" pos="5308560"/>
                      <a:tab algn="l" pos="5640480"/>
                      <a:tab algn="l" pos="5972040"/>
                      <a:tab algn="l" pos="6303960"/>
                      <a:tab algn="l" pos="6635880"/>
                    </a:tabLst>
                  </a:pPr>
                  <a:endParaRPr b="0" lang="en-US" sz="13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7" name="Triangle isocèle 147"/>
                <p:cNvSpPr/>
                <p:nvPr/>
              </p:nvSpPr>
              <p:spPr>
                <a:xfrm rot="16200000">
                  <a:off x="3588480" y="6677280"/>
                  <a:ext cx="45360" cy="93960"/>
                </a:xfrm>
                <a:prstGeom prst="triangle">
                  <a:avLst>
                    <a:gd name="adj" fmla="val 50000"/>
                  </a:avLst>
                </a:prstGeom>
                <a:solidFill>
                  <a:srgbClr val="0000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5480" bIns="-15480" anchor="ctr">
                  <a:noAutofit/>
                </a:bodyPr>
                <a:p>
                  <a:pPr algn="ctr">
                    <a:tabLst>
                      <a:tab algn="l" pos="0"/>
                      <a:tab algn="l" pos="331920"/>
                      <a:tab algn="l" pos="663480"/>
                      <a:tab algn="l" pos="995400"/>
                      <a:tab algn="l" pos="1327320"/>
                      <a:tab algn="l" pos="1658880"/>
                      <a:tab algn="l" pos="1990800"/>
                      <a:tab algn="l" pos="2322360"/>
                      <a:tab algn="l" pos="2654280"/>
                      <a:tab algn="l" pos="2986200"/>
                      <a:tab algn="l" pos="3317760"/>
                      <a:tab algn="l" pos="3649680"/>
                      <a:tab algn="l" pos="3981600"/>
                      <a:tab algn="l" pos="4313160"/>
                      <a:tab algn="l" pos="4645080"/>
                      <a:tab algn="l" pos="4976640"/>
                      <a:tab algn="l" pos="5308560"/>
                      <a:tab algn="l" pos="5640480"/>
                      <a:tab algn="l" pos="5972040"/>
                      <a:tab algn="l" pos="6303960"/>
                      <a:tab algn="l" pos="6635880"/>
                    </a:tabLst>
                  </a:pPr>
                  <a:endParaRPr b="0" lang="en-US" sz="13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8" name="ZoneTexte 148"/>
                <p:cNvSpPr/>
                <p:nvPr/>
              </p:nvSpPr>
              <p:spPr>
                <a:xfrm>
                  <a:off x="3609360" y="6610320"/>
                  <a:ext cx="52812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331920"/>
                      <a:tab algn="l" pos="663480"/>
                      <a:tab algn="l" pos="995400"/>
                      <a:tab algn="l" pos="1327320"/>
                      <a:tab algn="l" pos="1658880"/>
                      <a:tab algn="l" pos="1990800"/>
                      <a:tab algn="l" pos="2322360"/>
                      <a:tab algn="l" pos="2654280"/>
                      <a:tab algn="l" pos="2986200"/>
                      <a:tab algn="l" pos="3317760"/>
                      <a:tab algn="l" pos="3649680"/>
                      <a:tab algn="l" pos="3981600"/>
                      <a:tab algn="l" pos="4313160"/>
                      <a:tab algn="l" pos="4645080"/>
                      <a:tab algn="l" pos="4976640"/>
                      <a:tab algn="l" pos="5308560"/>
                      <a:tab algn="l" pos="5640480"/>
                      <a:tab algn="l" pos="5972040"/>
                      <a:tab algn="l" pos="6303960"/>
                      <a:tab algn="l" pos="6635880"/>
                    </a:tabLst>
                  </a:pPr>
                  <a:r>
                    <a:rPr b="1" lang="fr-FR" sz="12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ClpP</a:t>
                  </a:r>
                  <a:endParaRPr b="0" lang="en-US" sz="12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9" name="ZoneTexte 149"/>
                <p:cNvSpPr/>
                <p:nvPr/>
              </p:nvSpPr>
              <p:spPr>
                <a:xfrm>
                  <a:off x="3606840" y="6462720"/>
                  <a:ext cx="85140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331920"/>
                      <a:tab algn="l" pos="663480"/>
                      <a:tab algn="l" pos="995400"/>
                      <a:tab algn="l" pos="1327320"/>
                      <a:tab algn="l" pos="1658880"/>
                      <a:tab algn="l" pos="1990800"/>
                      <a:tab algn="l" pos="2322360"/>
                      <a:tab algn="l" pos="2654280"/>
                      <a:tab algn="l" pos="2986200"/>
                      <a:tab algn="l" pos="3317760"/>
                      <a:tab algn="l" pos="3649680"/>
                      <a:tab algn="l" pos="3981600"/>
                      <a:tab algn="l" pos="4313160"/>
                      <a:tab algn="l" pos="4645080"/>
                      <a:tab algn="l" pos="4976640"/>
                      <a:tab algn="l" pos="5308560"/>
                      <a:tab algn="l" pos="5640480"/>
                      <a:tab algn="l" pos="5972040"/>
                      <a:tab algn="l" pos="6303960"/>
                      <a:tab algn="l" pos="663588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ClpP1His</a:t>
                  </a:r>
                  <a:endParaRPr b="0" lang="en-US" sz="12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0" name="ZoneTexte 150"/>
                <p:cNvSpPr/>
                <p:nvPr/>
              </p:nvSpPr>
              <p:spPr>
                <a:xfrm>
                  <a:off x="3601080" y="6327720"/>
                  <a:ext cx="85140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331920"/>
                      <a:tab algn="l" pos="663480"/>
                      <a:tab algn="l" pos="995400"/>
                      <a:tab algn="l" pos="1327320"/>
                      <a:tab algn="l" pos="1658880"/>
                      <a:tab algn="l" pos="1990800"/>
                      <a:tab algn="l" pos="2322360"/>
                      <a:tab algn="l" pos="2654280"/>
                      <a:tab algn="l" pos="2986200"/>
                      <a:tab algn="l" pos="3317760"/>
                      <a:tab algn="l" pos="3649680"/>
                      <a:tab algn="l" pos="3981600"/>
                      <a:tab algn="l" pos="4313160"/>
                      <a:tab algn="l" pos="4645080"/>
                      <a:tab algn="l" pos="4976640"/>
                      <a:tab algn="l" pos="5308560"/>
                      <a:tab algn="l" pos="5640480"/>
                      <a:tab algn="l" pos="5972040"/>
                      <a:tab algn="l" pos="6303960"/>
                      <a:tab algn="l" pos="663588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ClpP2His</a:t>
                  </a:r>
                  <a:endParaRPr b="0" lang="en-US" sz="12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1" name="Parenthèse ouvrante 151"/>
                <p:cNvSpPr/>
                <p:nvPr/>
              </p:nvSpPr>
              <p:spPr>
                <a:xfrm rot="5400000">
                  <a:off x="2250000" y="4757400"/>
                  <a:ext cx="158400" cy="2354400"/>
                </a:xfrm>
                <a:custGeom>
                  <a:avLst/>
                  <a:gdLst>
                    <a:gd name="textAreaLeft" fmla="*/ 46440 w 158400"/>
                    <a:gd name="textAreaRight" fmla="*/ 158760 w 158400"/>
                    <a:gd name="textAreaTop" fmla="*/ 6480 h 2354400"/>
                    <a:gd name="textAreaBottom" fmla="*/ 2347920 h 235440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21600" y="0"/>
                      </a:moveTo>
                      <a:cubicBezTo>
                        <a:pt x="10800" y="0"/>
                        <a:pt x="0" y="61"/>
                        <a:pt x="0" y="121"/>
                      </a:cubicBezTo>
                      <a:lnTo>
                        <a:pt x="0" y="21479"/>
                      </a:lnTo>
                      <a:cubicBezTo>
                        <a:pt x="0" y="21540"/>
                        <a:pt x="10800" y="21600"/>
                        <a:pt x="21600" y="21600"/>
                      </a:cubicBezTo>
                    </a:path>
                  </a:pathLst>
                </a:custGeom>
                <a:noFill/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tabLst>
                      <a:tab algn="l" pos="0"/>
                      <a:tab algn="l" pos="331920"/>
                      <a:tab algn="l" pos="663480"/>
                      <a:tab algn="l" pos="995400"/>
                      <a:tab algn="l" pos="1327320"/>
                      <a:tab algn="l" pos="1658880"/>
                      <a:tab algn="l" pos="1990800"/>
                      <a:tab algn="l" pos="2322360"/>
                      <a:tab algn="l" pos="2654280"/>
                      <a:tab algn="l" pos="2986200"/>
                      <a:tab algn="l" pos="3317760"/>
                      <a:tab algn="l" pos="3649680"/>
                      <a:tab algn="l" pos="3981600"/>
                      <a:tab algn="l" pos="4313160"/>
                      <a:tab algn="l" pos="4645080"/>
                      <a:tab algn="l" pos="4976640"/>
                      <a:tab algn="l" pos="5308560"/>
                      <a:tab algn="l" pos="5640480"/>
                      <a:tab algn="l" pos="5972040"/>
                      <a:tab algn="l" pos="6303960"/>
                      <a:tab algn="l" pos="6635880"/>
                    </a:tabLst>
                  </a:pPr>
                  <a:endParaRPr b="0" lang="en-US" sz="13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sp>
            <p:nvSpPr>
              <p:cNvPr id="62" name="ZoneTexte 130"/>
              <p:cNvSpPr/>
              <p:nvPr/>
            </p:nvSpPr>
            <p:spPr>
              <a:xfrm>
                <a:off x="1910880" y="5573880"/>
                <a:ext cx="78408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331920"/>
                    <a:tab algn="l" pos="663480"/>
                    <a:tab algn="l" pos="995400"/>
                    <a:tab algn="l" pos="1327320"/>
                    <a:tab algn="l" pos="1658880"/>
                    <a:tab algn="l" pos="1990800"/>
                    <a:tab algn="l" pos="2322360"/>
                    <a:tab algn="l" pos="2654280"/>
                    <a:tab algn="l" pos="2986200"/>
                    <a:tab algn="l" pos="3317760"/>
                    <a:tab algn="l" pos="3649680"/>
                    <a:tab algn="l" pos="3981600"/>
                    <a:tab algn="l" pos="4313160"/>
                    <a:tab algn="l" pos="4645080"/>
                    <a:tab algn="l" pos="4976640"/>
                    <a:tab algn="l" pos="5308560"/>
                    <a:tab algn="l" pos="5640480"/>
                    <a:tab algn="l" pos="5972040"/>
                    <a:tab algn="l" pos="6303960"/>
                    <a:tab algn="l" pos="663588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Elution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63" name="ZoneTexte 94"/>
            <p:cNvSpPr/>
            <p:nvPr/>
          </p:nvSpPr>
          <p:spPr>
            <a:xfrm>
              <a:off x="82800" y="5982480"/>
              <a:ext cx="497880" cy="550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331920"/>
                  <a:tab algn="l" pos="663480"/>
                  <a:tab algn="l" pos="995400"/>
                  <a:tab algn="l" pos="1327320"/>
                  <a:tab algn="l" pos="1658880"/>
                  <a:tab algn="l" pos="1990800"/>
                  <a:tab algn="l" pos="2322360"/>
                  <a:tab algn="l" pos="2654280"/>
                  <a:tab algn="l" pos="2986200"/>
                  <a:tab algn="l" pos="3317760"/>
                  <a:tab algn="l" pos="3649680"/>
                  <a:tab algn="l" pos="3981600"/>
                  <a:tab algn="l" pos="4313160"/>
                  <a:tab algn="l" pos="4645080"/>
                  <a:tab algn="l" pos="4976640"/>
                  <a:tab algn="l" pos="5308560"/>
                  <a:tab algn="l" pos="5640480"/>
                  <a:tab algn="l" pos="5972040"/>
                  <a:tab algn="l" pos="6303960"/>
                  <a:tab algn="l" pos="6635880"/>
                </a:tabLst>
              </a:pPr>
              <a:r>
                <a:rPr b="1" lang="fr-F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MW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331920"/>
                  <a:tab algn="l" pos="663480"/>
                  <a:tab algn="l" pos="995400"/>
                  <a:tab algn="l" pos="1327320"/>
                  <a:tab algn="l" pos="1658880"/>
                  <a:tab algn="l" pos="1990800"/>
                  <a:tab algn="l" pos="2322360"/>
                  <a:tab algn="l" pos="2654280"/>
                  <a:tab algn="l" pos="2986200"/>
                  <a:tab algn="l" pos="3317760"/>
                  <a:tab algn="l" pos="3649680"/>
                  <a:tab algn="l" pos="3981600"/>
                  <a:tab algn="l" pos="4313160"/>
                  <a:tab algn="l" pos="4645080"/>
                  <a:tab algn="l" pos="4976640"/>
                  <a:tab algn="l" pos="5308560"/>
                  <a:tab algn="l" pos="5640480"/>
                  <a:tab algn="l" pos="5972040"/>
                  <a:tab algn="l" pos="6303960"/>
                  <a:tab algn="l" pos="6635880"/>
                </a:tabLst>
              </a:pPr>
              <a:r>
                <a:rPr b="1" lang="fr-F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(kDa)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331920"/>
                  <a:tab algn="l" pos="663480"/>
                  <a:tab algn="l" pos="995400"/>
                  <a:tab algn="l" pos="1327320"/>
                  <a:tab algn="l" pos="1658880"/>
                  <a:tab algn="l" pos="1990800"/>
                  <a:tab algn="l" pos="2322360"/>
                  <a:tab algn="l" pos="2654280"/>
                  <a:tab algn="l" pos="2986200"/>
                  <a:tab algn="l" pos="3317760"/>
                  <a:tab algn="l" pos="3649680"/>
                  <a:tab algn="l" pos="3981600"/>
                  <a:tab algn="l" pos="4313160"/>
                  <a:tab algn="l" pos="4645080"/>
                  <a:tab algn="l" pos="4976640"/>
                  <a:tab algn="l" pos="5308560"/>
                  <a:tab algn="l" pos="5640480"/>
                  <a:tab algn="l" pos="5972040"/>
                  <a:tab algn="l" pos="6303960"/>
                  <a:tab algn="l" pos="663588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64" name="Grouper 112"/>
          <p:cNvGrpSpPr/>
          <p:nvPr/>
        </p:nvGrpSpPr>
        <p:grpSpPr>
          <a:xfrm>
            <a:off x="101160" y="14400"/>
            <a:ext cx="4378680" cy="2725920"/>
            <a:chOff x="101160" y="14400"/>
            <a:chExt cx="4378680" cy="2725920"/>
          </a:xfrm>
        </p:grpSpPr>
        <p:grpSp>
          <p:nvGrpSpPr>
            <p:cNvPr id="65" name="Grouper 221"/>
            <p:cNvGrpSpPr/>
            <p:nvPr/>
          </p:nvGrpSpPr>
          <p:grpSpPr>
            <a:xfrm>
              <a:off x="164520" y="14400"/>
              <a:ext cx="4315320" cy="2725920"/>
              <a:chOff x="164520" y="14400"/>
              <a:chExt cx="4315320" cy="2725920"/>
            </a:xfrm>
          </p:grpSpPr>
          <p:sp>
            <p:nvSpPr>
              <p:cNvPr id="66" name="ZoneTexte 127"/>
              <p:cNvSpPr/>
              <p:nvPr/>
            </p:nvSpPr>
            <p:spPr>
              <a:xfrm>
                <a:off x="164520" y="883440"/>
                <a:ext cx="46872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331920"/>
                    <a:tab algn="l" pos="663480"/>
                    <a:tab algn="l" pos="995400"/>
                    <a:tab algn="l" pos="1327320"/>
                    <a:tab algn="l" pos="1658880"/>
                    <a:tab algn="l" pos="1990800"/>
                    <a:tab algn="l" pos="2322360"/>
                    <a:tab algn="l" pos="2654280"/>
                    <a:tab algn="l" pos="2986200"/>
                    <a:tab algn="l" pos="3317760"/>
                    <a:tab algn="l" pos="3649680"/>
                    <a:tab algn="l" pos="3981600"/>
                    <a:tab algn="l" pos="4313160"/>
                    <a:tab algn="l" pos="4645080"/>
                    <a:tab algn="l" pos="4976640"/>
                    <a:tab algn="l" pos="5308560"/>
                    <a:tab algn="l" pos="5640480"/>
                    <a:tab algn="l" pos="5972040"/>
                    <a:tab algn="l" pos="6303960"/>
                    <a:tab algn="l" pos="663588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00.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grpSp>
            <p:nvGrpSpPr>
              <p:cNvPr id="67" name="Grouper 120"/>
              <p:cNvGrpSpPr/>
              <p:nvPr/>
            </p:nvGrpSpPr>
            <p:grpSpPr>
              <a:xfrm>
                <a:off x="164520" y="14400"/>
                <a:ext cx="4315320" cy="2725920"/>
                <a:chOff x="164520" y="14400"/>
                <a:chExt cx="4315320" cy="2725920"/>
              </a:xfrm>
            </p:grpSpPr>
            <p:sp>
              <p:nvSpPr>
                <p:cNvPr id="68" name="ZoneTexte 186"/>
                <p:cNvSpPr/>
                <p:nvPr/>
              </p:nvSpPr>
              <p:spPr>
                <a:xfrm>
                  <a:off x="164520" y="788400"/>
                  <a:ext cx="468720" cy="231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331920"/>
                      <a:tab algn="l" pos="663480"/>
                      <a:tab algn="l" pos="995400"/>
                      <a:tab algn="l" pos="1327320"/>
                      <a:tab algn="l" pos="1658880"/>
                      <a:tab algn="l" pos="1990800"/>
                      <a:tab algn="l" pos="2322360"/>
                      <a:tab algn="l" pos="2654280"/>
                      <a:tab algn="l" pos="2986200"/>
                      <a:tab algn="l" pos="3317760"/>
                      <a:tab algn="l" pos="3649680"/>
                      <a:tab algn="l" pos="3981600"/>
                      <a:tab algn="l" pos="4313160"/>
                      <a:tab algn="l" pos="4645080"/>
                      <a:tab algn="l" pos="4976640"/>
                      <a:tab algn="l" pos="5308560"/>
                      <a:tab algn="l" pos="5640480"/>
                      <a:tab algn="l" pos="5972040"/>
                      <a:tab algn="l" pos="6303960"/>
                      <a:tab algn="l" pos="6635880"/>
                    </a:tabLst>
                  </a:pPr>
                  <a:r>
                    <a:rPr b="1" lang="en-US" sz="9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140.0</a:t>
                  </a:r>
                  <a:endParaRPr b="0" lang="en-US" sz="9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grpSp>
              <p:nvGrpSpPr>
                <p:cNvPr id="69" name="Grouper 119"/>
                <p:cNvGrpSpPr/>
                <p:nvPr/>
              </p:nvGrpSpPr>
              <p:grpSpPr>
                <a:xfrm>
                  <a:off x="222120" y="14400"/>
                  <a:ext cx="4257720" cy="2725920"/>
                  <a:chOff x="222120" y="14400"/>
                  <a:chExt cx="4257720" cy="2725920"/>
                </a:xfrm>
              </p:grpSpPr>
              <p:pic>
                <p:nvPicPr>
                  <p:cNvPr id="70" name="Image 4" descr=""/>
                  <p:cNvPicPr/>
                  <p:nvPr/>
                </p:nvPicPr>
                <p:blipFill>
                  <a:blip r:embed="rId2">
                    <a:grayscl/>
                  </a:blip>
                  <a:stretch/>
                </p:blipFill>
                <p:spPr>
                  <a:xfrm>
                    <a:off x="680040" y="763560"/>
                    <a:ext cx="2882160" cy="1923120"/>
                  </a:xfrm>
                  <a:prstGeom prst="rect">
                    <a:avLst/>
                  </a:prstGeom>
                  <a:ln w="19080">
                    <a:solidFill>
                      <a:srgbClr val="000000"/>
                    </a:solidFill>
                    <a:miter/>
                  </a:ln>
                </p:spPr>
              </p:pic>
              <p:sp>
                <p:nvSpPr>
                  <p:cNvPr id="71" name="Connecteur droit 6"/>
                  <p:cNvSpPr/>
                  <p:nvPr/>
                </p:nvSpPr>
                <p:spPr>
                  <a:xfrm>
                    <a:off x="583920" y="901080"/>
                    <a:ext cx="96120" cy="1440"/>
                  </a:xfrm>
                  <a:prstGeom prst="line">
                    <a:avLst/>
                  </a:prstGeom>
                  <a:ln w="190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13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2" name="Connecteur droit 190"/>
                  <p:cNvSpPr/>
                  <p:nvPr/>
                </p:nvSpPr>
                <p:spPr>
                  <a:xfrm>
                    <a:off x="583920" y="1117080"/>
                    <a:ext cx="96120" cy="1440"/>
                  </a:xfrm>
                  <a:prstGeom prst="line">
                    <a:avLst/>
                  </a:prstGeom>
                  <a:ln w="190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13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3" name="Connecteur droit 191"/>
                  <p:cNvSpPr/>
                  <p:nvPr/>
                </p:nvSpPr>
                <p:spPr>
                  <a:xfrm>
                    <a:off x="583920" y="1377360"/>
                    <a:ext cx="96120" cy="1440"/>
                  </a:xfrm>
                  <a:prstGeom prst="line">
                    <a:avLst/>
                  </a:prstGeom>
                  <a:ln w="190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13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4" name="Connecteur droit 192"/>
                  <p:cNvSpPr/>
                  <p:nvPr/>
                </p:nvSpPr>
                <p:spPr>
                  <a:xfrm>
                    <a:off x="583920" y="1510560"/>
                    <a:ext cx="96120" cy="1440"/>
                  </a:xfrm>
                  <a:prstGeom prst="line">
                    <a:avLst/>
                  </a:prstGeom>
                  <a:ln w="190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13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5" name="Connecteur droit 193"/>
                  <p:cNvSpPr/>
                  <p:nvPr/>
                </p:nvSpPr>
                <p:spPr>
                  <a:xfrm>
                    <a:off x="583920" y="1733040"/>
                    <a:ext cx="96120" cy="1440"/>
                  </a:xfrm>
                  <a:prstGeom prst="line">
                    <a:avLst/>
                  </a:prstGeom>
                  <a:ln w="190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13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6" name="Connecteur droit 194"/>
                  <p:cNvSpPr/>
                  <p:nvPr/>
                </p:nvSpPr>
                <p:spPr>
                  <a:xfrm>
                    <a:off x="583920" y="1009080"/>
                    <a:ext cx="96120" cy="1440"/>
                  </a:xfrm>
                  <a:prstGeom prst="line">
                    <a:avLst/>
                  </a:prstGeom>
                  <a:ln w="190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13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7" name="ZoneTexte 195"/>
                  <p:cNvSpPr/>
                  <p:nvPr/>
                </p:nvSpPr>
                <p:spPr>
                  <a:xfrm>
                    <a:off x="228240" y="997920"/>
                    <a:ext cx="404640" cy="2311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331920"/>
                        <a:tab algn="l" pos="663480"/>
                        <a:tab algn="l" pos="995400"/>
                        <a:tab algn="l" pos="1327320"/>
                        <a:tab algn="l" pos="1658880"/>
                        <a:tab algn="l" pos="1990800"/>
                        <a:tab algn="l" pos="2322360"/>
                        <a:tab algn="l" pos="2654280"/>
                        <a:tab algn="l" pos="2986200"/>
                        <a:tab algn="l" pos="3317760"/>
                        <a:tab algn="l" pos="3649680"/>
                        <a:tab algn="l" pos="3981600"/>
                        <a:tab algn="l" pos="4313160"/>
                        <a:tab algn="l" pos="4645080"/>
                        <a:tab algn="l" pos="4976640"/>
                        <a:tab algn="l" pos="5308560"/>
                        <a:tab algn="l" pos="5640480"/>
                        <a:tab algn="l" pos="5972040"/>
                        <a:tab algn="l" pos="6303960"/>
                        <a:tab algn="l" pos="6635880"/>
                      </a:tabLst>
                    </a:pPr>
                    <a:r>
                      <a:rPr b="1" lang="en-US" sz="9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70.0</a:t>
                    </a:r>
                    <a:endParaRPr b="0" lang="en-US" sz="9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8" name="ZoneTexte 196"/>
                  <p:cNvSpPr/>
                  <p:nvPr/>
                </p:nvSpPr>
                <p:spPr>
                  <a:xfrm>
                    <a:off x="228240" y="1264680"/>
                    <a:ext cx="404640" cy="2311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331920"/>
                        <a:tab algn="l" pos="663480"/>
                        <a:tab algn="l" pos="995400"/>
                        <a:tab algn="l" pos="1327320"/>
                        <a:tab algn="l" pos="1658880"/>
                        <a:tab algn="l" pos="1990800"/>
                        <a:tab algn="l" pos="2322360"/>
                        <a:tab algn="l" pos="2654280"/>
                        <a:tab algn="l" pos="2986200"/>
                        <a:tab algn="l" pos="3317760"/>
                        <a:tab algn="l" pos="3649680"/>
                        <a:tab algn="l" pos="3981600"/>
                        <a:tab algn="l" pos="4313160"/>
                        <a:tab algn="l" pos="4645080"/>
                        <a:tab algn="l" pos="4976640"/>
                        <a:tab algn="l" pos="5308560"/>
                        <a:tab algn="l" pos="5640480"/>
                        <a:tab algn="l" pos="5972040"/>
                        <a:tab algn="l" pos="6303960"/>
                        <a:tab algn="l" pos="6635880"/>
                      </a:tabLst>
                    </a:pPr>
                    <a:r>
                      <a:rPr b="1" lang="en-US" sz="9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50.0</a:t>
                    </a:r>
                    <a:endParaRPr b="0" lang="en-US" sz="9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9" name="ZoneTexte 197"/>
                  <p:cNvSpPr/>
                  <p:nvPr/>
                </p:nvSpPr>
                <p:spPr>
                  <a:xfrm>
                    <a:off x="228240" y="1397880"/>
                    <a:ext cx="404640" cy="2311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331920"/>
                        <a:tab algn="l" pos="663480"/>
                        <a:tab algn="l" pos="995400"/>
                        <a:tab algn="l" pos="1327320"/>
                        <a:tab algn="l" pos="1658880"/>
                        <a:tab algn="l" pos="1990800"/>
                        <a:tab algn="l" pos="2322360"/>
                        <a:tab algn="l" pos="2654280"/>
                        <a:tab algn="l" pos="2986200"/>
                        <a:tab algn="l" pos="3317760"/>
                        <a:tab algn="l" pos="3649680"/>
                        <a:tab algn="l" pos="3981600"/>
                        <a:tab algn="l" pos="4313160"/>
                        <a:tab algn="l" pos="4645080"/>
                        <a:tab algn="l" pos="4976640"/>
                        <a:tab algn="l" pos="5308560"/>
                        <a:tab algn="l" pos="5640480"/>
                        <a:tab algn="l" pos="5972040"/>
                        <a:tab algn="l" pos="6303960"/>
                        <a:tab algn="l" pos="6635880"/>
                      </a:tabLst>
                    </a:pPr>
                    <a:r>
                      <a:rPr b="1" lang="en-US" sz="9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40.0</a:t>
                    </a:r>
                    <a:endParaRPr b="0" lang="en-US" sz="9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0" name="ZoneTexte 198"/>
                  <p:cNvSpPr/>
                  <p:nvPr/>
                </p:nvSpPr>
                <p:spPr>
                  <a:xfrm>
                    <a:off x="228240" y="1607400"/>
                    <a:ext cx="404640" cy="2311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331920"/>
                        <a:tab algn="l" pos="663480"/>
                        <a:tab algn="l" pos="995400"/>
                        <a:tab algn="l" pos="1327320"/>
                        <a:tab algn="l" pos="1658880"/>
                        <a:tab algn="l" pos="1990800"/>
                        <a:tab algn="l" pos="2322360"/>
                        <a:tab algn="l" pos="2654280"/>
                        <a:tab algn="l" pos="2986200"/>
                        <a:tab algn="l" pos="3317760"/>
                        <a:tab algn="l" pos="3649680"/>
                        <a:tab algn="l" pos="3981600"/>
                        <a:tab algn="l" pos="4313160"/>
                        <a:tab algn="l" pos="4645080"/>
                        <a:tab algn="l" pos="4976640"/>
                        <a:tab algn="l" pos="5308560"/>
                        <a:tab algn="l" pos="5640480"/>
                        <a:tab algn="l" pos="5972040"/>
                        <a:tab algn="l" pos="6303960"/>
                        <a:tab algn="l" pos="6635880"/>
                      </a:tabLst>
                    </a:pPr>
                    <a:r>
                      <a:rPr b="1" lang="en-US" sz="9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35.0</a:t>
                    </a:r>
                    <a:endParaRPr b="0" lang="en-US" sz="9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1" name="Connecteur droit 199"/>
                  <p:cNvSpPr/>
                  <p:nvPr/>
                </p:nvSpPr>
                <p:spPr>
                  <a:xfrm>
                    <a:off x="577440" y="2001600"/>
                    <a:ext cx="96120" cy="1440"/>
                  </a:xfrm>
                  <a:prstGeom prst="line">
                    <a:avLst/>
                  </a:prstGeom>
                  <a:ln w="190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13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2" name="ZoneTexte 200"/>
                  <p:cNvSpPr/>
                  <p:nvPr/>
                </p:nvSpPr>
                <p:spPr>
                  <a:xfrm>
                    <a:off x="228240" y="1887120"/>
                    <a:ext cx="404640" cy="2311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331920"/>
                        <a:tab algn="l" pos="663480"/>
                        <a:tab algn="l" pos="995400"/>
                        <a:tab algn="l" pos="1327320"/>
                        <a:tab algn="l" pos="1658880"/>
                        <a:tab algn="l" pos="1990800"/>
                        <a:tab algn="l" pos="2322360"/>
                        <a:tab algn="l" pos="2654280"/>
                        <a:tab algn="l" pos="2986200"/>
                        <a:tab algn="l" pos="3317760"/>
                        <a:tab algn="l" pos="3649680"/>
                        <a:tab algn="l" pos="3981600"/>
                        <a:tab algn="l" pos="4313160"/>
                        <a:tab algn="l" pos="4645080"/>
                        <a:tab algn="l" pos="4976640"/>
                        <a:tab algn="l" pos="5308560"/>
                        <a:tab algn="l" pos="5640480"/>
                        <a:tab algn="l" pos="5972040"/>
                        <a:tab algn="l" pos="6303960"/>
                        <a:tab algn="l" pos="6635880"/>
                      </a:tabLst>
                    </a:pPr>
                    <a:r>
                      <a:rPr b="1" lang="en-US" sz="9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25.0</a:t>
                    </a:r>
                    <a:endParaRPr b="0" lang="en-US" sz="9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3" name="Connecteur droit 201"/>
                  <p:cNvSpPr/>
                  <p:nvPr/>
                </p:nvSpPr>
                <p:spPr>
                  <a:xfrm>
                    <a:off x="577440" y="2624040"/>
                    <a:ext cx="96120" cy="1440"/>
                  </a:xfrm>
                  <a:prstGeom prst="line">
                    <a:avLst/>
                  </a:prstGeom>
                  <a:ln w="190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13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4" name="ZoneTexte 202"/>
                  <p:cNvSpPr/>
                  <p:nvPr/>
                </p:nvSpPr>
                <p:spPr>
                  <a:xfrm>
                    <a:off x="222120" y="2509200"/>
                    <a:ext cx="404640" cy="2311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331920"/>
                        <a:tab algn="l" pos="663480"/>
                        <a:tab algn="l" pos="995400"/>
                        <a:tab algn="l" pos="1327320"/>
                        <a:tab algn="l" pos="1658880"/>
                        <a:tab algn="l" pos="1990800"/>
                        <a:tab algn="l" pos="2322360"/>
                        <a:tab algn="l" pos="2654280"/>
                        <a:tab algn="l" pos="2986200"/>
                        <a:tab algn="l" pos="3317760"/>
                        <a:tab algn="l" pos="3649680"/>
                        <a:tab algn="l" pos="3981600"/>
                        <a:tab algn="l" pos="4313160"/>
                        <a:tab algn="l" pos="4645080"/>
                        <a:tab algn="l" pos="4976640"/>
                        <a:tab algn="l" pos="5308560"/>
                        <a:tab algn="l" pos="5640480"/>
                        <a:tab algn="l" pos="5972040"/>
                        <a:tab algn="l" pos="6303960"/>
                        <a:tab algn="l" pos="6635880"/>
                      </a:tabLst>
                    </a:pPr>
                    <a:r>
                      <a:rPr b="1" lang="en-US" sz="9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15.0</a:t>
                    </a:r>
                    <a:endParaRPr b="0" lang="en-US" sz="9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grpSp>
                <p:nvGrpSpPr>
                  <p:cNvPr id="85" name="Grouper 34"/>
                  <p:cNvGrpSpPr/>
                  <p:nvPr/>
                </p:nvGrpSpPr>
                <p:grpSpPr>
                  <a:xfrm>
                    <a:off x="3612960" y="2121480"/>
                    <a:ext cx="541440" cy="276480"/>
                    <a:chOff x="3612960" y="2121480"/>
                    <a:chExt cx="541440" cy="276480"/>
                  </a:xfrm>
                </p:grpSpPr>
                <p:sp>
                  <p:nvSpPr>
                    <p:cNvPr id="86" name="Triangle isocèle 218"/>
                    <p:cNvSpPr/>
                    <p:nvPr/>
                  </p:nvSpPr>
                  <p:spPr>
                    <a:xfrm rot="16200000">
                      <a:off x="3621960" y="2225160"/>
                      <a:ext cx="50040" cy="68400"/>
                    </a:xfrm>
                    <a:prstGeom prst="triangle">
                      <a:avLst>
                        <a:gd name="adj" fmla="val 50000"/>
                      </a:avLst>
                    </a:prstGeom>
                    <a:solidFill>
                      <a:srgbClr val="000000"/>
                    </a:solidFill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23760" bIns="-2376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331920"/>
                          <a:tab algn="l" pos="663480"/>
                          <a:tab algn="l" pos="995400"/>
                          <a:tab algn="l" pos="1327320"/>
                          <a:tab algn="l" pos="1658880"/>
                          <a:tab algn="l" pos="1990800"/>
                          <a:tab algn="l" pos="2322360"/>
                          <a:tab algn="l" pos="2654280"/>
                          <a:tab algn="l" pos="2986200"/>
                          <a:tab algn="l" pos="3317760"/>
                          <a:tab algn="l" pos="3649680"/>
                          <a:tab algn="l" pos="3981600"/>
                          <a:tab algn="l" pos="4313160"/>
                          <a:tab algn="l" pos="4645080"/>
                          <a:tab algn="l" pos="4976640"/>
                          <a:tab algn="l" pos="5308560"/>
                          <a:tab algn="l" pos="5640480"/>
                          <a:tab algn="l" pos="5972040"/>
                          <a:tab algn="l" pos="6303960"/>
                          <a:tab algn="l" pos="6635880"/>
                        </a:tabLst>
                      </a:pPr>
                      <a:endParaRPr b="0" lang="en-US" sz="13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  <p:sp>
                  <p:nvSpPr>
                    <p:cNvPr id="87" name="ZoneTexte 219"/>
                    <p:cNvSpPr/>
                    <p:nvPr/>
                  </p:nvSpPr>
                  <p:spPr>
                    <a:xfrm>
                      <a:off x="3626280" y="2121480"/>
                      <a:ext cx="528120" cy="2764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90000" rIns="90000" tIns="46800" bIns="4680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331920"/>
                          <a:tab algn="l" pos="663480"/>
                          <a:tab algn="l" pos="995400"/>
                          <a:tab algn="l" pos="1327320"/>
                          <a:tab algn="l" pos="1658880"/>
                          <a:tab algn="l" pos="1990800"/>
                          <a:tab algn="l" pos="2322360"/>
                          <a:tab algn="l" pos="2654280"/>
                          <a:tab algn="l" pos="2986200"/>
                          <a:tab algn="l" pos="3317760"/>
                          <a:tab algn="l" pos="3649680"/>
                          <a:tab algn="l" pos="3981600"/>
                          <a:tab algn="l" pos="4313160"/>
                          <a:tab algn="l" pos="4645080"/>
                          <a:tab algn="l" pos="4976640"/>
                          <a:tab algn="l" pos="5308560"/>
                          <a:tab algn="l" pos="5640480"/>
                          <a:tab algn="l" pos="5972040"/>
                          <a:tab algn="l" pos="6303960"/>
                          <a:tab algn="l" pos="6635880"/>
                        </a:tabLst>
                      </a:pPr>
                      <a:r>
                        <a:rPr b="1" lang="fr-FR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lpP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</p:grpSp>
              <p:grpSp>
                <p:nvGrpSpPr>
                  <p:cNvPr id="88" name="Grouper 33"/>
                  <p:cNvGrpSpPr/>
                  <p:nvPr/>
                </p:nvGrpSpPr>
                <p:grpSpPr>
                  <a:xfrm>
                    <a:off x="3612960" y="1994400"/>
                    <a:ext cx="866880" cy="276480"/>
                    <a:chOff x="3612960" y="1994400"/>
                    <a:chExt cx="866880" cy="276480"/>
                  </a:xfrm>
                </p:grpSpPr>
                <p:sp>
                  <p:nvSpPr>
                    <p:cNvPr id="89" name="Triangle isocèle 216"/>
                    <p:cNvSpPr/>
                    <p:nvPr/>
                  </p:nvSpPr>
                  <p:spPr>
                    <a:xfrm rot="16200000">
                      <a:off x="3621960" y="2098080"/>
                      <a:ext cx="50040" cy="68400"/>
                    </a:xfrm>
                    <a:prstGeom prst="triangle">
                      <a:avLst>
                        <a:gd name="adj" fmla="val 50000"/>
                      </a:avLst>
                    </a:prstGeom>
                    <a:solidFill>
                      <a:srgbClr val="000000"/>
                    </a:solidFill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23760" bIns="-2376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331920"/>
                          <a:tab algn="l" pos="663480"/>
                          <a:tab algn="l" pos="995400"/>
                          <a:tab algn="l" pos="1327320"/>
                          <a:tab algn="l" pos="1658880"/>
                          <a:tab algn="l" pos="1990800"/>
                          <a:tab algn="l" pos="2322360"/>
                          <a:tab algn="l" pos="2654280"/>
                          <a:tab algn="l" pos="2986200"/>
                          <a:tab algn="l" pos="3317760"/>
                          <a:tab algn="l" pos="3649680"/>
                          <a:tab algn="l" pos="3981600"/>
                          <a:tab algn="l" pos="4313160"/>
                          <a:tab algn="l" pos="4645080"/>
                          <a:tab algn="l" pos="4976640"/>
                          <a:tab algn="l" pos="5308560"/>
                          <a:tab algn="l" pos="5640480"/>
                          <a:tab algn="l" pos="5972040"/>
                          <a:tab algn="l" pos="6303960"/>
                          <a:tab algn="l" pos="6635880"/>
                        </a:tabLst>
                      </a:pPr>
                      <a:endParaRPr b="0" lang="en-US" sz="13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  <p:sp>
                  <p:nvSpPr>
                    <p:cNvPr id="90" name="ZoneTexte 217"/>
                    <p:cNvSpPr/>
                    <p:nvPr/>
                  </p:nvSpPr>
                  <p:spPr>
                    <a:xfrm>
                      <a:off x="3628440" y="1994400"/>
                      <a:ext cx="851400" cy="2764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90000" rIns="90000" tIns="46800" bIns="4680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331920"/>
                          <a:tab algn="l" pos="663480"/>
                          <a:tab algn="l" pos="995400"/>
                          <a:tab algn="l" pos="1327320"/>
                          <a:tab algn="l" pos="1658880"/>
                          <a:tab algn="l" pos="1990800"/>
                          <a:tab algn="l" pos="2322360"/>
                          <a:tab algn="l" pos="2654280"/>
                          <a:tab algn="l" pos="2986200"/>
                          <a:tab algn="l" pos="3317760"/>
                          <a:tab algn="l" pos="3649680"/>
                          <a:tab algn="l" pos="3981600"/>
                          <a:tab algn="l" pos="4313160"/>
                          <a:tab algn="l" pos="4645080"/>
                          <a:tab algn="l" pos="4976640"/>
                          <a:tab algn="l" pos="5308560"/>
                          <a:tab algn="l" pos="5640480"/>
                          <a:tab algn="l" pos="5972040"/>
                          <a:tab algn="l" pos="6303960"/>
                          <a:tab algn="l" pos="663588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lpP1Hi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p:txBody>
                </p:sp>
              </p:grpSp>
              <p:sp>
                <p:nvSpPr>
                  <p:cNvPr id="91" name="ZoneTexte 205"/>
                  <p:cNvSpPr/>
                  <p:nvPr/>
                </p:nvSpPr>
                <p:spPr>
                  <a:xfrm>
                    <a:off x="667080" y="387720"/>
                    <a:ext cx="467280" cy="3682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331920"/>
                        <a:tab algn="l" pos="663480"/>
                        <a:tab algn="l" pos="995400"/>
                        <a:tab algn="l" pos="1327320"/>
                        <a:tab algn="l" pos="1658880"/>
                        <a:tab algn="l" pos="1990800"/>
                        <a:tab algn="l" pos="2322360"/>
                        <a:tab algn="l" pos="2654280"/>
                        <a:tab algn="l" pos="2986200"/>
                        <a:tab algn="l" pos="3317760"/>
                        <a:tab algn="l" pos="3649680"/>
                        <a:tab algn="l" pos="3981600"/>
                        <a:tab algn="l" pos="4313160"/>
                        <a:tab algn="l" pos="4645080"/>
                        <a:tab algn="l" pos="4976640"/>
                        <a:tab algn="l" pos="5308560"/>
                        <a:tab algn="l" pos="5640480"/>
                        <a:tab algn="l" pos="5972040"/>
                        <a:tab algn="l" pos="6303960"/>
                        <a:tab algn="l" pos="6635880"/>
                      </a:tabLst>
                    </a:pPr>
                    <a:r>
                      <a:rPr b="1" lang="fr-FR" sz="9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MW</a:t>
                    </a:r>
                    <a:endParaRPr b="0" lang="en-US" sz="9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331920"/>
                        <a:tab algn="l" pos="663480"/>
                        <a:tab algn="l" pos="995400"/>
                        <a:tab algn="l" pos="1327320"/>
                        <a:tab algn="l" pos="1658880"/>
                        <a:tab algn="l" pos="1990800"/>
                        <a:tab algn="l" pos="2322360"/>
                        <a:tab algn="l" pos="2654280"/>
                        <a:tab algn="l" pos="2986200"/>
                        <a:tab algn="l" pos="3317760"/>
                        <a:tab algn="l" pos="3649680"/>
                        <a:tab algn="l" pos="3981600"/>
                        <a:tab algn="l" pos="4313160"/>
                        <a:tab algn="l" pos="4645080"/>
                        <a:tab algn="l" pos="4976640"/>
                        <a:tab algn="l" pos="5308560"/>
                        <a:tab algn="l" pos="5640480"/>
                        <a:tab algn="l" pos="5972040"/>
                        <a:tab algn="l" pos="6303960"/>
                        <a:tab algn="l" pos="6635880"/>
                      </a:tabLst>
                    </a:pPr>
                    <a:r>
                      <a:rPr b="1" lang="fr-FR" sz="9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(kDa)</a:t>
                    </a:r>
                    <a:endParaRPr b="0" lang="en-US" sz="9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92" name="ZoneTexte 206"/>
                  <p:cNvSpPr/>
                  <p:nvPr/>
                </p:nvSpPr>
                <p:spPr>
                  <a:xfrm>
                    <a:off x="1068480" y="371160"/>
                    <a:ext cx="468720" cy="2462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331920"/>
                        <a:tab algn="l" pos="663480"/>
                        <a:tab algn="l" pos="995400"/>
                        <a:tab algn="l" pos="1327320"/>
                        <a:tab algn="l" pos="1658880"/>
                        <a:tab algn="l" pos="1990800"/>
                        <a:tab algn="l" pos="2322360"/>
                        <a:tab algn="l" pos="2654280"/>
                        <a:tab algn="l" pos="2986200"/>
                        <a:tab algn="l" pos="3317760"/>
                        <a:tab algn="l" pos="3649680"/>
                        <a:tab algn="l" pos="3981600"/>
                        <a:tab algn="l" pos="4313160"/>
                        <a:tab algn="l" pos="4645080"/>
                        <a:tab algn="l" pos="4976640"/>
                        <a:tab algn="l" pos="5308560"/>
                        <a:tab algn="l" pos="5640480"/>
                        <a:tab algn="l" pos="5972040"/>
                        <a:tab algn="l" pos="6303960"/>
                        <a:tab algn="l" pos="6635880"/>
                      </a:tabLst>
                    </a:pPr>
                    <a:r>
                      <a:rPr b="1" lang="fr-FR" sz="10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ClpP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93" name="ZoneTexte 207"/>
                  <p:cNvSpPr/>
                  <p:nvPr/>
                </p:nvSpPr>
                <p:spPr>
                  <a:xfrm>
                    <a:off x="1395000" y="371160"/>
                    <a:ext cx="538920" cy="2462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331920"/>
                        <a:tab algn="l" pos="663480"/>
                        <a:tab algn="l" pos="995400"/>
                        <a:tab algn="l" pos="1327320"/>
                        <a:tab algn="l" pos="1658880"/>
                        <a:tab algn="l" pos="1990800"/>
                        <a:tab algn="l" pos="2322360"/>
                        <a:tab algn="l" pos="2654280"/>
                        <a:tab algn="l" pos="2986200"/>
                        <a:tab algn="l" pos="3317760"/>
                        <a:tab algn="l" pos="3649680"/>
                        <a:tab algn="l" pos="3981600"/>
                        <a:tab algn="l" pos="4313160"/>
                        <a:tab algn="l" pos="4645080"/>
                        <a:tab algn="l" pos="4976640"/>
                        <a:tab algn="l" pos="5308560"/>
                        <a:tab algn="l" pos="5640480"/>
                        <a:tab algn="l" pos="5972040"/>
                        <a:tab algn="l" pos="6303960"/>
                        <a:tab algn="l" pos="6635880"/>
                      </a:tabLst>
                    </a:pPr>
                    <a:r>
                      <a:rPr b="1" lang="en-US" sz="10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ClpP1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94" name="ZoneTexte 208"/>
                  <p:cNvSpPr/>
                  <p:nvPr/>
                </p:nvSpPr>
                <p:spPr>
                  <a:xfrm>
                    <a:off x="1781640" y="217440"/>
                    <a:ext cx="538920" cy="3985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331920"/>
                        <a:tab algn="l" pos="663480"/>
                        <a:tab algn="l" pos="995400"/>
                        <a:tab algn="l" pos="1327320"/>
                        <a:tab algn="l" pos="1658880"/>
                        <a:tab algn="l" pos="1990800"/>
                        <a:tab algn="l" pos="2322360"/>
                        <a:tab algn="l" pos="2654280"/>
                        <a:tab algn="l" pos="2986200"/>
                        <a:tab algn="l" pos="3317760"/>
                        <a:tab algn="l" pos="3649680"/>
                        <a:tab algn="l" pos="3981600"/>
                        <a:tab algn="l" pos="4313160"/>
                        <a:tab algn="l" pos="4645080"/>
                        <a:tab algn="l" pos="4976640"/>
                        <a:tab algn="l" pos="5308560"/>
                        <a:tab algn="l" pos="5640480"/>
                        <a:tab algn="l" pos="5972040"/>
                        <a:tab algn="l" pos="6303960"/>
                        <a:tab algn="l" pos="6635880"/>
                      </a:tabLst>
                    </a:pPr>
                    <a:r>
                      <a:rPr b="1" lang="fr-FR" sz="10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ClpP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331920"/>
                        <a:tab algn="l" pos="663480"/>
                        <a:tab algn="l" pos="995400"/>
                        <a:tab algn="l" pos="1327320"/>
                        <a:tab algn="l" pos="1658880"/>
                        <a:tab algn="l" pos="1990800"/>
                        <a:tab algn="l" pos="2322360"/>
                        <a:tab algn="l" pos="2654280"/>
                        <a:tab algn="l" pos="2986200"/>
                        <a:tab algn="l" pos="3317760"/>
                        <a:tab algn="l" pos="3649680"/>
                        <a:tab algn="l" pos="3981600"/>
                        <a:tab algn="l" pos="4313160"/>
                        <a:tab algn="l" pos="4645080"/>
                        <a:tab algn="l" pos="4976640"/>
                        <a:tab algn="l" pos="5308560"/>
                        <a:tab algn="l" pos="5640480"/>
                        <a:tab algn="l" pos="5972040"/>
                        <a:tab algn="l" pos="6303960"/>
                        <a:tab algn="l" pos="6635880"/>
                      </a:tabLst>
                    </a:pPr>
                    <a:r>
                      <a:rPr b="1" lang="fr-FR" sz="10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ClpP1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95" name="ZoneTexte 209"/>
                  <p:cNvSpPr/>
                  <p:nvPr/>
                </p:nvSpPr>
                <p:spPr>
                  <a:xfrm>
                    <a:off x="2217960" y="371160"/>
                    <a:ext cx="468720" cy="2462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331920"/>
                        <a:tab algn="l" pos="663480"/>
                        <a:tab algn="l" pos="995400"/>
                        <a:tab algn="l" pos="1327320"/>
                        <a:tab algn="l" pos="1658880"/>
                        <a:tab algn="l" pos="1990800"/>
                        <a:tab algn="l" pos="2322360"/>
                        <a:tab algn="l" pos="2654280"/>
                        <a:tab algn="l" pos="2986200"/>
                        <a:tab algn="l" pos="3317760"/>
                        <a:tab algn="l" pos="3649680"/>
                        <a:tab algn="l" pos="3981600"/>
                        <a:tab algn="l" pos="4313160"/>
                        <a:tab algn="l" pos="4645080"/>
                        <a:tab algn="l" pos="4976640"/>
                        <a:tab algn="l" pos="5308560"/>
                        <a:tab algn="l" pos="5640480"/>
                        <a:tab algn="l" pos="5972040"/>
                        <a:tab algn="l" pos="6303960"/>
                        <a:tab algn="l" pos="6635880"/>
                      </a:tabLst>
                    </a:pPr>
                    <a:r>
                      <a:rPr b="1" lang="fr-FR" sz="10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ClpP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96" name="ZoneTexte 210"/>
                  <p:cNvSpPr/>
                  <p:nvPr/>
                </p:nvSpPr>
                <p:spPr>
                  <a:xfrm>
                    <a:off x="2563560" y="371160"/>
                    <a:ext cx="538920" cy="2462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331920"/>
                        <a:tab algn="l" pos="663480"/>
                        <a:tab algn="l" pos="995400"/>
                        <a:tab algn="l" pos="1327320"/>
                        <a:tab algn="l" pos="1658880"/>
                        <a:tab algn="l" pos="1990800"/>
                        <a:tab algn="l" pos="2322360"/>
                        <a:tab algn="l" pos="2654280"/>
                        <a:tab algn="l" pos="2986200"/>
                        <a:tab algn="l" pos="3317760"/>
                        <a:tab algn="l" pos="3649680"/>
                        <a:tab algn="l" pos="3981600"/>
                        <a:tab algn="l" pos="4313160"/>
                        <a:tab algn="l" pos="4645080"/>
                        <a:tab algn="l" pos="4976640"/>
                        <a:tab algn="l" pos="5308560"/>
                        <a:tab algn="l" pos="5640480"/>
                        <a:tab algn="l" pos="5972040"/>
                        <a:tab algn="l" pos="6303960"/>
                        <a:tab algn="l" pos="6635880"/>
                      </a:tabLst>
                    </a:pPr>
                    <a:r>
                      <a:rPr b="1" lang="en-US" sz="10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ClpP1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97" name="ZoneTexte 211"/>
                  <p:cNvSpPr/>
                  <p:nvPr/>
                </p:nvSpPr>
                <p:spPr>
                  <a:xfrm>
                    <a:off x="2967480" y="217440"/>
                    <a:ext cx="538920" cy="3985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331920"/>
                        <a:tab algn="l" pos="663480"/>
                        <a:tab algn="l" pos="995400"/>
                        <a:tab algn="l" pos="1327320"/>
                        <a:tab algn="l" pos="1658880"/>
                        <a:tab algn="l" pos="1990800"/>
                        <a:tab algn="l" pos="2322360"/>
                        <a:tab algn="l" pos="2654280"/>
                        <a:tab algn="l" pos="2986200"/>
                        <a:tab algn="l" pos="3317760"/>
                        <a:tab algn="l" pos="3649680"/>
                        <a:tab algn="l" pos="3981600"/>
                        <a:tab algn="l" pos="4313160"/>
                        <a:tab algn="l" pos="4645080"/>
                        <a:tab algn="l" pos="4976640"/>
                        <a:tab algn="l" pos="5308560"/>
                        <a:tab algn="l" pos="5640480"/>
                        <a:tab algn="l" pos="5972040"/>
                        <a:tab algn="l" pos="6303960"/>
                        <a:tab algn="l" pos="6635880"/>
                      </a:tabLst>
                    </a:pPr>
                    <a:r>
                      <a:rPr b="1" lang="fr-FR" sz="10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ClpP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331920"/>
                        <a:tab algn="l" pos="663480"/>
                        <a:tab algn="l" pos="995400"/>
                        <a:tab algn="l" pos="1327320"/>
                        <a:tab algn="l" pos="1658880"/>
                        <a:tab algn="l" pos="1990800"/>
                        <a:tab algn="l" pos="2322360"/>
                        <a:tab algn="l" pos="2654280"/>
                        <a:tab algn="l" pos="2986200"/>
                        <a:tab algn="l" pos="3317760"/>
                        <a:tab algn="l" pos="3649680"/>
                        <a:tab algn="l" pos="3981600"/>
                        <a:tab algn="l" pos="4313160"/>
                        <a:tab algn="l" pos="4645080"/>
                        <a:tab algn="l" pos="4976640"/>
                        <a:tab algn="l" pos="5308560"/>
                        <a:tab algn="l" pos="5640480"/>
                        <a:tab algn="l" pos="5972040"/>
                        <a:tab algn="l" pos="6303960"/>
                        <a:tab algn="l" pos="6635880"/>
                      </a:tabLst>
                    </a:pPr>
                    <a:r>
                      <a:rPr b="1" lang="fr-FR" sz="10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ClpP1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98" name="Parenthèse ouvrante 212"/>
                  <p:cNvSpPr/>
                  <p:nvPr/>
                </p:nvSpPr>
                <p:spPr>
                  <a:xfrm rot="5400000">
                    <a:off x="1623240" y="-203400"/>
                    <a:ext cx="107280" cy="1075680"/>
                  </a:xfrm>
                  <a:custGeom>
                    <a:avLst/>
                    <a:gdLst>
                      <a:gd name="textAreaLeft" fmla="*/ 31320 w 107280"/>
                      <a:gd name="textAreaRight" fmla="*/ 107640 w 107280"/>
                      <a:gd name="textAreaTop" fmla="*/ 4320 h 1075680"/>
                      <a:gd name="textAreaBottom" fmla="*/ 1071360 h 1075680"/>
                    </a:gdLst>
                    <a:ahLst/>
                    <a:rect l="textAreaLeft" t="textAreaTop" r="textAreaRight" b="textAreaBottom"/>
                    <a:pathLst>
                      <a:path w="21600" h="21600">
                        <a:moveTo>
                          <a:pt x="21600" y="0"/>
                        </a:moveTo>
                        <a:cubicBezTo>
                          <a:pt x="10800" y="0"/>
                          <a:pt x="0" y="90"/>
                          <a:pt x="0" y="179"/>
                        </a:cubicBezTo>
                        <a:lnTo>
                          <a:pt x="0" y="21421"/>
                        </a:lnTo>
                        <a:cubicBezTo>
                          <a:pt x="0" y="21511"/>
                          <a:pt x="10800" y="21600"/>
                          <a:pt x="21600" y="21600"/>
                        </a:cubicBezTo>
                      </a:path>
                    </a:pathLst>
                  </a:custGeom>
                  <a:noFill/>
                  <a:ln w="190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pPr algn="ctr">
                      <a:tabLst>
                        <a:tab algn="l" pos="0"/>
                        <a:tab algn="l" pos="331920"/>
                        <a:tab algn="l" pos="663480"/>
                        <a:tab algn="l" pos="995400"/>
                        <a:tab algn="l" pos="1327320"/>
                        <a:tab algn="l" pos="1658880"/>
                        <a:tab algn="l" pos="1990800"/>
                        <a:tab algn="l" pos="2322360"/>
                        <a:tab algn="l" pos="2654280"/>
                        <a:tab algn="l" pos="2986200"/>
                        <a:tab algn="l" pos="3317760"/>
                        <a:tab algn="l" pos="3649680"/>
                        <a:tab algn="l" pos="3981600"/>
                        <a:tab algn="l" pos="4313160"/>
                        <a:tab algn="l" pos="4645080"/>
                        <a:tab algn="l" pos="4976640"/>
                        <a:tab algn="l" pos="5308560"/>
                        <a:tab algn="l" pos="5640480"/>
                        <a:tab algn="l" pos="5972040"/>
                        <a:tab algn="l" pos="6303960"/>
                        <a:tab algn="l" pos="6635880"/>
                      </a:tabLst>
                    </a:pPr>
                    <a:endParaRPr b="0" lang="en-US" sz="13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99" name="Parenthèse ouvrante 213"/>
                  <p:cNvSpPr/>
                  <p:nvPr/>
                </p:nvSpPr>
                <p:spPr>
                  <a:xfrm rot="5400000">
                    <a:off x="2849400" y="-273600"/>
                    <a:ext cx="107280" cy="1216080"/>
                  </a:xfrm>
                  <a:custGeom>
                    <a:avLst/>
                    <a:gdLst>
                      <a:gd name="textAreaLeft" fmla="*/ 31320 w 107280"/>
                      <a:gd name="textAreaRight" fmla="*/ 107640 w 107280"/>
                      <a:gd name="textAreaTop" fmla="*/ 4320 h 1216080"/>
                      <a:gd name="textAreaBottom" fmla="*/ 1211760 h 1216080"/>
                    </a:gdLst>
                    <a:ahLst/>
                    <a:rect l="textAreaLeft" t="textAreaTop" r="textAreaRight" b="textAreaBottom"/>
                    <a:pathLst>
                      <a:path w="21600" h="21600">
                        <a:moveTo>
                          <a:pt x="21600" y="0"/>
                        </a:moveTo>
                        <a:cubicBezTo>
                          <a:pt x="10800" y="0"/>
                          <a:pt x="0" y="80"/>
                          <a:pt x="0" y="159"/>
                        </a:cubicBezTo>
                        <a:lnTo>
                          <a:pt x="0" y="21441"/>
                        </a:lnTo>
                        <a:cubicBezTo>
                          <a:pt x="0" y="21521"/>
                          <a:pt x="10800" y="21600"/>
                          <a:pt x="21600" y="21600"/>
                        </a:cubicBezTo>
                      </a:path>
                    </a:pathLst>
                  </a:custGeom>
                  <a:noFill/>
                  <a:ln w="190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pPr algn="ctr">
                      <a:tabLst>
                        <a:tab algn="l" pos="0"/>
                        <a:tab algn="l" pos="331920"/>
                        <a:tab algn="l" pos="663480"/>
                        <a:tab algn="l" pos="995400"/>
                        <a:tab algn="l" pos="1327320"/>
                        <a:tab algn="l" pos="1658880"/>
                        <a:tab algn="l" pos="1990800"/>
                        <a:tab algn="l" pos="2322360"/>
                        <a:tab algn="l" pos="2654280"/>
                        <a:tab algn="l" pos="2986200"/>
                        <a:tab algn="l" pos="3317760"/>
                        <a:tab algn="l" pos="3649680"/>
                        <a:tab algn="l" pos="3981600"/>
                        <a:tab algn="l" pos="4313160"/>
                        <a:tab algn="l" pos="4645080"/>
                        <a:tab algn="l" pos="4976640"/>
                        <a:tab algn="l" pos="5308560"/>
                        <a:tab algn="l" pos="5640480"/>
                        <a:tab algn="l" pos="5972040"/>
                        <a:tab algn="l" pos="6303960"/>
                        <a:tab algn="l" pos="6635880"/>
                      </a:tabLst>
                    </a:pPr>
                    <a:endParaRPr b="0" lang="en-US" sz="13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00" name="ZoneTexte 214"/>
                  <p:cNvSpPr/>
                  <p:nvPr/>
                </p:nvSpPr>
                <p:spPr>
                  <a:xfrm>
                    <a:off x="1242720" y="14400"/>
                    <a:ext cx="884880" cy="3070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331920"/>
                        <a:tab algn="l" pos="663480"/>
                        <a:tab algn="l" pos="995400"/>
                        <a:tab algn="l" pos="1327320"/>
                        <a:tab algn="l" pos="1658880"/>
                        <a:tab algn="l" pos="1990800"/>
                        <a:tab algn="l" pos="2322360"/>
                        <a:tab algn="l" pos="2654280"/>
                        <a:tab algn="l" pos="2986200"/>
                        <a:tab algn="l" pos="3317760"/>
                        <a:tab algn="l" pos="3649680"/>
                        <a:tab algn="l" pos="3981600"/>
                        <a:tab algn="l" pos="4313160"/>
                        <a:tab algn="l" pos="4645080"/>
                        <a:tab algn="l" pos="4976640"/>
                        <a:tab algn="l" pos="5308560"/>
                        <a:tab algn="l" pos="5640480"/>
                        <a:tab algn="l" pos="5972040"/>
                        <a:tab algn="l" pos="6303960"/>
                        <a:tab algn="l" pos="6635880"/>
                      </a:tabLst>
                    </a:pPr>
                    <a:r>
                      <a:rPr b="1" lang="fr-FR" sz="14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Extracts</a:t>
                    </a:r>
                    <a:endParaRPr b="0" lang="en-US" sz="14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01" name="ZoneTexte 215"/>
                  <p:cNvSpPr/>
                  <p:nvPr/>
                </p:nvSpPr>
                <p:spPr>
                  <a:xfrm>
                    <a:off x="2523960" y="14400"/>
                    <a:ext cx="784080" cy="3070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331920"/>
                        <a:tab algn="l" pos="663480"/>
                        <a:tab algn="l" pos="995400"/>
                        <a:tab algn="l" pos="1327320"/>
                        <a:tab algn="l" pos="1658880"/>
                        <a:tab algn="l" pos="1990800"/>
                        <a:tab algn="l" pos="2322360"/>
                        <a:tab algn="l" pos="2654280"/>
                        <a:tab algn="l" pos="2986200"/>
                        <a:tab algn="l" pos="3317760"/>
                        <a:tab algn="l" pos="3649680"/>
                        <a:tab algn="l" pos="3981600"/>
                        <a:tab algn="l" pos="4313160"/>
                        <a:tab algn="l" pos="4645080"/>
                        <a:tab algn="l" pos="4976640"/>
                        <a:tab algn="l" pos="5308560"/>
                        <a:tab algn="l" pos="5640480"/>
                        <a:tab algn="l" pos="5972040"/>
                        <a:tab algn="l" pos="6303960"/>
                        <a:tab algn="l" pos="6635880"/>
                      </a:tabLst>
                    </a:pPr>
                    <a:r>
                      <a:rPr b="1" lang="en-US" sz="14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Elution</a:t>
                    </a:r>
                    <a:endParaRPr b="0" lang="en-US" sz="14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</p:grpSp>
        </p:grpSp>
        <p:sp>
          <p:nvSpPr>
            <p:cNvPr id="102" name="ZoneTexte 96"/>
            <p:cNvSpPr/>
            <p:nvPr/>
          </p:nvSpPr>
          <p:spPr>
            <a:xfrm>
              <a:off x="101160" y="220320"/>
              <a:ext cx="3452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331920"/>
                  <a:tab algn="l" pos="663480"/>
                  <a:tab algn="l" pos="995400"/>
                  <a:tab algn="l" pos="1327320"/>
                  <a:tab algn="l" pos="1658880"/>
                  <a:tab algn="l" pos="1990800"/>
                  <a:tab algn="l" pos="2322360"/>
                  <a:tab algn="l" pos="2654280"/>
                  <a:tab algn="l" pos="2986200"/>
                  <a:tab algn="l" pos="3317760"/>
                  <a:tab algn="l" pos="3649680"/>
                  <a:tab algn="l" pos="3981600"/>
                  <a:tab algn="l" pos="4313160"/>
                  <a:tab algn="l" pos="4645080"/>
                  <a:tab algn="l" pos="4976640"/>
                  <a:tab algn="l" pos="5308560"/>
                  <a:tab algn="l" pos="5640480"/>
                  <a:tab algn="l" pos="5972040"/>
                  <a:tab algn="l" pos="6303960"/>
                  <a:tab algn="l" pos="663588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  <a:ea typeface="Arial"/>
                </a:rPr>
                <a:t>A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03" name="Grouper 111"/>
          <p:cNvGrpSpPr/>
          <p:nvPr/>
        </p:nvGrpSpPr>
        <p:grpSpPr>
          <a:xfrm>
            <a:off x="101160" y="2786040"/>
            <a:ext cx="4383720" cy="2684880"/>
            <a:chOff x="101160" y="2786040"/>
            <a:chExt cx="4383720" cy="2684880"/>
          </a:xfrm>
        </p:grpSpPr>
        <p:grpSp>
          <p:nvGrpSpPr>
            <p:cNvPr id="104" name="Grouper 118"/>
            <p:cNvGrpSpPr/>
            <p:nvPr/>
          </p:nvGrpSpPr>
          <p:grpSpPr>
            <a:xfrm>
              <a:off x="164520" y="2786040"/>
              <a:ext cx="4320360" cy="2684880"/>
              <a:chOff x="164520" y="2786040"/>
              <a:chExt cx="4320360" cy="2684880"/>
            </a:xfrm>
          </p:grpSpPr>
          <p:sp>
            <p:nvSpPr>
              <p:cNvPr id="105" name="ZoneTexte 152"/>
              <p:cNvSpPr/>
              <p:nvPr/>
            </p:nvSpPr>
            <p:spPr>
              <a:xfrm>
                <a:off x="164520" y="3550680"/>
                <a:ext cx="46872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331920"/>
                    <a:tab algn="l" pos="663480"/>
                    <a:tab algn="l" pos="995400"/>
                    <a:tab algn="l" pos="1327320"/>
                    <a:tab algn="l" pos="1658880"/>
                    <a:tab algn="l" pos="1990800"/>
                    <a:tab algn="l" pos="2322360"/>
                    <a:tab algn="l" pos="2654280"/>
                    <a:tab algn="l" pos="2986200"/>
                    <a:tab algn="l" pos="3317760"/>
                    <a:tab algn="l" pos="3649680"/>
                    <a:tab algn="l" pos="3981600"/>
                    <a:tab algn="l" pos="4313160"/>
                    <a:tab algn="l" pos="4645080"/>
                    <a:tab algn="l" pos="4976640"/>
                    <a:tab algn="l" pos="5308560"/>
                    <a:tab algn="l" pos="5640480"/>
                    <a:tab algn="l" pos="5972040"/>
                    <a:tab algn="l" pos="6303960"/>
                    <a:tab algn="l" pos="663588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40.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6" name="Connecteur droit 153"/>
              <p:cNvSpPr/>
              <p:nvPr/>
            </p:nvSpPr>
            <p:spPr>
              <a:xfrm>
                <a:off x="583920" y="3765240"/>
                <a:ext cx="95760" cy="14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3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7" name="ZoneTexte 154"/>
              <p:cNvSpPr/>
              <p:nvPr/>
            </p:nvSpPr>
            <p:spPr>
              <a:xfrm>
                <a:off x="164520" y="3639600"/>
                <a:ext cx="46872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331920"/>
                    <a:tab algn="l" pos="663480"/>
                    <a:tab algn="l" pos="995400"/>
                    <a:tab algn="l" pos="1327320"/>
                    <a:tab algn="l" pos="1658880"/>
                    <a:tab algn="l" pos="1990800"/>
                    <a:tab algn="l" pos="2322360"/>
                    <a:tab algn="l" pos="2654280"/>
                    <a:tab algn="l" pos="2986200"/>
                    <a:tab algn="l" pos="3317760"/>
                    <a:tab algn="l" pos="3649680"/>
                    <a:tab algn="l" pos="3981600"/>
                    <a:tab algn="l" pos="4313160"/>
                    <a:tab algn="l" pos="4645080"/>
                    <a:tab algn="l" pos="4976640"/>
                    <a:tab algn="l" pos="5308560"/>
                    <a:tab algn="l" pos="5640480"/>
                    <a:tab algn="l" pos="5972040"/>
                    <a:tab algn="l" pos="6303960"/>
                    <a:tab algn="l" pos="663588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00.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pic>
            <p:nvPicPr>
              <p:cNvPr id="108" name="Image 155" descr=""/>
              <p:cNvPicPr/>
              <p:nvPr/>
            </p:nvPicPr>
            <p:blipFill>
              <a:blip r:embed="rId3"/>
              <a:stretch/>
            </p:blipFill>
            <p:spPr>
              <a:xfrm>
                <a:off x="680040" y="3553560"/>
                <a:ext cx="2894400" cy="1906920"/>
              </a:xfrm>
              <a:prstGeom prst="rect">
                <a:avLst/>
              </a:prstGeom>
              <a:ln w="19080">
                <a:solidFill>
                  <a:srgbClr val="000000"/>
                </a:solidFill>
                <a:miter/>
              </a:ln>
            </p:spPr>
          </p:pic>
          <p:sp>
            <p:nvSpPr>
              <p:cNvPr id="109" name="Connecteur droit 156"/>
              <p:cNvSpPr/>
              <p:nvPr/>
            </p:nvSpPr>
            <p:spPr>
              <a:xfrm>
                <a:off x="583920" y="3669840"/>
                <a:ext cx="95760" cy="14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3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0" name="Connecteur droit 157"/>
              <p:cNvSpPr/>
              <p:nvPr/>
            </p:nvSpPr>
            <p:spPr>
              <a:xfrm>
                <a:off x="583920" y="3873240"/>
                <a:ext cx="95760" cy="14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3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1" name="ZoneTexte 158"/>
              <p:cNvSpPr/>
              <p:nvPr/>
            </p:nvSpPr>
            <p:spPr>
              <a:xfrm>
                <a:off x="228600" y="3754080"/>
                <a:ext cx="40464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331920"/>
                    <a:tab algn="l" pos="663480"/>
                    <a:tab algn="l" pos="995400"/>
                    <a:tab algn="l" pos="1327320"/>
                    <a:tab algn="l" pos="1658880"/>
                    <a:tab algn="l" pos="1990800"/>
                    <a:tab algn="l" pos="2322360"/>
                    <a:tab algn="l" pos="2654280"/>
                    <a:tab algn="l" pos="2986200"/>
                    <a:tab algn="l" pos="3317760"/>
                    <a:tab algn="l" pos="3649680"/>
                    <a:tab algn="l" pos="3981600"/>
                    <a:tab algn="l" pos="4313160"/>
                    <a:tab algn="l" pos="4645080"/>
                    <a:tab algn="l" pos="4976640"/>
                    <a:tab algn="l" pos="5308560"/>
                    <a:tab algn="l" pos="5640480"/>
                    <a:tab algn="l" pos="5972040"/>
                    <a:tab algn="l" pos="6303960"/>
                    <a:tab algn="l" pos="663588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70.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2" name="Connecteur droit 159"/>
              <p:cNvSpPr/>
              <p:nvPr/>
            </p:nvSpPr>
            <p:spPr>
              <a:xfrm>
                <a:off x="583920" y="4114440"/>
                <a:ext cx="95760" cy="14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3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3" name="ZoneTexte 160"/>
              <p:cNvSpPr/>
              <p:nvPr/>
            </p:nvSpPr>
            <p:spPr>
              <a:xfrm>
                <a:off x="228600" y="4001760"/>
                <a:ext cx="40464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331920"/>
                    <a:tab algn="l" pos="663480"/>
                    <a:tab algn="l" pos="995400"/>
                    <a:tab algn="l" pos="1327320"/>
                    <a:tab algn="l" pos="1658880"/>
                    <a:tab algn="l" pos="1990800"/>
                    <a:tab algn="l" pos="2322360"/>
                    <a:tab algn="l" pos="2654280"/>
                    <a:tab algn="l" pos="2986200"/>
                    <a:tab algn="l" pos="3317760"/>
                    <a:tab algn="l" pos="3649680"/>
                    <a:tab algn="l" pos="3981600"/>
                    <a:tab algn="l" pos="4313160"/>
                    <a:tab algn="l" pos="4645080"/>
                    <a:tab algn="l" pos="4976640"/>
                    <a:tab algn="l" pos="5308560"/>
                    <a:tab algn="l" pos="5640480"/>
                    <a:tab algn="l" pos="5972040"/>
                    <a:tab algn="l" pos="6303960"/>
                    <a:tab algn="l" pos="663588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50.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4" name="Connecteur droit 161"/>
              <p:cNvSpPr/>
              <p:nvPr/>
            </p:nvSpPr>
            <p:spPr>
              <a:xfrm>
                <a:off x="583920" y="4254120"/>
                <a:ext cx="95760" cy="14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3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5" name="ZoneTexte 162"/>
              <p:cNvSpPr/>
              <p:nvPr/>
            </p:nvSpPr>
            <p:spPr>
              <a:xfrm>
                <a:off x="228600" y="4141440"/>
                <a:ext cx="40464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331920"/>
                    <a:tab algn="l" pos="663480"/>
                    <a:tab algn="l" pos="995400"/>
                    <a:tab algn="l" pos="1327320"/>
                    <a:tab algn="l" pos="1658880"/>
                    <a:tab algn="l" pos="1990800"/>
                    <a:tab algn="l" pos="2322360"/>
                    <a:tab algn="l" pos="2654280"/>
                    <a:tab algn="l" pos="2986200"/>
                    <a:tab algn="l" pos="3317760"/>
                    <a:tab algn="l" pos="3649680"/>
                    <a:tab algn="l" pos="3981600"/>
                    <a:tab algn="l" pos="4313160"/>
                    <a:tab algn="l" pos="4645080"/>
                    <a:tab algn="l" pos="4976640"/>
                    <a:tab algn="l" pos="5308560"/>
                    <a:tab algn="l" pos="5640480"/>
                    <a:tab algn="l" pos="5972040"/>
                    <a:tab algn="l" pos="6303960"/>
                    <a:tab algn="l" pos="663588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40.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6" name="Connecteur droit 163"/>
              <p:cNvSpPr/>
              <p:nvPr/>
            </p:nvSpPr>
            <p:spPr>
              <a:xfrm>
                <a:off x="583920" y="4451040"/>
                <a:ext cx="95760" cy="14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3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7" name="ZoneTexte 164"/>
              <p:cNvSpPr/>
              <p:nvPr/>
            </p:nvSpPr>
            <p:spPr>
              <a:xfrm>
                <a:off x="228600" y="4325400"/>
                <a:ext cx="40464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331920"/>
                    <a:tab algn="l" pos="663480"/>
                    <a:tab algn="l" pos="995400"/>
                    <a:tab algn="l" pos="1327320"/>
                    <a:tab algn="l" pos="1658880"/>
                    <a:tab algn="l" pos="1990800"/>
                    <a:tab algn="l" pos="2322360"/>
                    <a:tab algn="l" pos="2654280"/>
                    <a:tab algn="l" pos="2986200"/>
                    <a:tab algn="l" pos="3317760"/>
                    <a:tab algn="l" pos="3649680"/>
                    <a:tab algn="l" pos="3981600"/>
                    <a:tab algn="l" pos="4313160"/>
                    <a:tab algn="l" pos="4645080"/>
                    <a:tab algn="l" pos="4976640"/>
                    <a:tab algn="l" pos="5308560"/>
                    <a:tab algn="l" pos="5640480"/>
                    <a:tab algn="l" pos="5972040"/>
                    <a:tab algn="l" pos="6303960"/>
                    <a:tab algn="l" pos="663588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35.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8" name="Connecteur droit 165"/>
              <p:cNvSpPr/>
              <p:nvPr/>
            </p:nvSpPr>
            <p:spPr>
              <a:xfrm>
                <a:off x="577800" y="4713120"/>
                <a:ext cx="95760" cy="14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3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9" name="ZoneTexte 166"/>
              <p:cNvSpPr/>
              <p:nvPr/>
            </p:nvSpPr>
            <p:spPr>
              <a:xfrm>
                <a:off x="228600" y="4598640"/>
                <a:ext cx="40464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331920"/>
                    <a:tab algn="l" pos="663480"/>
                    <a:tab algn="l" pos="995400"/>
                    <a:tab algn="l" pos="1327320"/>
                    <a:tab algn="l" pos="1658880"/>
                    <a:tab algn="l" pos="1990800"/>
                    <a:tab algn="l" pos="2322360"/>
                    <a:tab algn="l" pos="2654280"/>
                    <a:tab algn="l" pos="2986200"/>
                    <a:tab algn="l" pos="3317760"/>
                    <a:tab algn="l" pos="3649680"/>
                    <a:tab algn="l" pos="3981600"/>
                    <a:tab algn="l" pos="4313160"/>
                    <a:tab algn="l" pos="4645080"/>
                    <a:tab algn="l" pos="4976640"/>
                    <a:tab algn="l" pos="5308560"/>
                    <a:tab algn="l" pos="5640480"/>
                    <a:tab algn="l" pos="5972040"/>
                    <a:tab algn="l" pos="6303960"/>
                    <a:tab algn="l" pos="663588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25.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0" name="Connecteur droit 167"/>
              <p:cNvSpPr/>
              <p:nvPr/>
            </p:nvSpPr>
            <p:spPr>
              <a:xfrm>
                <a:off x="577800" y="5354640"/>
                <a:ext cx="95760" cy="14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3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1" name="ZoneTexte 168"/>
              <p:cNvSpPr/>
              <p:nvPr/>
            </p:nvSpPr>
            <p:spPr>
              <a:xfrm>
                <a:off x="222120" y="5239800"/>
                <a:ext cx="40464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331920"/>
                    <a:tab algn="l" pos="663480"/>
                    <a:tab algn="l" pos="995400"/>
                    <a:tab algn="l" pos="1327320"/>
                    <a:tab algn="l" pos="1658880"/>
                    <a:tab algn="l" pos="1990800"/>
                    <a:tab algn="l" pos="2322360"/>
                    <a:tab algn="l" pos="2654280"/>
                    <a:tab algn="l" pos="2986200"/>
                    <a:tab algn="l" pos="3317760"/>
                    <a:tab algn="l" pos="3649680"/>
                    <a:tab algn="l" pos="3981600"/>
                    <a:tab algn="l" pos="4313160"/>
                    <a:tab algn="l" pos="4645080"/>
                    <a:tab algn="l" pos="4976640"/>
                    <a:tab algn="l" pos="5308560"/>
                    <a:tab algn="l" pos="5640480"/>
                    <a:tab algn="l" pos="5972040"/>
                    <a:tab algn="l" pos="6303960"/>
                    <a:tab algn="l" pos="663588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5.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grpSp>
            <p:nvGrpSpPr>
              <p:cNvPr id="122" name="Grouper 60"/>
              <p:cNvGrpSpPr/>
              <p:nvPr/>
            </p:nvGrpSpPr>
            <p:grpSpPr>
              <a:xfrm>
                <a:off x="3618000" y="4843440"/>
                <a:ext cx="541440" cy="276480"/>
                <a:chOff x="3618000" y="4843440"/>
                <a:chExt cx="541440" cy="276480"/>
              </a:xfrm>
            </p:grpSpPr>
            <p:sp>
              <p:nvSpPr>
                <p:cNvPr id="123" name="Triangle isocèle 184"/>
                <p:cNvSpPr/>
                <p:nvPr/>
              </p:nvSpPr>
              <p:spPr>
                <a:xfrm rot="16200000">
                  <a:off x="3627000" y="4947120"/>
                  <a:ext cx="50040" cy="68400"/>
                </a:xfrm>
                <a:prstGeom prst="triangle">
                  <a:avLst>
                    <a:gd name="adj" fmla="val 50000"/>
                  </a:avLst>
                </a:prstGeom>
                <a:solidFill>
                  <a:srgbClr val="0000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3760" bIns="-23760" anchor="ctr">
                  <a:noAutofit/>
                </a:bodyPr>
                <a:p>
                  <a:pPr algn="ctr">
                    <a:tabLst>
                      <a:tab algn="l" pos="0"/>
                      <a:tab algn="l" pos="331920"/>
                      <a:tab algn="l" pos="663480"/>
                      <a:tab algn="l" pos="995400"/>
                      <a:tab algn="l" pos="1327320"/>
                      <a:tab algn="l" pos="1658880"/>
                      <a:tab algn="l" pos="1990800"/>
                      <a:tab algn="l" pos="2322360"/>
                      <a:tab algn="l" pos="2654280"/>
                      <a:tab algn="l" pos="2986200"/>
                      <a:tab algn="l" pos="3317760"/>
                      <a:tab algn="l" pos="3649680"/>
                      <a:tab algn="l" pos="3981600"/>
                      <a:tab algn="l" pos="4313160"/>
                      <a:tab algn="l" pos="4645080"/>
                      <a:tab algn="l" pos="4976640"/>
                      <a:tab algn="l" pos="5308560"/>
                      <a:tab algn="l" pos="5640480"/>
                      <a:tab algn="l" pos="5972040"/>
                      <a:tab algn="l" pos="6303960"/>
                      <a:tab algn="l" pos="6635880"/>
                    </a:tabLst>
                  </a:pPr>
                  <a:endParaRPr b="0" lang="en-US" sz="13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24" name="ZoneTexte 185"/>
                <p:cNvSpPr/>
                <p:nvPr/>
              </p:nvSpPr>
              <p:spPr>
                <a:xfrm>
                  <a:off x="3631320" y="4843440"/>
                  <a:ext cx="52812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331920"/>
                      <a:tab algn="l" pos="663480"/>
                      <a:tab algn="l" pos="995400"/>
                      <a:tab algn="l" pos="1327320"/>
                      <a:tab algn="l" pos="1658880"/>
                      <a:tab algn="l" pos="1990800"/>
                      <a:tab algn="l" pos="2322360"/>
                      <a:tab algn="l" pos="2654280"/>
                      <a:tab algn="l" pos="2986200"/>
                      <a:tab algn="l" pos="3317760"/>
                      <a:tab algn="l" pos="3649680"/>
                      <a:tab algn="l" pos="3981600"/>
                      <a:tab algn="l" pos="4313160"/>
                      <a:tab algn="l" pos="4645080"/>
                      <a:tab algn="l" pos="4976640"/>
                      <a:tab algn="l" pos="5308560"/>
                      <a:tab algn="l" pos="5640480"/>
                      <a:tab algn="l" pos="5972040"/>
                      <a:tab algn="l" pos="6303960"/>
                      <a:tab algn="l" pos="6635880"/>
                    </a:tabLst>
                  </a:pPr>
                  <a:r>
                    <a:rPr b="1" lang="fr-FR" sz="12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ClpP</a:t>
                  </a:r>
                  <a:endParaRPr b="0" lang="en-US" sz="12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125" name="Grouper 63"/>
              <p:cNvGrpSpPr/>
              <p:nvPr/>
            </p:nvGrpSpPr>
            <p:grpSpPr>
              <a:xfrm>
                <a:off x="3618000" y="4671720"/>
                <a:ext cx="866880" cy="276480"/>
                <a:chOff x="3618000" y="4671720"/>
                <a:chExt cx="866880" cy="276480"/>
              </a:xfrm>
            </p:grpSpPr>
            <p:sp>
              <p:nvSpPr>
                <p:cNvPr id="126" name="Triangle isocèle 182"/>
                <p:cNvSpPr/>
                <p:nvPr/>
              </p:nvSpPr>
              <p:spPr>
                <a:xfrm rot="16200000">
                  <a:off x="3627000" y="4775400"/>
                  <a:ext cx="50040" cy="68400"/>
                </a:xfrm>
                <a:prstGeom prst="triangle">
                  <a:avLst>
                    <a:gd name="adj" fmla="val 50000"/>
                  </a:avLst>
                </a:prstGeom>
                <a:solidFill>
                  <a:srgbClr val="0000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3760" bIns="-23760" anchor="ctr">
                  <a:noAutofit/>
                </a:bodyPr>
                <a:p>
                  <a:pPr algn="ctr">
                    <a:tabLst>
                      <a:tab algn="l" pos="0"/>
                      <a:tab algn="l" pos="331920"/>
                      <a:tab algn="l" pos="663480"/>
                      <a:tab algn="l" pos="995400"/>
                      <a:tab algn="l" pos="1327320"/>
                      <a:tab algn="l" pos="1658880"/>
                      <a:tab algn="l" pos="1990800"/>
                      <a:tab algn="l" pos="2322360"/>
                      <a:tab algn="l" pos="2654280"/>
                      <a:tab algn="l" pos="2986200"/>
                      <a:tab algn="l" pos="3317760"/>
                      <a:tab algn="l" pos="3649680"/>
                      <a:tab algn="l" pos="3981600"/>
                      <a:tab algn="l" pos="4313160"/>
                      <a:tab algn="l" pos="4645080"/>
                      <a:tab algn="l" pos="4976640"/>
                      <a:tab algn="l" pos="5308560"/>
                      <a:tab algn="l" pos="5640480"/>
                      <a:tab algn="l" pos="5972040"/>
                      <a:tab algn="l" pos="6303960"/>
                      <a:tab algn="l" pos="6635880"/>
                    </a:tabLst>
                  </a:pPr>
                  <a:endParaRPr b="0" lang="en-US" sz="13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27" name="ZoneTexte 183"/>
                <p:cNvSpPr/>
                <p:nvPr/>
              </p:nvSpPr>
              <p:spPr>
                <a:xfrm>
                  <a:off x="3633480" y="4671720"/>
                  <a:ext cx="85140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331920"/>
                      <a:tab algn="l" pos="663480"/>
                      <a:tab algn="l" pos="995400"/>
                      <a:tab algn="l" pos="1327320"/>
                      <a:tab algn="l" pos="1658880"/>
                      <a:tab algn="l" pos="1990800"/>
                      <a:tab algn="l" pos="2322360"/>
                      <a:tab algn="l" pos="2654280"/>
                      <a:tab algn="l" pos="2986200"/>
                      <a:tab algn="l" pos="3317760"/>
                      <a:tab algn="l" pos="3649680"/>
                      <a:tab algn="l" pos="3981600"/>
                      <a:tab algn="l" pos="4313160"/>
                      <a:tab algn="l" pos="4645080"/>
                      <a:tab algn="l" pos="4976640"/>
                      <a:tab algn="l" pos="5308560"/>
                      <a:tab algn="l" pos="5640480"/>
                      <a:tab algn="l" pos="5972040"/>
                      <a:tab algn="l" pos="6303960"/>
                      <a:tab algn="l" pos="663588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ClpP2His</a:t>
                  </a:r>
                  <a:endParaRPr b="0" lang="en-US" sz="12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sp>
            <p:nvSpPr>
              <p:cNvPr id="128" name="ZoneTexte 171"/>
              <p:cNvSpPr/>
              <p:nvPr/>
            </p:nvSpPr>
            <p:spPr>
              <a:xfrm>
                <a:off x="641880" y="3172320"/>
                <a:ext cx="46728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331920"/>
                    <a:tab algn="l" pos="663480"/>
                    <a:tab algn="l" pos="995400"/>
                    <a:tab algn="l" pos="1327320"/>
                    <a:tab algn="l" pos="1658880"/>
                    <a:tab algn="l" pos="1990800"/>
                    <a:tab algn="l" pos="2322360"/>
                    <a:tab algn="l" pos="2654280"/>
                    <a:tab algn="l" pos="2986200"/>
                    <a:tab algn="l" pos="3317760"/>
                    <a:tab algn="l" pos="3649680"/>
                    <a:tab algn="l" pos="3981600"/>
                    <a:tab algn="l" pos="4313160"/>
                    <a:tab algn="l" pos="4645080"/>
                    <a:tab algn="l" pos="4976640"/>
                    <a:tab algn="l" pos="5308560"/>
                    <a:tab algn="l" pos="5640480"/>
                    <a:tab algn="l" pos="5972040"/>
                    <a:tab algn="l" pos="6303960"/>
                    <a:tab algn="l" pos="6635880"/>
                  </a:tabLst>
                </a:pPr>
                <a:r>
                  <a:rPr b="1" lang="fr-FR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MW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331920"/>
                    <a:tab algn="l" pos="663480"/>
                    <a:tab algn="l" pos="995400"/>
                    <a:tab algn="l" pos="1327320"/>
                    <a:tab algn="l" pos="1658880"/>
                    <a:tab algn="l" pos="1990800"/>
                    <a:tab algn="l" pos="2322360"/>
                    <a:tab algn="l" pos="2654280"/>
                    <a:tab algn="l" pos="2986200"/>
                    <a:tab algn="l" pos="3317760"/>
                    <a:tab algn="l" pos="3649680"/>
                    <a:tab algn="l" pos="3981600"/>
                    <a:tab algn="l" pos="4313160"/>
                    <a:tab algn="l" pos="4645080"/>
                    <a:tab algn="l" pos="4976640"/>
                    <a:tab algn="l" pos="5308560"/>
                    <a:tab algn="l" pos="5640480"/>
                    <a:tab algn="l" pos="5972040"/>
                    <a:tab algn="l" pos="6303960"/>
                    <a:tab algn="l" pos="6635880"/>
                  </a:tabLst>
                </a:pPr>
                <a:r>
                  <a:rPr b="1" lang="fr-FR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(kDa)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9" name="ZoneTexte 172"/>
              <p:cNvSpPr/>
              <p:nvPr/>
            </p:nvSpPr>
            <p:spPr>
              <a:xfrm>
                <a:off x="1042920" y="3161880"/>
                <a:ext cx="4687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331920"/>
                    <a:tab algn="l" pos="663480"/>
                    <a:tab algn="l" pos="995400"/>
                    <a:tab algn="l" pos="1327320"/>
                    <a:tab algn="l" pos="1658880"/>
                    <a:tab algn="l" pos="1990800"/>
                    <a:tab algn="l" pos="2322360"/>
                    <a:tab algn="l" pos="2654280"/>
                    <a:tab algn="l" pos="2986200"/>
                    <a:tab algn="l" pos="3317760"/>
                    <a:tab algn="l" pos="3649680"/>
                    <a:tab algn="l" pos="3981600"/>
                    <a:tab algn="l" pos="4313160"/>
                    <a:tab algn="l" pos="4645080"/>
                    <a:tab algn="l" pos="4976640"/>
                    <a:tab algn="l" pos="5308560"/>
                    <a:tab algn="l" pos="5640480"/>
                    <a:tab algn="l" pos="5972040"/>
                    <a:tab algn="l" pos="6303960"/>
                    <a:tab algn="l" pos="6635880"/>
                  </a:tabLst>
                </a:pPr>
                <a:r>
                  <a:rPr b="1" lang="fr-FR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ClpP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0" name="ZoneTexte 173"/>
              <p:cNvSpPr/>
              <p:nvPr/>
            </p:nvSpPr>
            <p:spPr>
              <a:xfrm>
                <a:off x="1369800" y="3161880"/>
                <a:ext cx="5389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331920"/>
                    <a:tab algn="l" pos="663480"/>
                    <a:tab algn="l" pos="995400"/>
                    <a:tab algn="l" pos="1327320"/>
                    <a:tab algn="l" pos="1658880"/>
                    <a:tab algn="l" pos="1990800"/>
                    <a:tab algn="l" pos="2322360"/>
                    <a:tab algn="l" pos="2654280"/>
                    <a:tab algn="l" pos="2986200"/>
                    <a:tab algn="l" pos="3317760"/>
                    <a:tab algn="l" pos="3649680"/>
                    <a:tab algn="l" pos="3981600"/>
                    <a:tab algn="l" pos="4313160"/>
                    <a:tab algn="l" pos="4645080"/>
                    <a:tab algn="l" pos="4976640"/>
                    <a:tab algn="l" pos="5308560"/>
                    <a:tab algn="l" pos="5640480"/>
                    <a:tab algn="l" pos="5972040"/>
                    <a:tab algn="l" pos="6303960"/>
                    <a:tab algn="l" pos="663588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ClpP2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1" name="ZoneTexte 174"/>
              <p:cNvSpPr/>
              <p:nvPr/>
            </p:nvSpPr>
            <p:spPr>
              <a:xfrm>
                <a:off x="1756440" y="3008160"/>
                <a:ext cx="538920" cy="398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331920"/>
                    <a:tab algn="l" pos="663480"/>
                    <a:tab algn="l" pos="995400"/>
                    <a:tab algn="l" pos="1327320"/>
                    <a:tab algn="l" pos="1658880"/>
                    <a:tab algn="l" pos="1990800"/>
                    <a:tab algn="l" pos="2322360"/>
                    <a:tab algn="l" pos="2654280"/>
                    <a:tab algn="l" pos="2986200"/>
                    <a:tab algn="l" pos="3317760"/>
                    <a:tab algn="l" pos="3649680"/>
                    <a:tab algn="l" pos="3981600"/>
                    <a:tab algn="l" pos="4313160"/>
                    <a:tab algn="l" pos="4645080"/>
                    <a:tab algn="l" pos="4976640"/>
                    <a:tab algn="l" pos="5308560"/>
                    <a:tab algn="l" pos="5640480"/>
                    <a:tab algn="l" pos="5972040"/>
                    <a:tab algn="l" pos="6303960"/>
                    <a:tab algn="l" pos="6635880"/>
                  </a:tabLst>
                </a:pPr>
                <a:r>
                  <a:rPr b="1" lang="fr-FR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ClpP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331920"/>
                    <a:tab algn="l" pos="663480"/>
                    <a:tab algn="l" pos="995400"/>
                    <a:tab algn="l" pos="1327320"/>
                    <a:tab algn="l" pos="1658880"/>
                    <a:tab algn="l" pos="1990800"/>
                    <a:tab algn="l" pos="2322360"/>
                    <a:tab algn="l" pos="2654280"/>
                    <a:tab algn="l" pos="2986200"/>
                    <a:tab algn="l" pos="3317760"/>
                    <a:tab algn="l" pos="3649680"/>
                    <a:tab algn="l" pos="3981600"/>
                    <a:tab algn="l" pos="4313160"/>
                    <a:tab algn="l" pos="4645080"/>
                    <a:tab algn="l" pos="4976640"/>
                    <a:tab algn="l" pos="5308560"/>
                    <a:tab algn="l" pos="5640480"/>
                    <a:tab algn="l" pos="5972040"/>
                    <a:tab algn="l" pos="6303960"/>
                    <a:tab algn="l" pos="6635880"/>
                  </a:tabLst>
                </a:pPr>
                <a:r>
                  <a:rPr b="1" lang="fr-FR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ClpP2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2" name="ZoneTexte 175"/>
              <p:cNvSpPr/>
              <p:nvPr/>
            </p:nvSpPr>
            <p:spPr>
              <a:xfrm>
                <a:off x="2192400" y="3161880"/>
                <a:ext cx="4687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331920"/>
                    <a:tab algn="l" pos="663480"/>
                    <a:tab algn="l" pos="995400"/>
                    <a:tab algn="l" pos="1327320"/>
                    <a:tab algn="l" pos="1658880"/>
                    <a:tab algn="l" pos="1990800"/>
                    <a:tab algn="l" pos="2322360"/>
                    <a:tab algn="l" pos="2654280"/>
                    <a:tab algn="l" pos="2986200"/>
                    <a:tab algn="l" pos="3317760"/>
                    <a:tab algn="l" pos="3649680"/>
                    <a:tab algn="l" pos="3981600"/>
                    <a:tab algn="l" pos="4313160"/>
                    <a:tab algn="l" pos="4645080"/>
                    <a:tab algn="l" pos="4976640"/>
                    <a:tab algn="l" pos="5308560"/>
                    <a:tab algn="l" pos="5640480"/>
                    <a:tab algn="l" pos="5972040"/>
                    <a:tab algn="l" pos="6303960"/>
                    <a:tab algn="l" pos="6635880"/>
                  </a:tabLst>
                </a:pPr>
                <a:r>
                  <a:rPr b="1" lang="fr-FR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ClpP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3" name="ZoneTexte 176"/>
              <p:cNvSpPr/>
              <p:nvPr/>
            </p:nvSpPr>
            <p:spPr>
              <a:xfrm>
                <a:off x="2538360" y="3161880"/>
                <a:ext cx="5389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331920"/>
                    <a:tab algn="l" pos="663480"/>
                    <a:tab algn="l" pos="995400"/>
                    <a:tab algn="l" pos="1327320"/>
                    <a:tab algn="l" pos="1658880"/>
                    <a:tab algn="l" pos="1990800"/>
                    <a:tab algn="l" pos="2322360"/>
                    <a:tab algn="l" pos="2654280"/>
                    <a:tab algn="l" pos="2986200"/>
                    <a:tab algn="l" pos="3317760"/>
                    <a:tab algn="l" pos="3649680"/>
                    <a:tab algn="l" pos="3981600"/>
                    <a:tab algn="l" pos="4313160"/>
                    <a:tab algn="l" pos="4645080"/>
                    <a:tab algn="l" pos="4976640"/>
                    <a:tab algn="l" pos="5308560"/>
                    <a:tab algn="l" pos="5640480"/>
                    <a:tab algn="l" pos="5972040"/>
                    <a:tab algn="l" pos="6303960"/>
                    <a:tab algn="l" pos="663588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ClpP2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4" name="ZoneTexte 177"/>
              <p:cNvSpPr/>
              <p:nvPr/>
            </p:nvSpPr>
            <p:spPr>
              <a:xfrm>
                <a:off x="2999160" y="3008160"/>
                <a:ext cx="538920" cy="398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331920"/>
                    <a:tab algn="l" pos="663480"/>
                    <a:tab algn="l" pos="995400"/>
                    <a:tab algn="l" pos="1327320"/>
                    <a:tab algn="l" pos="1658880"/>
                    <a:tab algn="l" pos="1990800"/>
                    <a:tab algn="l" pos="2322360"/>
                    <a:tab algn="l" pos="2654280"/>
                    <a:tab algn="l" pos="2986200"/>
                    <a:tab algn="l" pos="3317760"/>
                    <a:tab algn="l" pos="3649680"/>
                    <a:tab algn="l" pos="3981600"/>
                    <a:tab algn="l" pos="4313160"/>
                    <a:tab algn="l" pos="4645080"/>
                    <a:tab algn="l" pos="4976640"/>
                    <a:tab algn="l" pos="5308560"/>
                    <a:tab algn="l" pos="5640480"/>
                    <a:tab algn="l" pos="5972040"/>
                    <a:tab algn="l" pos="6303960"/>
                    <a:tab algn="l" pos="6635880"/>
                  </a:tabLst>
                </a:pPr>
                <a:r>
                  <a:rPr b="1" lang="fr-FR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ClpP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331920"/>
                    <a:tab algn="l" pos="663480"/>
                    <a:tab algn="l" pos="995400"/>
                    <a:tab algn="l" pos="1327320"/>
                    <a:tab algn="l" pos="1658880"/>
                    <a:tab algn="l" pos="1990800"/>
                    <a:tab algn="l" pos="2322360"/>
                    <a:tab algn="l" pos="2654280"/>
                    <a:tab algn="l" pos="2986200"/>
                    <a:tab algn="l" pos="3317760"/>
                    <a:tab algn="l" pos="3649680"/>
                    <a:tab algn="l" pos="3981600"/>
                    <a:tab algn="l" pos="4313160"/>
                    <a:tab algn="l" pos="4645080"/>
                    <a:tab algn="l" pos="4976640"/>
                    <a:tab algn="l" pos="5308560"/>
                    <a:tab algn="l" pos="5640480"/>
                    <a:tab algn="l" pos="5972040"/>
                    <a:tab algn="l" pos="6303960"/>
                    <a:tab algn="l" pos="6635880"/>
                  </a:tabLst>
                </a:pPr>
                <a:r>
                  <a:rPr b="1" lang="fr-FR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ClpP2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5" name="Parenthèse ouvrante 178"/>
              <p:cNvSpPr/>
              <p:nvPr/>
            </p:nvSpPr>
            <p:spPr>
              <a:xfrm rot="5400000">
                <a:off x="1598040" y="2574720"/>
                <a:ext cx="107280" cy="1075680"/>
              </a:xfrm>
              <a:custGeom>
                <a:avLst/>
                <a:gdLst>
                  <a:gd name="textAreaLeft" fmla="*/ 31320 w 107280"/>
                  <a:gd name="textAreaRight" fmla="*/ 107640 w 107280"/>
                  <a:gd name="textAreaTop" fmla="*/ 4320 h 1075680"/>
                  <a:gd name="textAreaBottom" fmla="*/ 1071360 h 107568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21600" y="0"/>
                    </a:moveTo>
                    <a:cubicBezTo>
                      <a:pt x="10800" y="0"/>
                      <a:pt x="0" y="90"/>
                      <a:pt x="0" y="179"/>
                    </a:cubicBezTo>
                    <a:lnTo>
                      <a:pt x="0" y="21421"/>
                    </a:lnTo>
                    <a:cubicBezTo>
                      <a:pt x="0" y="21511"/>
                      <a:pt x="10800" y="21600"/>
                      <a:pt x="21600" y="21600"/>
                    </a:cubicBezTo>
                  </a:path>
                </a:pathLst>
              </a:custGeom>
              <a:noFill/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331920"/>
                    <a:tab algn="l" pos="663480"/>
                    <a:tab algn="l" pos="995400"/>
                    <a:tab algn="l" pos="1327320"/>
                    <a:tab algn="l" pos="1658880"/>
                    <a:tab algn="l" pos="1990800"/>
                    <a:tab algn="l" pos="2322360"/>
                    <a:tab algn="l" pos="2654280"/>
                    <a:tab algn="l" pos="2986200"/>
                    <a:tab algn="l" pos="3317760"/>
                    <a:tab algn="l" pos="3649680"/>
                    <a:tab algn="l" pos="3981600"/>
                    <a:tab algn="l" pos="4313160"/>
                    <a:tab algn="l" pos="4645080"/>
                    <a:tab algn="l" pos="4976640"/>
                    <a:tab algn="l" pos="5308560"/>
                    <a:tab algn="l" pos="5640480"/>
                    <a:tab algn="l" pos="5972040"/>
                    <a:tab algn="l" pos="6303960"/>
                    <a:tab algn="l" pos="6635880"/>
                  </a:tabLst>
                </a:pPr>
                <a:endParaRPr b="0" lang="en-US" sz="13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6" name="Parenthèse ouvrante 179"/>
              <p:cNvSpPr/>
              <p:nvPr/>
            </p:nvSpPr>
            <p:spPr>
              <a:xfrm rot="5400000">
                <a:off x="2823840" y="2504160"/>
                <a:ext cx="106920" cy="1216080"/>
              </a:xfrm>
              <a:custGeom>
                <a:avLst/>
                <a:gdLst>
                  <a:gd name="textAreaLeft" fmla="*/ 31320 w 106920"/>
                  <a:gd name="textAreaRight" fmla="*/ 107280 w 106920"/>
                  <a:gd name="textAreaTop" fmla="*/ 4320 h 1216080"/>
                  <a:gd name="textAreaBottom" fmla="*/ 1211760 h 121608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21600" y="0"/>
                    </a:moveTo>
                    <a:cubicBezTo>
                      <a:pt x="10800" y="0"/>
                      <a:pt x="0" y="80"/>
                      <a:pt x="0" y="159"/>
                    </a:cubicBezTo>
                    <a:lnTo>
                      <a:pt x="0" y="21441"/>
                    </a:lnTo>
                    <a:cubicBezTo>
                      <a:pt x="0" y="21521"/>
                      <a:pt x="10800" y="21600"/>
                      <a:pt x="21600" y="21600"/>
                    </a:cubicBezTo>
                  </a:path>
                </a:pathLst>
              </a:custGeom>
              <a:noFill/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331920"/>
                    <a:tab algn="l" pos="663480"/>
                    <a:tab algn="l" pos="995400"/>
                    <a:tab algn="l" pos="1327320"/>
                    <a:tab algn="l" pos="1658880"/>
                    <a:tab algn="l" pos="1990800"/>
                    <a:tab algn="l" pos="2322360"/>
                    <a:tab algn="l" pos="2654280"/>
                    <a:tab algn="l" pos="2986200"/>
                    <a:tab algn="l" pos="3317760"/>
                    <a:tab algn="l" pos="3649680"/>
                    <a:tab algn="l" pos="3981600"/>
                    <a:tab algn="l" pos="4313160"/>
                    <a:tab algn="l" pos="4645080"/>
                    <a:tab algn="l" pos="4976640"/>
                    <a:tab algn="l" pos="5308560"/>
                    <a:tab algn="l" pos="5640480"/>
                    <a:tab algn="l" pos="5972040"/>
                    <a:tab algn="l" pos="6303960"/>
                    <a:tab algn="l" pos="6635880"/>
                  </a:tabLst>
                </a:pPr>
                <a:endParaRPr b="0" lang="en-US" sz="13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7" name="ZoneTexte 180"/>
              <p:cNvSpPr/>
              <p:nvPr/>
            </p:nvSpPr>
            <p:spPr>
              <a:xfrm>
                <a:off x="1217520" y="2786040"/>
                <a:ext cx="88488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331920"/>
                    <a:tab algn="l" pos="663480"/>
                    <a:tab algn="l" pos="995400"/>
                    <a:tab algn="l" pos="1327320"/>
                    <a:tab algn="l" pos="1658880"/>
                    <a:tab algn="l" pos="1990800"/>
                    <a:tab algn="l" pos="2322360"/>
                    <a:tab algn="l" pos="2654280"/>
                    <a:tab algn="l" pos="2986200"/>
                    <a:tab algn="l" pos="3317760"/>
                    <a:tab algn="l" pos="3649680"/>
                    <a:tab algn="l" pos="3981600"/>
                    <a:tab algn="l" pos="4313160"/>
                    <a:tab algn="l" pos="4645080"/>
                    <a:tab algn="l" pos="4976640"/>
                    <a:tab algn="l" pos="5308560"/>
                    <a:tab algn="l" pos="5640480"/>
                    <a:tab algn="l" pos="5972040"/>
                    <a:tab algn="l" pos="6303960"/>
                    <a:tab algn="l" pos="6635880"/>
                  </a:tabLst>
                </a:pPr>
                <a:r>
                  <a:rPr b="1" lang="fr-FR" sz="14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Extracts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8" name="ZoneTexte 181"/>
              <p:cNvSpPr/>
              <p:nvPr/>
            </p:nvSpPr>
            <p:spPr>
              <a:xfrm>
                <a:off x="2498760" y="2786040"/>
                <a:ext cx="78408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331920"/>
                    <a:tab algn="l" pos="663480"/>
                    <a:tab algn="l" pos="995400"/>
                    <a:tab algn="l" pos="1327320"/>
                    <a:tab algn="l" pos="1658880"/>
                    <a:tab algn="l" pos="1990800"/>
                    <a:tab algn="l" pos="2322360"/>
                    <a:tab algn="l" pos="2654280"/>
                    <a:tab algn="l" pos="2986200"/>
                    <a:tab algn="l" pos="3317760"/>
                    <a:tab algn="l" pos="3649680"/>
                    <a:tab algn="l" pos="3981600"/>
                    <a:tab algn="l" pos="4313160"/>
                    <a:tab algn="l" pos="4645080"/>
                    <a:tab algn="l" pos="4976640"/>
                    <a:tab algn="l" pos="5308560"/>
                    <a:tab algn="l" pos="5640480"/>
                    <a:tab algn="l" pos="5972040"/>
                    <a:tab algn="l" pos="6303960"/>
                    <a:tab algn="l" pos="663588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Elution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139" name="ZoneTexte 97"/>
            <p:cNvSpPr/>
            <p:nvPr/>
          </p:nvSpPr>
          <p:spPr>
            <a:xfrm>
              <a:off x="101160" y="2835360"/>
              <a:ext cx="3452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331920"/>
                  <a:tab algn="l" pos="663480"/>
                  <a:tab algn="l" pos="995400"/>
                  <a:tab algn="l" pos="1327320"/>
                  <a:tab algn="l" pos="1658880"/>
                  <a:tab algn="l" pos="1990800"/>
                  <a:tab algn="l" pos="2322360"/>
                  <a:tab algn="l" pos="2654280"/>
                  <a:tab algn="l" pos="2986200"/>
                  <a:tab algn="l" pos="3317760"/>
                  <a:tab algn="l" pos="3649680"/>
                  <a:tab algn="l" pos="3981600"/>
                  <a:tab algn="l" pos="4313160"/>
                  <a:tab algn="l" pos="4645080"/>
                  <a:tab algn="l" pos="4976640"/>
                  <a:tab algn="l" pos="5308560"/>
                  <a:tab algn="l" pos="5640480"/>
                  <a:tab algn="l" pos="5972040"/>
                  <a:tab algn="l" pos="6303960"/>
                  <a:tab algn="l" pos="663588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  <a:ea typeface="Arial"/>
                </a:rPr>
                <a:t>B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40" name="ZoneTexte 98"/>
          <p:cNvSpPr/>
          <p:nvPr/>
        </p:nvSpPr>
        <p:spPr>
          <a:xfrm>
            <a:off x="101160" y="550080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331920"/>
                <a:tab algn="l" pos="663480"/>
                <a:tab algn="l" pos="995400"/>
                <a:tab algn="l" pos="1327320"/>
                <a:tab algn="l" pos="1658880"/>
                <a:tab algn="l" pos="1990800"/>
                <a:tab algn="l" pos="2322360"/>
                <a:tab algn="l" pos="2654280"/>
                <a:tab algn="l" pos="2986200"/>
                <a:tab algn="l" pos="3317760"/>
                <a:tab algn="l" pos="3649680"/>
                <a:tab algn="l" pos="3981600"/>
                <a:tab algn="l" pos="4313160"/>
                <a:tab algn="l" pos="4645080"/>
                <a:tab algn="l" pos="4976640"/>
                <a:tab algn="l" pos="5308560"/>
                <a:tab algn="l" pos="5640480"/>
                <a:tab algn="l" pos="5972040"/>
                <a:tab algn="l" pos="6303960"/>
                <a:tab algn="l" pos="663588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1" name="ZoneTexte 99"/>
          <p:cNvSpPr/>
          <p:nvPr/>
        </p:nvSpPr>
        <p:spPr>
          <a:xfrm>
            <a:off x="1163880" y="53028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331920"/>
                <a:tab algn="l" pos="663480"/>
                <a:tab algn="l" pos="995400"/>
                <a:tab algn="l" pos="1327320"/>
                <a:tab algn="l" pos="1658880"/>
                <a:tab algn="l" pos="1990800"/>
                <a:tab algn="l" pos="2322360"/>
                <a:tab algn="l" pos="2654280"/>
                <a:tab algn="l" pos="2986200"/>
                <a:tab algn="l" pos="3317760"/>
                <a:tab algn="l" pos="3649680"/>
                <a:tab algn="l" pos="3981600"/>
                <a:tab algn="l" pos="4313160"/>
                <a:tab algn="l" pos="4645080"/>
                <a:tab algn="l" pos="4976640"/>
                <a:tab algn="l" pos="5308560"/>
                <a:tab algn="l" pos="5640480"/>
                <a:tab algn="l" pos="5972040"/>
                <a:tab algn="l" pos="6303960"/>
                <a:tab algn="l" pos="663588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2" name="ZoneTexte 100"/>
          <p:cNvSpPr/>
          <p:nvPr/>
        </p:nvSpPr>
        <p:spPr>
          <a:xfrm>
            <a:off x="1538640" y="53028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331920"/>
                <a:tab algn="l" pos="663480"/>
                <a:tab algn="l" pos="995400"/>
                <a:tab algn="l" pos="1327320"/>
                <a:tab algn="l" pos="1658880"/>
                <a:tab algn="l" pos="1990800"/>
                <a:tab algn="l" pos="2322360"/>
                <a:tab algn="l" pos="2654280"/>
                <a:tab algn="l" pos="2986200"/>
                <a:tab algn="l" pos="3317760"/>
                <a:tab algn="l" pos="3649680"/>
                <a:tab algn="l" pos="3981600"/>
                <a:tab algn="l" pos="4313160"/>
                <a:tab algn="l" pos="4645080"/>
                <a:tab algn="l" pos="4976640"/>
                <a:tab algn="l" pos="5308560"/>
                <a:tab algn="l" pos="5640480"/>
                <a:tab algn="l" pos="5972040"/>
                <a:tab algn="l" pos="6303960"/>
                <a:tab algn="l" pos="663588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3" name="ZoneTexte 101"/>
          <p:cNvSpPr/>
          <p:nvPr/>
        </p:nvSpPr>
        <p:spPr>
          <a:xfrm>
            <a:off x="1908360" y="53028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331920"/>
                <a:tab algn="l" pos="663480"/>
                <a:tab algn="l" pos="995400"/>
                <a:tab algn="l" pos="1327320"/>
                <a:tab algn="l" pos="1658880"/>
                <a:tab algn="l" pos="1990800"/>
                <a:tab algn="l" pos="2322360"/>
                <a:tab algn="l" pos="2654280"/>
                <a:tab algn="l" pos="2986200"/>
                <a:tab algn="l" pos="3317760"/>
                <a:tab algn="l" pos="3649680"/>
                <a:tab algn="l" pos="3981600"/>
                <a:tab algn="l" pos="4313160"/>
                <a:tab algn="l" pos="4645080"/>
                <a:tab algn="l" pos="4976640"/>
                <a:tab algn="l" pos="5308560"/>
                <a:tab algn="l" pos="5640480"/>
                <a:tab algn="l" pos="5972040"/>
                <a:tab algn="l" pos="6303960"/>
                <a:tab algn="l" pos="663588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4" name="ZoneTexte 102"/>
          <p:cNvSpPr/>
          <p:nvPr/>
        </p:nvSpPr>
        <p:spPr>
          <a:xfrm>
            <a:off x="2308320" y="53028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331920"/>
                <a:tab algn="l" pos="663480"/>
                <a:tab algn="l" pos="995400"/>
                <a:tab algn="l" pos="1327320"/>
                <a:tab algn="l" pos="1658880"/>
                <a:tab algn="l" pos="1990800"/>
                <a:tab algn="l" pos="2322360"/>
                <a:tab algn="l" pos="2654280"/>
                <a:tab algn="l" pos="2986200"/>
                <a:tab algn="l" pos="3317760"/>
                <a:tab algn="l" pos="3649680"/>
                <a:tab algn="l" pos="3981600"/>
                <a:tab algn="l" pos="4313160"/>
                <a:tab algn="l" pos="4645080"/>
                <a:tab algn="l" pos="4976640"/>
                <a:tab algn="l" pos="5308560"/>
                <a:tab algn="l" pos="5640480"/>
                <a:tab algn="l" pos="5972040"/>
                <a:tab algn="l" pos="6303960"/>
                <a:tab algn="l" pos="663588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5" name="ZoneTexte 103"/>
          <p:cNvSpPr/>
          <p:nvPr/>
        </p:nvSpPr>
        <p:spPr>
          <a:xfrm>
            <a:off x="2675880" y="53028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331920"/>
                <a:tab algn="l" pos="663480"/>
                <a:tab algn="l" pos="995400"/>
                <a:tab algn="l" pos="1327320"/>
                <a:tab algn="l" pos="1658880"/>
                <a:tab algn="l" pos="1990800"/>
                <a:tab algn="l" pos="2322360"/>
                <a:tab algn="l" pos="2654280"/>
                <a:tab algn="l" pos="2986200"/>
                <a:tab algn="l" pos="3317760"/>
                <a:tab algn="l" pos="3649680"/>
                <a:tab algn="l" pos="3981600"/>
                <a:tab algn="l" pos="4313160"/>
                <a:tab algn="l" pos="4645080"/>
                <a:tab algn="l" pos="4976640"/>
                <a:tab algn="l" pos="5308560"/>
                <a:tab algn="l" pos="5640480"/>
                <a:tab algn="l" pos="5972040"/>
                <a:tab algn="l" pos="6303960"/>
                <a:tab algn="l" pos="663588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6" name="ZoneTexte 104"/>
          <p:cNvSpPr/>
          <p:nvPr/>
        </p:nvSpPr>
        <p:spPr>
          <a:xfrm>
            <a:off x="3110400" y="53028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331920"/>
                <a:tab algn="l" pos="663480"/>
                <a:tab algn="l" pos="995400"/>
                <a:tab algn="l" pos="1327320"/>
                <a:tab algn="l" pos="1658880"/>
                <a:tab algn="l" pos="1990800"/>
                <a:tab algn="l" pos="2322360"/>
                <a:tab algn="l" pos="2654280"/>
                <a:tab algn="l" pos="2986200"/>
                <a:tab algn="l" pos="3317760"/>
                <a:tab algn="l" pos="3649680"/>
                <a:tab algn="l" pos="3981600"/>
                <a:tab algn="l" pos="4313160"/>
                <a:tab algn="l" pos="4645080"/>
                <a:tab algn="l" pos="4976640"/>
                <a:tab algn="l" pos="5308560"/>
                <a:tab algn="l" pos="5640480"/>
                <a:tab algn="l" pos="5972040"/>
                <a:tab algn="l" pos="6303960"/>
                <a:tab algn="l" pos="663588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6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7" name="ZoneTexte 105"/>
          <p:cNvSpPr/>
          <p:nvPr/>
        </p:nvSpPr>
        <p:spPr>
          <a:xfrm>
            <a:off x="1128960" y="332100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331920"/>
                <a:tab algn="l" pos="663480"/>
                <a:tab algn="l" pos="995400"/>
                <a:tab algn="l" pos="1327320"/>
                <a:tab algn="l" pos="1658880"/>
                <a:tab algn="l" pos="1990800"/>
                <a:tab algn="l" pos="2322360"/>
                <a:tab algn="l" pos="2654280"/>
                <a:tab algn="l" pos="2986200"/>
                <a:tab algn="l" pos="3317760"/>
                <a:tab algn="l" pos="3649680"/>
                <a:tab algn="l" pos="3981600"/>
                <a:tab algn="l" pos="4313160"/>
                <a:tab algn="l" pos="4645080"/>
                <a:tab algn="l" pos="4976640"/>
                <a:tab algn="l" pos="5308560"/>
                <a:tab algn="l" pos="5640480"/>
                <a:tab algn="l" pos="5972040"/>
                <a:tab algn="l" pos="6303960"/>
                <a:tab algn="l" pos="663588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8" name="ZoneTexte 106"/>
          <p:cNvSpPr/>
          <p:nvPr/>
        </p:nvSpPr>
        <p:spPr>
          <a:xfrm>
            <a:off x="1486080" y="332100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331920"/>
                <a:tab algn="l" pos="663480"/>
                <a:tab algn="l" pos="995400"/>
                <a:tab algn="l" pos="1327320"/>
                <a:tab algn="l" pos="1658880"/>
                <a:tab algn="l" pos="1990800"/>
                <a:tab algn="l" pos="2322360"/>
                <a:tab algn="l" pos="2654280"/>
                <a:tab algn="l" pos="2986200"/>
                <a:tab algn="l" pos="3317760"/>
                <a:tab algn="l" pos="3649680"/>
                <a:tab algn="l" pos="3981600"/>
                <a:tab algn="l" pos="4313160"/>
                <a:tab algn="l" pos="4645080"/>
                <a:tab algn="l" pos="4976640"/>
                <a:tab algn="l" pos="5308560"/>
                <a:tab algn="l" pos="5640480"/>
                <a:tab algn="l" pos="5972040"/>
                <a:tab algn="l" pos="6303960"/>
                <a:tab algn="l" pos="663588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9" name="ZoneTexte 107"/>
          <p:cNvSpPr/>
          <p:nvPr/>
        </p:nvSpPr>
        <p:spPr>
          <a:xfrm>
            <a:off x="1843200" y="332100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331920"/>
                <a:tab algn="l" pos="663480"/>
                <a:tab algn="l" pos="995400"/>
                <a:tab algn="l" pos="1327320"/>
                <a:tab algn="l" pos="1658880"/>
                <a:tab algn="l" pos="1990800"/>
                <a:tab algn="l" pos="2322360"/>
                <a:tab algn="l" pos="2654280"/>
                <a:tab algn="l" pos="2986200"/>
                <a:tab algn="l" pos="3317760"/>
                <a:tab algn="l" pos="3649680"/>
                <a:tab algn="l" pos="3981600"/>
                <a:tab algn="l" pos="4313160"/>
                <a:tab algn="l" pos="4645080"/>
                <a:tab algn="l" pos="4976640"/>
                <a:tab algn="l" pos="5308560"/>
                <a:tab algn="l" pos="5640480"/>
                <a:tab algn="l" pos="5972040"/>
                <a:tab algn="l" pos="6303960"/>
                <a:tab algn="l" pos="663588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0" name="ZoneTexte 108"/>
          <p:cNvSpPr/>
          <p:nvPr/>
        </p:nvSpPr>
        <p:spPr>
          <a:xfrm>
            <a:off x="2265480" y="332100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331920"/>
                <a:tab algn="l" pos="663480"/>
                <a:tab algn="l" pos="995400"/>
                <a:tab algn="l" pos="1327320"/>
                <a:tab algn="l" pos="1658880"/>
                <a:tab algn="l" pos="1990800"/>
                <a:tab algn="l" pos="2322360"/>
                <a:tab algn="l" pos="2654280"/>
                <a:tab algn="l" pos="2986200"/>
                <a:tab algn="l" pos="3317760"/>
                <a:tab algn="l" pos="3649680"/>
                <a:tab algn="l" pos="3981600"/>
                <a:tab algn="l" pos="4313160"/>
                <a:tab algn="l" pos="4645080"/>
                <a:tab algn="l" pos="4976640"/>
                <a:tab algn="l" pos="5308560"/>
                <a:tab algn="l" pos="5640480"/>
                <a:tab algn="l" pos="5972040"/>
                <a:tab algn="l" pos="6303960"/>
                <a:tab algn="l" pos="663588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1" name="ZoneTexte 109"/>
          <p:cNvSpPr/>
          <p:nvPr/>
        </p:nvSpPr>
        <p:spPr>
          <a:xfrm>
            <a:off x="2666520" y="332100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331920"/>
                <a:tab algn="l" pos="663480"/>
                <a:tab algn="l" pos="995400"/>
                <a:tab algn="l" pos="1327320"/>
                <a:tab algn="l" pos="1658880"/>
                <a:tab algn="l" pos="1990800"/>
                <a:tab algn="l" pos="2322360"/>
                <a:tab algn="l" pos="2654280"/>
                <a:tab algn="l" pos="2986200"/>
                <a:tab algn="l" pos="3317760"/>
                <a:tab algn="l" pos="3649680"/>
                <a:tab algn="l" pos="3981600"/>
                <a:tab algn="l" pos="4313160"/>
                <a:tab algn="l" pos="4645080"/>
                <a:tab algn="l" pos="4976640"/>
                <a:tab algn="l" pos="5308560"/>
                <a:tab algn="l" pos="5640480"/>
                <a:tab algn="l" pos="5972040"/>
                <a:tab algn="l" pos="6303960"/>
                <a:tab algn="l" pos="663588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2" name="ZoneTexte 110"/>
          <p:cNvSpPr/>
          <p:nvPr/>
        </p:nvSpPr>
        <p:spPr>
          <a:xfrm>
            <a:off x="3118320" y="332100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331920"/>
                <a:tab algn="l" pos="663480"/>
                <a:tab algn="l" pos="995400"/>
                <a:tab algn="l" pos="1327320"/>
                <a:tab algn="l" pos="1658880"/>
                <a:tab algn="l" pos="1990800"/>
                <a:tab algn="l" pos="2322360"/>
                <a:tab algn="l" pos="2654280"/>
                <a:tab algn="l" pos="2986200"/>
                <a:tab algn="l" pos="3317760"/>
                <a:tab algn="l" pos="3649680"/>
                <a:tab algn="l" pos="3981600"/>
                <a:tab algn="l" pos="4313160"/>
                <a:tab algn="l" pos="4645080"/>
                <a:tab algn="l" pos="4976640"/>
                <a:tab algn="l" pos="5308560"/>
                <a:tab algn="l" pos="5640480"/>
                <a:tab algn="l" pos="5972040"/>
                <a:tab algn="l" pos="6303960"/>
                <a:tab algn="l" pos="663588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6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3" name="ZoneTexte 113"/>
          <p:cNvSpPr/>
          <p:nvPr/>
        </p:nvSpPr>
        <p:spPr>
          <a:xfrm>
            <a:off x="696240" y="615636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331920"/>
                <a:tab algn="l" pos="663480"/>
                <a:tab algn="l" pos="995400"/>
                <a:tab algn="l" pos="1327320"/>
                <a:tab algn="l" pos="1658880"/>
                <a:tab algn="l" pos="1990800"/>
                <a:tab algn="l" pos="2322360"/>
                <a:tab algn="l" pos="2654280"/>
                <a:tab algn="l" pos="2986200"/>
                <a:tab algn="l" pos="3317760"/>
                <a:tab algn="l" pos="3649680"/>
                <a:tab algn="l" pos="3981600"/>
                <a:tab algn="l" pos="4313160"/>
                <a:tab algn="l" pos="4645080"/>
                <a:tab algn="l" pos="4976640"/>
                <a:tab algn="l" pos="5308560"/>
                <a:tab algn="l" pos="5640480"/>
                <a:tab algn="l" pos="5972040"/>
                <a:tab algn="l" pos="6303960"/>
                <a:tab algn="l" pos="663588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4" name="ZoneTexte 114"/>
          <p:cNvSpPr/>
          <p:nvPr/>
        </p:nvSpPr>
        <p:spPr>
          <a:xfrm>
            <a:off x="1159920" y="615636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331920"/>
                <a:tab algn="l" pos="663480"/>
                <a:tab algn="l" pos="995400"/>
                <a:tab algn="l" pos="1327320"/>
                <a:tab algn="l" pos="1658880"/>
                <a:tab algn="l" pos="1990800"/>
                <a:tab algn="l" pos="2322360"/>
                <a:tab algn="l" pos="2654280"/>
                <a:tab algn="l" pos="2986200"/>
                <a:tab algn="l" pos="3317760"/>
                <a:tab algn="l" pos="3649680"/>
                <a:tab algn="l" pos="3981600"/>
                <a:tab algn="l" pos="4313160"/>
                <a:tab algn="l" pos="4645080"/>
                <a:tab algn="l" pos="4976640"/>
                <a:tab algn="l" pos="5308560"/>
                <a:tab algn="l" pos="5640480"/>
                <a:tab algn="l" pos="5972040"/>
                <a:tab algn="l" pos="6303960"/>
                <a:tab algn="l" pos="663588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5" name="ZoneTexte 115"/>
          <p:cNvSpPr/>
          <p:nvPr/>
        </p:nvSpPr>
        <p:spPr>
          <a:xfrm>
            <a:off x="1623240" y="615636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331920"/>
                <a:tab algn="l" pos="663480"/>
                <a:tab algn="l" pos="995400"/>
                <a:tab algn="l" pos="1327320"/>
                <a:tab algn="l" pos="1658880"/>
                <a:tab algn="l" pos="1990800"/>
                <a:tab algn="l" pos="2322360"/>
                <a:tab algn="l" pos="2654280"/>
                <a:tab algn="l" pos="2986200"/>
                <a:tab algn="l" pos="3317760"/>
                <a:tab algn="l" pos="3649680"/>
                <a:tab algn="l" pos="3981600"/>
                <a:tab algn="l" pos="4313160"/>
                <a:tab algn="l" pos="4645080"/>
                <a:tab algn="l" pos="4976640"/>
                <a:tab algn="l" pos="5308560"/>
                <a:tab algn="l" pos="5640480"/>
                <a:tab algn="l" pos="5972040"/>
                <a:tab algn="l" pos="6303960"/>
                <a:tab algn="l" pos="663588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6" name="ZoneTexte 116"/>
          <p:cNvSpPr/>
          <p:nvPr/>
        </p:nvSpPr>
        <p:spPr>
          <a:xfrm>
            <a:off x="2125080" y="615636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331920"/>
                <a:tab algn="l" pos="663480"/>
                <a:tab algn="l" pos="995400"/>
                <a:tab algn="l" pos="1327320"/>
                <a:tab algn="l" pos="1658880"/>
                <a:tab algn="l" pos="1990800"/>
                <a:tab algn="l" pos="2322360"/>
                <a:tab algn="l" pos="2654280"/>
                <a:tab algn="l" pos="2986200"/>
                <a:tab algn="l" pos="3317760"/>
                <a:tab algn="l" pos="3649680"/>
                <a:tab algn="l" pos="3981600"/>
                <a:tab algn="l" pos="4313160"/>
                <a:tab algn="l" pos="4645080"/>
                <a:tab algn="l" pos="4976640"/>
                <a:tab algn="l" pos="5308560"/>
                <a:tab algn="l" pos="5640480"/>
                <a:tab algn="l" pos="5972040"/>
                <a:tab algn="l" pos="6303960"/>
                <a:tab algn="l" pos="663588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7" name="ZoneTexte 117"/>
          <p:cNvSpPr/>
          <p:nvPr/>
        </p:nvSpPr>
        <p:spPr>
          <a:xfrm>
            <a:off x="2613960" y="615636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331920"/>
                <a:tab algn="l" pos="663480"/>
                <a:tab algn="l" pos="995400"/>
                <a:tab algn="l" pos="1327320"/>
                <a:tab algn="l" pos="1658880"/>
                <a:tab algn="l" pos="1990800"/>
                <a:tab algn="l" pos="2322360"/>
                <a:tab algn="l" pos="2654280"/>
                <a:tab algn="l" pos="2986200"/>
                <a:tab algn="l" pos="3317760"/>
                <a:tab algn="l" pos="3649680"/>
                <a:tab algn="l" pos="3981600"/>
                <a:tab algn="l" pos="4313160"/>
                <a:tab algn="l" pos="4645080"/>
                <a:tab algn="l" pos="4976640"/>
                <a:tab algn="l" pos="5308560"/>
                <a:tab algn="l" pos="5640480"/>
                <a:tab algn="l" pos="5972040"/>
                <a:tab algn="l" pos="6303960"/>
                <a:tab algn="l" pos="663588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8" name="ZoneTexte 118"/>
          <p:cNvSpPr/>
          <p:nvPr/>
        </p:nvSpPr>
        <p:spPr>
          <a:xfrm>
            <a:off x="3103200" y="615636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331920"/>
                <a:tab algn="l" pos="663480"/>
                <a:tab algn="l" pos="995400"/>
                <a:tab algn="l" pos="1327320"/>
                <a:tab algn="l" pos="1658880"/>
                <a:tab algn="l" pos="1990800"/>
                <a:tab algn="l" pos="2322360"/>
                <a:tab algn="l" pos="2654280"/>
                <a:tab algn="l" pos="2986200"/>
                <a:tab algn="l" pos="3317760"/>
                <a:tab algn="l" pos="3649680"/>
                <a:tab algn="l" pos="3981600"/>
                <a:tab algn="l" pos="4313160"/>
                <a:tab algn="l" pos="4645080"/>
                <a:tab algn="l" pos="4976640"/>
                <a:tab algn="l" pos="5308560"/>
                <a:tab algn="l" pos="5640480"/>
                <a:tab algn="l" pos="5972040"/>
                <a:tab algn="l" pos="6303960"/>
                <a:tab algn="l" pos="663588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6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11-02T19:59:56Z</dcterms:created>
  <dc:creator>Nadia</dc:creator>
  <dc:description/>
  <dc:language>en-US</dc:language>
  <cp:lastModifiedBy>Nadia</cp:lastModifiedBy>
  <cp:lastPrinted>2011-11-02T20:00:10Z</cp:lastPrinted>
  <dcterms:modified xsi:type="dcterms:W3CDTF">2011-11-03T19:50:08Z</dcterms:modified>
  <cp:revision>19</cp:revision>
  <dc:subject/>
  <dc:title>Diapositive 1</dc:title>
</cp:coreProperties>
</file>